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7"/>
  </p:notesMasterIdLst>
  <p:sldIdLst>
    <p:sldId id="578" r:id="rId2"/>
    <p:sldId id="476" r:id="rId3"/>
    <p:sldId id="260" r:id="rId4"/>
    <p:sldId id="264" r:id="rId5"/>
    <p:sldId id="265" r:id="rId6"/>
    <p:sldId id="266" r:id="rId7"/>
    <p:sldId id="263" r:id="rId8"/>
    <p:sldId id="262" r:id="rId9"/>
    <p:sldId id="259" r:id="rId10"/>
    <p:sldId id="258" r:id="rId11"/>
    <p:sldId id="667" r:id="rId12"/>
    <p:sldId id="668" r:id="rId13"/>
    <p:sldId id="628" r:id="rId14"/>
    <p:sldId id="661" r:id="rId15"/>
    <p:sldId id="644" r:id="rId16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994" autoAdjust="0"/>
    <p:restoredTop sz="94660"/>
  </p:normalViewPr>
  <p:slideViewPr>
    <p:cSldViewPr snapToGrid="0">
      <p:cViewPr varScale="1">
        <p:scale>
          <a:sx n="49" d="100"/>
          <a:sy n="49" d="100"/>
        </p:scale>
        <p:origin x="287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-2808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IU-OTA-PDIV-01\ctr$\TRIB-Secure\PHPandya\IN%20VIVO%20studies\Osteosarcoma\2020\4-29-2020%20TT2%20Palbociclib%20efficacy%20(Farinaz)\Final%204_29_20_TT2_Palbociclib_Efficacy_(3wks)_(7_16_2020)%20(1)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IU-OTA-PDIV-01\ctr$\TRIB-Secure\PHPandya\IN%20VIVO%20studies\Osteosarcoma\2020\6-23-2020%20R-HT96%20%20SRA%20+OTX\Final%20R-HT96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18813649568541"/>
          <c:y val="0.23572201034013029"/>
          <c:w val="0.82277888340880467"/>
          <c:h val="0.66879377577802779"/>
        </c:manualLayout>
      </c:layout>
      <c:scatterChart>
        <c:scatterStyle val="lineMarker"/>
        <c:varyColors val="0"/>
        <c:ser>
          <c:idx val="0"/>
          <c:order val="0"/>
          <c:tx>
            <c:strRef>
              <c:f>'for pdx paper GrpStat BW (2)'!$B$8:$C$8</c:f>
              <c:strCache>
                <c:ptCount val="2"/>
                <c:pt idx="0">
                  <c:v>Grp 1 Vehicle</c:v>
                </c:pt>
              </c:strCache>
            </c:strRef>
          </c:tx>
          <c:spPr>
            <a:ln w="25400">
              <a:solidFill>
                <a:srgbClr val="000000"/>
              </a:solidFill>
              <a:prstDash val="solid"/>
            </a:ln>
          </c:spPr>
          <c:marker>
            <c:symbol val="circle"/>
            <c:size val="7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for pdx paper GrpStat BW (2)'!$B$23,'for pdx paper GrpStat BW (2)'!$C$23,'for pdx paper GrpStat BW (2)'!$D$23,'for pdx paper GrpStat BW (2)'!$E$23,'for pdx paper GrpStat BW (2)'!$F$23,'for pdx paper GrpStat BW (2)'!$G$23,'for pdx paper GrpStat BW (2)'!$H$23,'for pdx paper GrpStat BW (2)'!$I$23,'for pdx paper GrpStat BW (2)'!$J$23,'for pdx paper GrpStat BW (2)'!$K$23,'for pdx paper GrpStat BW (2)'!$L$23)</c:f>
                <c:numCache>
                  <c:formatCode>General</c:formatCode>
                  <c:ptCount val="11"/>
                  <c:pt idx="0">
                    <c:v>0.68623535633608546</c:v>
                  </c:pt>
                  <c:pt idx="1">
                    <c:v>0.65375071701681531</c:v>
                  </c:pt>
                  <c:pt idx="2">
                    <c:v>0.71427689302588693</c:v>
                  </c:pt>
                  <c:pt idx="3">
                    <c:v>0.69246491498280449</c:v>
                  </c:pt>
                  <c:pt idx="4">
                    <c:v>0.77309150810930138</c:v>
                  </c:pt>
                  <c:pt idx="5">
                    <c:v>0.75542589099508206</c:v>
                  </c:pt>
                  <c:pt idx="6">
                    <c:v>1.271361171802359</c:v>
                  </c:pt>
                </c:numCache>
              </c:numRef>
            </c:plus>
            <c:minus>
              <c:numRef>
                <c:f>('for pdx paper GrpStat BW (2)'!$B$23,'for pdx paper GrpStat BW (2)'!$C$23,'for pdx paper GrpStat BW (2)'!$D$23,'for pdx paper GrpStat BW (2)'!$E$23,'for pdx paper GrpStat BW (2)'!$F$23,'for pdx paper GrpStat BW (2)'!$G$23,'for pdx paper GrpStat BW (2)'!$H$23,'for pdx paper GrpStat BW (2)'!$I$23,'for pdx paper GrpStat BW (2)'!$J$23,'for pdx paper GrpStat BW (2)'!$K$23,'for pdx paper GrpStat BW (2)'!$L$23)</c:f>
                <c:numCache>
                  <c:formatCode>General</c:formatCode>
                  <c:ptCount val="11"/>
                  <c:pt idx="0">
                    <c:v>0.68623535633608546</c:v>
                  </c:pt>
                  <c:pt idx="1">
                    <c:v>0.65375071701681531</c:v>
                  </c:pt>
                  <c:pt idx="2">
                    <c:v>0.71427689302588693</c:v>
                  </c:pt>
                  <c:pt idx="3">
                    <c:v>0.69246491498280449</c:v>
                  </c:pt>
                  <c:pt idx="4">
                    <c:v>0.77309150810930138</c:v>
                  </c:pt>
                  <c:pt idx="5">
                    <c:v>0.75542589099508206</c:v>
                  </c:pt>
                  <c:pt idx="6">
                    <c:v>1.271361171802359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('for pdx paper GrpStat BW (2)'!$B$15,'for pdx paper GrpStat BW (2)'!$C$15,'for pdx paper GrpStat BW (2)'!$D$15,'for pdx paper GrpStat BW (2)'!$E$15,'for pdx paper GrpStat BW (2)'!$F$15,'for pdx paper GrpStat BW (2)'!$G$15,'for pdx paper GrpStat BW (2)'!$H$15,'for pdx paper GrpStat BW (2)'!$I$15,'for pdx paper GrpStat BW (2)'!$J$15,'for pdx paper GrpStat BW (2)'!$K$15,'for pdx paper GrpStat BW (2)'!$L$15)</c:f>
              <c:numCache>
                <c:formatCode>General</c:formatCode>
                <c:ptCount val="11"/>
                <c:pt idx="0">
                  <c:v>1</c:v>
                </c:pt>
                <c:pt idx="1">
                  <c:v>7</c:v>
                </c:pt>
                <c:pt idx="2">
                  <c:v>10</c:v>
                </c:pt>
                <c:pt idx="3">
                  <c:v>14</c:v>
                </c:pt>
                <c:pt idx="4">
                  <c:v>17</c:v>
                </c:pt>
                <c:pt idx="5">
                  <c:v>21</c:v>
                </c:pt>
                <c:pt idx="6">
                  <c:v>28</c:v>
                </c:pt>
                <c:pt idx="7">
                  <c:v>35</c:v>
                </c:pt>
                <c:pt idx="8">
                  <c:v>42</c:v>
                </c:pt>
                <c:pt idx="9">
                  <c:v>49</c:v>
                </c:pt>
                <c:pt idx="10">
                  <c:v>56</c:v>
                </c:pt>
              </c:numCache>
            </c:numRef>
          </c:xVal>
          <c:yVal>
            <c:numRef>
              <c:f>('for pdx paper GrpStat BW (2)'!$B$16,'for pdx paper GrpStat BW (2)'!$C$16,'for pdx paper GrpStat BW (2)'!$D$16,'for pdx paper GrpStat BW (2)'!$E$16,'for pdx paper GrpStat BW (2)'!$F$16,'for pdx paper GrpStat BW (2)'!$G$16,'for pdx paper GrpStat BW (2)'!$H$16,'for pdx paper GrpStat BW (2)'!$I$16,'for pdx paper GrpStat BW (2)'!$J$16,'for pdx paper GrpStat BW (2)'!$K$16,'for pdx paper GrpStat BW (2)'!$L$16)</c:f>
              <c:numCache>
                <c:formatCode>####0.00</c:formatCode>
                <c:ptCount val="11"/>
                <c:pt idx="0">
                  <c:v>28.794</c:v>
                </c:pt>
                <c:pt idx="1">
                  <c:v>28.3215</c:v>
                </c:pt>
                <c:pt idx="2">
                  <c:v>28.706875</c:v>
                </c:pt>
                <c:pt idx="3">
                  <c:v>28.978874999999999</c:v>
                </c:pt>
                <c:pt idx="4">
                  <c:v>28.845874999999999</c:v>
                </c:pt>
                <c:pt idx="5">
                  <c:v>29.836749999999999</c:v>
                </c:pt>
                <c:pt idx="6">
                  <c:v>30.18325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264-4DBC-82D1-968891E4A4F1}"/>
            </c:ext>
          </c:extLst>
        </c:ser>
        <c:ser>
          <c:idx val="2"/>
          <c:order val="1"/>
          <c:tx>
            <c:strRef>
              <c:f>'for pdx paper GrpStat BW (2)'!$B$10:$C$10</c:f>
              <c:strCache>
                <c:ptCount val="2"/>
                <c:pt idx="0">
                  <c:v>Grp 3 Palbocicilib 120mg/kg</c:v>
                </c:pt>
              </c:strCache>
            </c:strRef>
          </c:tx>
          <c:spPr>
            <a:ln w="25400">
              <a:solidFill>
                <a:srgbClr val="0000FF"/>
              </a:solidFill>
              <a:prstDash val="solid"/>
            </a:ln>
          </c:spPr>
          <c:marker>
            <c:symbol val="circle"/>
            <c:size val="7"/>
            <c:spPr>
              <a:solidFill>
                <a:srgbClr val="0000FF"/>
              </a:solidFill>
              <a:ln>
                <a:solidFill>
                  <a:srgbClr val="0000FF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for pdx paper GrpStat BW (2)'!$B$25,'for pdx paper GrpStat BW (2)'!$C$25,'for pdx paper GrpStat BW (2)'!$D$25,'for pdx paper GrpStat BW (2)'!$E$25,'for pdx paper GrpStat BW (2)'!$F$25,'for pdx paper GrpStat BW (2)'!$G$25,'for pdx paper GrpStat BW (2)'!$H$25,'for pdx paper GrpStat BW (2)'!$I$25,'for pdx paper GrpStat BW (2)'!$J$25,'for pdx paper GrpStat BW (2)'!$K$25,'for pdx paper GrpStat BW (2)'!$L$25)</c:f>
                <c:numCache>
                  <c:formatCode>General</c:formatCode>
                  <c:ptCount val="11"/>
                  <c:pt idx="0">
                    <c:v>0.90712315314183545</c:v>
                  </c:pt>
                  <c:pt idx="1">
                    <c:v>0.58195834060874285</c:v>
                  </c:pt>
                  <c:pt idx="2">
                    <c:v>0.7991291603777112</c:v>
                  </c:pt>
                  <c:pt idx="3">
                    <c:v>0.82569433160928307</c:v>
                  </c:pt>
                  <c:pt idx="4">
                    <c:v>0.80625801899719396</c:v>
                  </c:pt>
                  <c:pt idx="5">
                    <c:v>0.83737147861464634</c:v>
                  </c:pt>
                  <c:pt idx="6">
                    <c:v>0.91432183708402581</c:v>
                  </c:pt>
                  <c:pt idx="7">
                    <c:v>0.94459601918268898</c:v>
                  </c:pt>
                  <c:pt idx="8">
                    <c:v>1.4775217633290931</c:v>
                  </c:pt>
                  <c:pt idx="9">
                    <c:v>0.93567202230981206</c:v>
                  </c:pt>
                  <c:pt idx="10">
                    <c:v>2.1915000000000013</c:v>
                  </c:pt>
                </c:numCache>
              </c:numRef>
            </c:plus>
            <c:minus>
              <c:numRef>
                <c:f>('for pdx paper GrpStat BW (2)'!$B$25,'for pdx paper GrpStat BW (2)'!$C$25,'for pdx paper GrpStat BW (2)'!$D$25,'for pdx paper GrpStat BW (2)'!$E$25,'for pdx paper GrpStat BW (2)'!$F$25,'for pdx paper GrpStat BW (2)'!$G$25,'for pdx paper GrpStat BW (2)'!$H$25,'for pdx paper GrpStat BW (2)'!$I$25,'for pdx paper GrpStat BW (2)'!$J$25,'for pdx paper GrpStat BW (2)'!$K$25,'for pdx paper GrpStat BW (2)'!$L$25)</c:f>
                <c:numCache>
                  <c:formatCode>General</c:formatCode>
                  <c:ptCount val="11"/>
                  <c:pt idx="0">
                    <c:v>0.90712315314183545</c:v>
                  </c:pt>
                  <c:pt idx="1">
                    <c:v>0.58195834060874285</c:v>
                  </c:pt>
                  <c:pt idx="2">
                    <c:v>0.7991291603777112</c:v>
                  </c:pt>
                  <c:pt idx="3">
                    <c:v>0.82569433160928307</c:v>
                  </c:pt>
                  <c:pt idx="4">
                    <c:v>0.80625801899719396</c:v>
                  </c:pt>
                  <c:pt idx="5">
                    <c:v>0.83737147861464634</c:v>
                  </c:pt>
                  <c:pt idx="6">
                    <c:v>0.91432183708402581</c:v>
                  </c:pt>
                  <c:pt idx="7">
                    <c:v>0.94459601918268898</c:v>
                  </c:pt>
                  <c:pt idx="8">
                    <c:v>1.4775217633290931</c:v>
                  </c:pt>
                  <c:pt idx="9">
                    <c:v>0.93567202230981206</c:v>
                  </c:pt>
                  <c:pt idx="10">
                    <c:v>2.1915000000000013</c:v>
                  </c:pt>
                </c:numCache>
              </c:numRef>
            </c:minus>
            <c:spPr>
              <a:ln w="12700">
                <a:solidFill>
                  <a:srgbClr val="0000FF"/>
                </a:solidFill>
                <a:prstDash val="solid"/>
              </a:ln>
            </c:spPr>
          </c:errBars>
          <c:xVal>
            <c:numRef>
              <c:f>('for pdx paper GrpStat BW (2)'!$B$15,'for pdx paper GrpStat BW (2)'!$C$15,'for pdx paper GrpStat BW (2)'!$D$15,'for pdx paper GrpStat BW (2)'!$E$15,'for pdx paper GrpStat BW (2)'!$F$15,'for pdx paper GrpStat BW (2)'!$G$15,'for pdx paper GrpStat BW (2)'!$H$15,'for pdx paper GrpStat BW (2)'!$I$15,'for pdx paper GrpStat BW (2)'!$J$15,'for pdx paper GrpStat BW (2)'!$K$15,'for pdx paper GrpStat BW (2)'!$L$15)</c:f>
              <c:numCache>
                <c:formatCode>General</c:formatCode>
                <c:ptCount val="11"/>
                <c:pt idx="0">
                  <c:v>1</c:v>
                </c:pt>
                <c:pt idx="1">
                  <c:v>7</c:v>
                </c:pt>
                <c:pt idx="2">
                  <c:v>10</c:v>
                </c:pt>
                <c:pt idx="3">
                  <c:v>14</c:v>
                </c:pt>
                <c:pt idx="4">
                  <c:v>17</c:v>
                </c:pt>
                <c:pt idx="5">
                  <c:v>21</c:v>
                </c:pt>
                <c:pt idx="6">
                  <c:v>28</c:v>
                </c:pt>
                <c:pt idx="7">
                  <c:v>35</c:v>
                </c:pt>
                <c:pt idx="8">
                  <c:v>42</c:v>
                </c:pt>
                <c:pt idx="9">
                  <c:v>49</c:v>
                </c:pt>
                <c:pt idx="10">
                  <c:v>56</c:v>
                </c:pt>
              </c:numCache>
            </c:numRef>
          </c:xVal>
          <c:yVal>
            <c:numRef>
              <c:f>('for pdx paper GrpStat BW (2)'!$B$18,'for pdx paper GrpStat BW (2)'!$C$18,'for pdx paper GrpStat BW (2)'!$D$18,'for pdx paper GrpStat BW (2)'!$E$18,'for pdx paper GrpStat BW (2)'!$F$18,'for pdx paper GrpStat BW (2)'!$G$18,'for pdx paper GrpStat BW (2)'!$H$18,'for pdx paper GrpStat BW (2)'!$I$18,'for pdx paper GrpStat BW (2)'!$J$18,'for pdx paper GrpStat BW (2)'!$K$18,'for pdx paper GrpStat BW (2)'!$L$18)</c:f>
              <c:numCache>
                <c:formatCode>####0.00</c:formatCode>
                <c:ptCount val="11"/>
                <c:pt idx="0">
                  <c:v>28.680714285714284</c:v>
                </c:pt>
                <c:pt idx="1">
                  <c:v>27.465714285714284</c:v>
                </c:pt>
                <c:pt idx="2">
                  <c:v>26.250285714285713</c:v>
                </c:pt>
                <c:pt idx="3">
                  <c:v>28.109285714285711</c:v>
                </c:pt>
                <c:pt idx="4">
                  <c:v>28.347428571428573</c:v>
                </c:pt>
                <c:pt idx="5">
                  <c:v>28.285571428571426</c:v>
                </c:pt>
                <c:pt idx="6">
                  <c:v>29.93242857142857</c:v>
                </c:pt>
                <c:pt idx="7">
                  <c:v>30.722142857142863</c:v>
                </c:pt>
                <c:pt idx="8">
                  <c:v>29.956166666666672</c:v>
                </c:pt>
                <c:pt idx="9">
                  <c:v>31.881999999999994</c:v>
                </c:pt>
                <c:pt idx="10">
                  <c:v>35.234499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264-4DBC-82D1-968891E4A4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59869359"/>
        <c:axId val="1"/>
      </c:scatterChart>
      <c:valAx>
        <c:axId val="859869359"/>
        <c:scaling>
          <c:orientation val="minMax"/>
          <c:max val="7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500" b="1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defRPr>
            </a:pPr>
            <a:endParaRPr lang="en-US"/>
          </a:p>
        </c:txPr>
        <c:crossAx val="1"/>
        <c:crosses val="autoZero"/>
        <c:crossBetween val="midCat"/>
        <c:majorUnit val="10"/>
      </c:valAx>
      <c:valAx>
        <c:axId val="1"/>
        <c:scaling>
          <c:orientation val="minMax"/>
          <c:min val="10"/>
        </c:scaling>
        <c:delete val="0"/>
        <c:axPos val="l"/>
        <c:majorGridlines>
          <c:spPr>
            <a:ln w="12700">
              <a:noFill/>
              <a:prstDash val="solid"/>
            </a:ln>
          </c:spPr>
        </c:majorGridlines>
        <c:numFmt formatCode="General" sourceLinked="0"/>
        <c:majorTickMark val="out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500" b="1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defRPr>
            </a:pPr>
            <a:endParaRPr lang="en-US"/>
          </a:p>
        </c:txPr>
        <c:crossAx val="859869359"/>
        <c:crossesAt val="0"/>
        <c:crossBetween val="midCat"/>
        <c:majorUnit val="10"/>
      </c:valAx>
      <c:spPr>
        <a:noFill/>
        <a:ln w="25400">
          <a:noFill/>
        </a:ln>
      </c:spPr>
    </c:plotArea>
    <c:plotVisOnly val="1"/>
    <c:dispBlanksAs val="span"/>
    <c:showDLblsOverMax val="0"/>
  </c:chart>
  <c:spPr>
    <a:solidFill>
      <a:srgbClr val="FFFFFF"/>
    </a:solidFill>
    <a:ln w="12700">
      <a:noFill/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021285865438476"/>
          <c:y val="4.1851837432749638E-2"/>
          <c:w val="0.82476882697355136"/>
          <c:h val="0.76470699270091935"/>
        </c:manualLayout>
      </c:layout>
      <c:scatterChart>
        <c:scatterStyle val="lineMarker"/>
        <c:varyColors val="0"/>
        <c:ser>
          <c:idx val="0"/>
          <c:order val="0"/>
          <c:tx>
            <c:strRef>
              <c:f>'GrpStat BW'!$B$8:$C$8</c:f>
              <c:strCache>
                <c:ptCount val="2"/>
                <c:pt idx="0">
                  <c:v>Group 1 - Vehicle</c:v>
                </c:pt>
              </c:strCache>
            </c:strRef>
          </c:tx>
          <c:spPr>
            <a:ln w="25400">
              <a:solidFill>
                <a:srgbClr val="000000"/>
              </a:solidFill>
              <a:prstDash val="solid"/>
            </a:ln>
          </c:spPr>
          <c:marker>
            <c:symbol val="circle"/>
            <c:size val="7"/>
            <c:spPr>
              <a:solidFill>
                <a:srgbClr val="000000"/>
              </a:solidFill>
              <a:ln>
                <a:solidFill>
                  <a:srgbClr val="000000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GrpStat BW'!$B$25,'GrpStat BW'!$C$25,'GrpStat BW'!$D$25,'GrpStat BW'!$E$25,'GrpStat BW'!$F$25,'GrpStat BW'!$G$25,'GrpStat BW'!$H$25,'GrpStat BW'!$I$25,'GrpStat BW'!$J$25,'GrpStat BW'!$K$25,'GrpStat BW'!$L$25,'GrpStat BW'!$M$25,'GrpStat BW'!$N$25,'GrpStat BW'!$O$25,'GrpStat BW'!$P$25,'GrpStat BW'!$Q$25)</c:f>
                <c:numCache>
                  <c:formatCode>General</c:formatCode>
                  <c:ptCount val="16"/>
                  <c:pt idx="0">
                    <c:v>0.79687295794945345</c:v>
                  </c:pt>
                  <c:pt idx="1">
                    <c:v>0.73102710468065257</c:v>
                  </c:pt>
                  <c:pt idx="2">
                    <c:v>0.92883792689814559</c:v>
                  </c:pt>
                  <c:pt idx="3">
                    <c:v>0.88088507258955817</c:v>
                  </c:pt>
                  <c:pt idx="4">
                    <c:v>0.82344401752638929</c:v>
                  </c:pt>
                  <c:pt idx="5">
                    <c:v>0.94585744756337964</c:v>
                  </c:pt>
                  <c:pt idx="6">
                    <c:v>0.89387433867033794</c:v>
                  </c:pt>
                  <c:pt idx="7">
                    <c:v>0.43729548362634629</c:v>
                  </c:pt>
                  <c:pt idx="8">
                    <c:v>0.25414059975620712</c:v>
                  </c:pt>
                  <c:pt idx="9">
                    <c:v>0.42749999999999999</c:v>
                  </c:pt>
                  <c:pt idx="10">
                    <c:v>0</c:v>
                  </c:pt>
                </c:numCache>
              </c:numRef>
            </c:plus>
            <c:minus>
              <c:numRef>
                <c:f>('GrpStat BW'!$B$25,'GrpStat BW'!$C$25,'GrpStat BW'!$D$25,'GrpStat BW'!$E$25,'GrpStat BW'!$F$25,'GrpStat BW'!$G$25,'GrpStat BW'!$H$25,'GrpStat BW'!$I$25,'GrpStat BW'!$J$25,'GrpStat BW'!$K$25,'GrpStat BW'!$L$25,'GrpStat BW'!$M$25,'GrpStat BW'!$N$25,'GrpStat BW'!$O$25,'GrpStat BW'!$P$25,'GrpStat BW'!$Q$25)</c:f>
                <c:numCache>
                  <c:formatCode>General</c:formatCode>
                  <c:ptCount val="16"/>
                  <c:pt idx="0">
                    <c:v>0.79687295794945345</c:v>
                  </c:pt>
                  <c:pt idx="1">
                    <c:v>0.73102710468065257</c:v>
                  </c:pt>
                  <c:pt idx="2">
                    <c:v>0.92883792689814559</c:v>
                  </c:pt>
                  <c:pt idx="3">
                    <c:v>0.88088507258955817</c:v>
                  </c:pt>
                  <c:pt idx="4">
                    <c:v>0.82344401752638929</c:v>
                  </c:pt>
                  <c:pt idx="5">
                    <c:v>0.94585744756337964</c:v>
                  </c:pt>
                  <c:pt idx="6">
                    <c:v>0.89387433867033794</c:v>
                  </c:pt>
                  <c:pt idx="7">
                    <c:v>0.43729548362634629</c:v>
                  </c:pt>
                  <c:pt idx="8">
                    <c:v>0.25414059975620712</c:v>
                  </c:pt>
                  <c:pt idx="9">
                    <c:v>0.42749999999999999</c:v>
                  </c:pt>
                  <c:pt idx="10">
                    <c:v>0</c:v>
                  </c:pt>
                </c:numCache>
              </c:numRef>
            </c:min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xVal>
            <c:numRef>
              <c:f>('GrpStat BW'!$B$16,'GrpStat BW'!$C$16,'GrpStat BW'!$D$16,'GrpStat BW'!$E$16,'GrpStat BW'!$F$16,'GrpStat BW'!$G$16,'GrpStat BW'!$H$16,'GrpStat BW'!$I$16,'GrpStat BW'!$J$16,'GrpStat BW'!$K$16,'GrpStat BW'!$L$16,'GrpStat BW'!$M$16,'GrpStat BW'!$N$16,'GrpStat BW'!$O$16,'GrpStat BW'!$P$16,'GrpStat BW'!$Q$16)</c:f>
              <c:numCache>
                <c:formatCode>####0</c:formatCode>
                <c:ptCount val="16"/>
                <c:pt idx="0">
                  <c:v>0</c:v>
                </c:pt>
                <c:pt idx="1">
                  <c:v>7</c:v>
                </c:pt>
                <c:pt idx="2">
                  <c:v>14</c:v>
                </c:pt>
                <c:pt idx="3">
                  <c:v>21</c:v>
                </c:pt>
                <c:pt idx="4">
                  <c:v>28</c:v>
                </c:pt>
                <c:pt idx="5">
                  <c:v>34</c:v>
                </c:pt>
                <c:pt idx="6">
                  <c:v>37</c:v>
                </c:pt>
                <c:pt idx="7">
                  <c:v>41</c:v>
                </c:pt>
                <c:pt idx="8">
                  <c:v>44</c:v>
                </c:pt>
                <c:pt idx="9">
                  <c:v>48</c:v>
                </c:pt>
                <c:pt idx="10">
                  <c:v>55</c:v>
                </c:pt>
                <c:pt idx="11">
                  <c:v>63</c:v>
                </c:pt>
                <c:pt idx="12">
                  <c:v>69</c:v>
                </c:pt>
                <c:pt idx="13">
                  <c:v>77</c:v>
                </c:pt>
                <c:pt idx="14">
                  <c:v>84</c:v>
                </c:pt>
                <c:pt idx="15">
                  <c:v>91</c:v>
                </c:pt>
              </c:numCache>
            </c:numRef>
          </c:xVal>
          <c:yVal>
            <c:numRef>
              <c:f>('GrpStat BW'!$B$17,'GrpStat BW'!$C$17,'GrpStat BW'!$D$17,'GrpStat BW'!$E$17,'GrpStat BW'!$F$17,'GrpStat BW'!$G$17,'GrpStat BW'!$H$17,'GrpStat BW'!$I$17,'GrpStat BW'!$J$17,'GrpStat BW'!$K$17,'GrpStat BW'!$L$17,'GrpStat BW'!$M$17,'GrpStat BW'!$N$17,'GrpStat BW'!$O$17,'GrpStat BW'!$P$17,'GrpStat BW'!$Q$17)</c:f>
              <c:numCache>
                <c:formatCode>####0.00</c:formatCode>
                <c:ptCount val="16"/>
                <c:pt idx="0">
                  <c:v>27.454666666666668</c:v>
                </c:pt>
                <c:pt idx="1">
                  <c:v>28.327833333333334</c:v>
                </c:pt>
                <c:pt idx="2">
                  <c:v>28.557166666666671</c:v>
                </c:pt>
                <c:pt idx="3">
                  <c:v>28.260666666666669</c:v>
                </c:pt>
                <c:pt idx="4">
                  <c:v>28.840499999999995</c:v>
                </c:pt>
                <c:pt idx="5">
                  <c:v>27.827666666666662</c:v>
                </c:pt>
                <c:pt idx="6">
                  <c:v>29.39</c:v>
                </c:pt>
                <c:pt idx="7">
                  <c:v>29.113800000000005</c:v>
                </c:pt>
                <c:pt idx="8">
                  <c:v>29.568666666666669</c:v>
                </c:pt>
                <c:pt idx="9">
                  <c:v>30.256500000000003</c:v>
                </c:pt>
                <c:pt idx="10">
                  <c:v>30.391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044-4E8A-ABA8-2F7899662C14}"/>
            </c:ext>
          </c:extLst>
        </c:ser>
        <c:ser>
          <c:idx val="2"/>
          <c:order val="1"/>
          <c:tx>
            <c:strRef>
              <c:f>'GrpStat BW'!$B$10:$C$10</c:f>
              <c:strCache>
                <c:ptCount val="2"/>
                <c:pt idx="0">
                  <c:v>Group 3- 25 mg/kg OTX-015</c:v>
                </c:pt>
              </c:strCache>
            </c:strRef>
          </c:tx>
          <c:spPr>
            <a:ln w="25400">
              <a:solidFill>
                <a:srgbClr val="FF0000"/>
              </a:solidFill>
              <a:prstDash val="solid"/>
            </a:ln>
          </c:spPr>
          <c:marker>
            <c:symbol val="circle"/>
            <c:size val="7"/>
            <c:spPr>
              <a:solidFill>
                <a:srgbClr val="FF0000"/>
              </a:solidFill>
              <a:ln>
                <a:solidFill>
                  <a:srgbClr val="FF0000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GrpStat BW'!$B$27,'GrpStat BW'!$C$27,'GrpStat BW'!$D$27,'GrpStat BW'!$E$27,'GrpStat BW'!$F$27,'GrpStat BW'!$G$27,'GrpStat BW'!$H$27,'GrpStat BW'!$I$27,'GrpStat BW'!$J$27,'GrpStat BW'!$K$27,'GrpStat BW'!$L$27,'GrpStat BW'!$M$27,'GrpStat BW'!$N$27,'GrpStat BW'!$O$27,'GrpStat BW'!$P$27,'GrpStat BW'!$Q$27)</c:f>
                <c:numCache>
                  <c:formatCode>General</c:formatCode>
                  <c:ptCount val="16"/>
                  <c:pt idx="0">
                    <c:v>1.35143639879944</c:v>
                  </c:pt>
                  <c:pt idx="1">
                    <c:v>1.4645255340894536</c:v>
                  </c:pt>
                  <c:pt idx="2">
                    <c:v>1.2448475569321731</c:v>
                  </c:pt>
                  <c:pt idx="3">
                    <c:v>1.1314756736227249</c:v>
                  </c:pt>
                  <c:pt idx="4">
                    <c:v>1.0612298808458047</c:v>
                  </c:pt>
                  <c:pt idx="5">
                    <c:v>1.1016441530730332</c:v>
                  </c:pt>
                  <c:pt idx="6">
                    <c:v>0.97915675966619353</c:v>
                  </c:pt>
                  <c:pt idx="7">
                    <c:v>0.98500682231139891</c:v>
                  </c:pt>
                  <c:pt idx="8">
                    <c:v>1.1849266390793987</c:v>
                  </c:pt>
                  <c:pt idx="9">
                    <c:v>1.0883538027681989</c:v>
                  </c:pt>
                  <c:pt idx="10">
                    <c:v>1.2650984309531017</c:v>
                  </c:pt>
                  <c:pt idx="11">
                    <c:v>1.3603031141991846</c:v>
                  </c:pt>
                  <c:pt idx="12">
                    <c:v>1.4032742960661679</c:v>
                  </c:pt>
                  <c:pt idx="13">
                    <c:v>2.0350000000000001</c:v>
                  </c:pt>
                </c:numCache>
              </c:numRef>
            </c:plus>
            <c:minus>
              <c:numRef>
                <c:f>('GrpStat BW'!$B$27,'GrpStat BW'!$C$27,'GrpStat BW'!$D$27,'GrpStat BW'!$E$27,'GrpStat BW'!$F$27,'GrpStat BW'!$G$27,'GrpStat BW'!$H$27,'GrpStat BW'!$I$27,'GrpStat BW'!$J$27,'GrpStat BW'!$K$27,'GrpStat BW'!$L$27,'GrpStat BW'!$M$27,'GrpStat BW'!$N$27,'GrpStat BW'!$O$27,'GrpStat BW'!$P$27,'GrpStat BW'!$Q$27)</c:f>
                <c:numCache>
                  <c:formatCode>General</c:formatCode>
                  <c:ptCount val="16"/>
                  <c:pt idx="0">
                    <c:v>1.35143639879944</c:v>
                  </c:pt>
                  <c:pt idx="1">
                    <c:v>1.4645255340894536</c:v>
                  </c:pt>
                  <c:pt idx="2">
                    <c:v>1.2448475569321731</c:v>
                  </c:pt>
                  <c:pt idx="3">
                    <c:v>1.1314756736227249</c:v>
                  </c:pt>
                  <c:pt idx="4">
                    <c:v>1.0612298808458047</c:v>
                  </c:pt>
                  <c:pt idx="5">
                    <c:v>1.1016441530730332</c:v>
                  </c:pt>
                  <c:pt idx="6">
                    <c:v>0.97915675966619353</c:v>
                  </c:pt>
                  <c:pt idx="7">
                    <c:v>0.98500682231139891</c:v>
                  </c:pt>
                  <c:pt idx="8">
                    <c:v>1.1849266390793987</c:v>
                  </c:pt>
                  <c:pt idx="9">
                    <c:v>1.0883538027681989</c:v>
                  </c:pt>
                  <c:pt idx="10">
                    <c:v>1.2650984309531017</c:v>
                  </c:pt>
                  <c:pt idx="11">
                    <c:v>1.3603031141991846</c:v>
                  </c:pt>
                  <c:pt idx="12">
                    <c:v>1.4032742960661679</c:v>
                  </c:pt>
                  <c:pt idx="13">
                    <c:v>2.0350000000000001</c:v>
                  </c:pt>
                </c:numCache>
              </c:numRef>
            </c:minus>
            <c:spPr>
              <a:ln w="12700">
                <a:solidFill>
                  <a:srgbClr val="FF0000"/>
                </a:solidFill>
                <a:prstDash val="solid"/>
              </a:ln>
            </c:spPr>
          </c:errBars>
          <c:xVal>
            <c:numRef>
              <c:f>('GrpStat BW'!$B$16,'GrpStat BW'!$C$16,'GrpStat BW'!$D$16,'GrpStat BW'!$E$16,'GrpStat BW'!$F$16,'GrpStat BW'!$G$16,'GrpStat BW'!$H$16,'GrpStat BW'!$I$16,'GrpStat BW'!$J$16,'GrpStat BW'!$K$16,'GrpStat BW'!$L$16,'GrpStat BW'!$M$16,'GrpStat BW'!$N$16,'GrpStat BW'!$O$16,'GrpStat BW'!$P$16,'GrpStat BW'!$Q$16)</c:f>
              <c:numCache>
                <c:formatCode>####0</c:formatCode>
                <c:ptCount val="16"/>
                <c:pt idx="0">
                  <c:v>0</c:v>
                </c:pt>
                <c:pt idx="1">
                  <c:v>7</c:v>
                </c:pt>
                <c:pt idx="2">
                  <c:v>14</c:v>
                </c:pt>
                <c:pt idx="3">
                  <c:v>21</c:v>
                </c:pt>
                <c:pt idx="4">
                  <c:v>28</c:v>
                </c:pt>
                <c:pt idx="5">
                  <c:v>34</c:v>
                </c:pt>
                <c:pt idx="6">
                  <c:v>37</c:v>
                </c:pt>
                <c:pt idx="7">
                  <c:v>41</c:v>
                </c:pt>
                <c:pt idx="8">
                  <c:v>44</c:v>
                </c:pt>
                <c:pt idx="9">
                  <c:v>48</c:v>
                </c:pt>
                <c:pt idx="10">
                  <c:v>55</c:v>
                </c:pt>
                <c:pt idx="11">
                  <c:v>63</c:v>
                </c:pt>
                <c:pt idx="12">
                  <c:v>69</c:v>
                </c:pt>
                <c:pt idx="13">
                  <c:v>77</c:v>
                </c:pt>
                <c:pt idx="14">
                  <c:v>84</c:v>
                </c:pt>
                <c:pt idx="15">
                  <c:v>91</c:v>
                </c:pt>
              </c:numCache>
            </c:numRef>
          </c:xVal>
          <c:yVal>
            <c:numRef>
              <c:f>('GrpStat BW'!$B$19,'GrpStat BW'!$C$19,'GrpStat BW'!$D$19,'GrpStat BW'!$E$19,'GrpStat BW'!$F$19,'GrpStat BW'!$G$19,'GrpStat BW'!$H$19,'GrpStat BW'!$I$19,'GrpStat BW'!$J$19,'GrpStat BW'!$K$19,'GrpStat BW'!$L$19,'GrpStat BW'!$M$19,'GrpStat BW'!$N$19,'GrpStat BW'!$O$19,'GrpStat BW'!$P$19,'GrpStat BW'!$Q$19)</c:f>
              <c:numCache>
                <c:formatCode>####0.00</c:formatCode>
                <c:ptCount val="16"/>
                <c:pt idx="0">
                  <c:v>26.6082</c:v>
                </c:pt>
                <c:pt idx="1">
                  <c:v>28.055200000000003</c:v>
                </c:pt>
                <c:pt idx="2">
                  <c:v>28.085200000000004</c:v>
                </c:pt>
                <c:pt idx="3">
                  <c:v>27.917999999999999</c:v>
                </c:pt>
                <c:pt idx="4">
                  <c:v>27.930599999999998</c:v>
                </c:pt>
                <c:pt idx="5">
                  <c:v>28.242200000000004</c:v>
                </c:pt>
                <c:pt idx="6">
                  <c:v>27.8154</c:v>
                </c:pt>
                <c:pt idx="7">
                  <c:v>28.895800000000001</c:v>
                </c:pt>
                <c:pt idx="8">
                  <c:v>29.477799999999995</c:v>
                </c:pt>
                <c:pt idx="9">
                  <c:v>30.25</c:v>
                </c:pt>
                <c:pt idx="10">
                  <c:v>31.651800000000001</c:v>
                </c:pt>
                <c:pt idx="11">
                  <c:v>31.547750000000001</c:v>
                </c:pt>
                <c:pt idx="12">
                  <c:v>32.141500000000001</c:v>
                </c:pt>
                <c:pt idx="13">
                  <c:v>32.8910000000000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044-4E8A-ABA8-2F7899662C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23955983"/>
        <c:axId val="1"/>
      </c:scatterChart>
      <c:valAx>
        <c:axId val="1223955983"/>
        <c:scaling>
          <c:orientation val="minMax"/>
          <c:max val="80"/>
        </c:scaling>
        <c:delete val="0"/>
        <c:axPos val="b"/>
        <c:numFmt formatCode="####0" sourceLinked="1"/>
        <c:majorTickMark val="out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500" b="1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defRPr>
            </a:pPr>
            <a:endParaRPr lang="en-US"/>
          </a:p>
        </c:txPr>
        <c:crossAx val="1"/>
        <c:crosses val="autoZero"/>
        <c:crossBetween val="midCat"/>
        <c:majorUnit val="10"/>
      </c:valAx>
      <c:valAx>
        <c:axId val="1"/>
        <c:scaling>
          <c:orientation val="minMax"/>
          <c:min val="10"/>
        </c:scaling>
        <c:delete val="0"/>
        <c:axPos val="l"/>
        <c:majorGridlines>
          <c:spPr>
            <a:ln w="12700">
              <a:noFill/>
              <a:prstDash val="solid"/>
            </a:ln>
          </c:spPr>
        </c:majorGridlines>
        <c:numFmt formatCode="General" sourceLinked="0"/>
        <c:majorTickMark val="out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500" b="1" i="0" u="none" strike="noStrike" baseline="0">
                <a:solidFill>
                  <a:srgbClr val="000000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</a:defRPr>
            </a:pPr>
            <a:endParaRPr lang="en-US"/>
          </a:p>
        </c:txPr>
        <c:crossAx val="1223955983"/>
        <c:crossesAt val="0"/>
        <c:crossBetween val="midCat"/>
        <c:majorUnit val="10"/>
      </c:valAx>
      <c:spPr>
        <a:solidFill>
          <a:srgbClr val="FFFFFF"/>
        </a:solidFill>
        <a:ln w="25400">
          <a:noFill/>
        </a:ln>
      </c:spPr>
    </c:plotArea>
    <c:plotVisOnly val="1"/>
    <c:dispBlanksAs val="span"/>
    <c:showDLblsOverMax val="0"/>
  </c:chart>
  <c:spPr>
    <a:solidFill>
      <a:srgbClr val="FFFFFF"/>
    </a:solidFill>
    <a:ln w="12700">
      <a:noFill/>
      <a:prstDash val="solid"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DF5113-886D-4597-9150-31B6570BEBF9}" type="datetimeFigureOut">
              <a:rPr lang="en-US" smtClean="0"/>
              <a:t>12/29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3DB458-AF94-49B3-B35E-A83A66486B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0782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B89C91-8C88-48B4-BE18-5F4E266CA33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0573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5E04-59C6-4ACF-9959-AD5EA13FC8A2}" type="datetimeFigureOut">
              <a:rPr lang="en-US" smtClean="0"/>
              <a:t>12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9D40B-1AD2-493E-B83F-35EDEAF9D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61039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5E04-59C6-4ACF-9959-AD5EA13FC8A2}" type="datetimeFigureOut">
              <a:rPr lang="en-US" smtClean="0"/>
              <a:t>12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9D40B-1AD2-493E-B83F-35EDEAF9D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4319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5E04-59C6-4ACF-9959-AD5EA13FC8A2}" type="datetimeFigureOut">
              <a:rPr lang="en-US" smtClean="0"/>
              <a:t>12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9D40B-1AD2-493E-B83F-35EDEAF9D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5693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5E04-59C6-4ACF-9959-AD5EA13FC8A2}" type="datetimeFigureOut">
              <a:rPr lang="en-US" smtClean="0"/>
              <a:t>12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9D40B-1AD2-493E-B83F-35EDEAF9D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5586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5E04-59C6-4ACF-9959-AD5EA13FC8A2}" type="datetimeFigureOut">
              <a:rPr lang="en-US" smtClean="0"/>
              <a:t>12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9D40B-1AD2-493E-B83F-35EDEAF9D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91847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5E04-59C6-4ACF-9959-AD5EA13FC8A2}" type="datetimeFigureOut">
              <a:rPr lang="en-US" smtClean="0"/>
              <a:t>12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9D40B-1AD2-493E-B83F-35EDEAF9D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34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5E04-59C6-4ACF-9959-AD5EA13FC8A2}" type="datetimeFigureOut">
              <a:rPr lang="en-US" smtClean="0"/>
              <a:t>12/2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9D40B-1AD2-493E-B83F-35EDEAF9D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860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5E04-59C6-4ACF-9959-AD5EA13FC8A2}" type="datetimeFigureOut">
              <a:rPr lang="en-US" smtClean="0"/>
              <a:t>12/2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9D40B-1AD2-493E-B83F-35EDEAF9D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5377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5E04-59C6-4ACF-9959-AD5EA13FC8A2}" type="datetimeFigureOut">
              <a:rPr lang="en-US" smtClean="0"/>
              <a:t>12/2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9D40B-1AD2-493E-B83F-35EDEAF9D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0711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5E04-59C6-4ACF-9959-AD5EA13FC8A2}" type="datetimeFigureOut">
              <a:rPr lang="en-US" smtClean="0"/>
              <a:t>12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9D40B-1AD2-493E-B83F-35EDEAF9D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0032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CA5E04-59C6-4ACF-9959-AD5EA13FC8A2}" type="datetimeFigureOut">
              <a:rPr lang="en-US" smtClean="0"/>
              <a:t>12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79D40B-1AD2-493E-B83F-35EDEAF9D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631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CA5E04-59C6-4ACF-9959-AD5EA13FC8A2}" type="datetimeFigureOut">
              <a:rPr lang="en-US" smtClean="0"/>
              <a:t>12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79D40B-1AD2-493E-B83F-35EDEAF9D0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8998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tif"/><Relationship Id="rId1" Type="http://schemas.openxmlformats.org/officeDocument/2006/relationships/slideLayout" Target="../slideLayouts/slideLayout6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tif"/><Relationship Id="rId1" Type="http://schemas.openxmlformats.org/officeDocument/2006/relationships/slideLayout" Target="../slideLayouts/slideLayout6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6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9.png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0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Picture 32">
            <a:extLst>
              <a:ext uri="{FF2B5EF4-FFF2-40B4-BE49-F238E27FC236}">
                <a16:creationId xmlns:a16="http://schemas.microsoft.com/office/drawing/2014/main" id="{B133F96E-97C8-4431-8B34-0505F952D8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378" y="770076"/>
            <a:ext cx="6488285" cy="3625462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B1A0BAED-2704-4079-A66B-A905C7B1362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478277"/>
            <a:ext cx="6595663" cy="392012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5F12EF0-2231-4581-9CF3-187963ABC21D}"/>
              </a:ext>
            </a:extLst>
          </p:cNvPr>
          <p:cNvSpPr txBox="1"/>
          <p:nvPr/>
        </p:nvSpPr>
        <p:spPr>
          <a:xfrm>
            <a:off x="0" y="0"/>
            <a:ext cx="1712068" cy="4085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Palatino Linotype" panose="02040502050505030304" pitchFamily="18" charset="0"/>
              </a:rPr>
              <a:t>Fig. S1</a:t>
            </a:r>
          </a:p>
        </p:txBody>
      </p:sp>
    </p:spTree>
    <p:extLst>
      <p:ext uri="{BB962C8B-B14F-4D97-AF65-F5344CB8AC3E}">
        <p14:creationId xmlns:p14="http://schemas.microsoft.com/office/powerpoint/2010/main" val="214392825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E878DCB-8D62-450D-94F4-EB4275BB17F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863" t="6452"/>
          <a:stretch/>
        </p:blipFill>
        <p:spPr>
          <a:xfrm>
            <a:off x="1958340" y="296015"/>
            <a:ext cx="3017520" cy="233242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528B720-E242-477E-B095-6AD940791F4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863" t="5958"/>
          <a:stretch/>
        </p:blipFill>
        <p:spPr>
          <a:xfrm>
            <a:off x="1958340" y="2672277"/>
            <a:ext cx="3017520" cy="234474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28648DB-35D2-4555-BD16-ACD1A4E7586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669" t="6452"/>
          <a:stretch/>
        </p:blipFill>
        <p:spPr>
          <a:xfrm>
            <a:off x="1958340" y="5046768"/>
            <a:ext cx="3017520" cy="232767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B6A8BE6-AA94-4562-A26A-A8EBD061C8A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669" t="5958"/>
          <a:stretch/>
        </p:blipFill>
        <p:spPr>
          <a:xfrm>
            <a:off x="1958340" y="7404194"/>
            <a:ext cx="3017520" cy="233996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1C53E1B-4B91-4C02-BC7F-68A36AB80F66}"/>
              </a:ext>
            </a:extLst>
          </p:cNvPr>
          <p:cNvSpPr txBox="1"/>
          <p:nvPr/>
        </p:nvSpPr>
        <p:spPr>
          <a:xfrm>
            <a:off x="3131771" y="0"/>
            <a:ext cx="1265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Palatino Linotype" panose="02040502050505030304" pitchFamily="18" charset="0"/>
              </a:rPr>
              <a:t>HT139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14909DD-818A-419C-A9E8-54BB28468FD6}"/>
              </a:ext>
            </a:extLst>
          </p:cNvPr>
          <p:cNvSpPr txBox="1"/>
          <p:nvPr/>
        </p:nvSpPr>
        <p:spPr>
          <a:xfrm rot="16200000">
            <a:off x="788875" y="3537118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1 Copy Ratio (log2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3C89520-4CD0-43AA-B973-AF6D6396B0EF}"/>
              </a:ext>
            </a:extLst>
          </p:cNvPr>
          <p:cNvSpPr txBox="1"/>
          <p:nvPr/>
        </p:nvSpPr>
        <p:spPr>
          <a:xfrm rot="16200000">
            <a:off x="788874" y="1109029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0 Copy Ratio (log2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11FD4E0-7820-4E9C-90AD-BFBF00F425B9}"/>
              </a:ext>
            </a:extLst>
          </p:cNvPr>
          <p:cNvSpPr txBox="1"/>
          <p:nvPr/>
        </p:nvSpPr>
        <p:spPr>
          <a:xfrm rot="16200000">
            <a:off x="788875" y="5979502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2 Copy Ratio (log2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E7EE78F-D4BB-4D13-A80F-1EE4A0339B00}"/>
              </a:ext>
            </a:extLst>
          </p:cNvPr>
          <p:cNvSpPr txBox="1"/>
          <p:nvPr/>
        </p:nvSpPr>
        <p:spPr>
          <a:xfrm rot="16200000">
            <a:off x="788874" y="8365736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3 Copy Ratio (log2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6EEC2CD-D800-4063-AA3C-AE5896E0F95A}"/>
              </a:ext>
            </a:extLst>
          </p:cNvPr>
          <p:cNvSpPr txBox="1"/>
          <p:nvPr/>
        </p:nvSpPr>
        <p:spPr>
          <a:xfrm>
            <a:off x="1663565" y="0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359AAC5-B09C-478E-98C5-60145F4D16EA}"/>
              </a:ext>
            </a:extLst>
          </p:cNvPr>
          <p:cNvSpPr txBox="1"/>
          <p:nvPr/>
        </p:nvSpPr>
        <p:spPr>
          <a:xfrm>
            <a:off x="1652510" y="2547786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A90EF52-B075-472F-BB89-D2462AEE1883}"/>
              </a:ext>
            </a:extLst>
          </p:cNvPr>
          <p:cNvSpPr txBox="1"/>
          <p:nvPr/>
        </p:nvSpPr>
        <p:spPr>
          <a:xfrm>
            <a:off x="1652510" y="4937349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F427300-6C33-409D-8DDE-06B7A0BB6F7F}"/>
              </a:ext>
            </a:extLst>
          </p:cNvPr>
          <p:cNvSpPr txBox="1"/>
          <p:nvPr/>
        </p:nvSpPr>
        <p:spPr>
          <a:xfrm>
            <a:off x="1673945" y="7230607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0B312C3-D72B-490A-8750-4B9FD2A435C8}"/>
              </a:ext>
            </a:extLst>
          </p:cNvPr>
          <p:cNvSpPr txBox="1"/>
          <p:nvPr/>
        </p:nvSpPr>
        <p:spPr>
          <a:xfrm>
            <a:off x="0" y="0"/>
            <a:ext cx="11089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Palatino Linotype" panose="02040502050505030304" pitchFamily="18" charset="0"/>
              </a:rPr>
              <a:t>Fig. S10</a:t>
            </a:r>
          </a:p>
        </p:txBody>
      </p:sp>
    </p:spTree>
    <p:extLst>
      <p:ext uri="{BB962C8B-B14F-4D97-AF65-F5344CB8AC3E}">
        <p14:creationId xmlns:p14="http://schemas.microsoft.com/office/powerpoint/2010/main" val="347513266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A picture containing text, music&#10;&#10;Description automatically generated">
            <a:extLst>
              <a:ext uri="{FF2B5EF4-FFF2-40B4-BE49-F238E27FC236}">
                <a16:creationId xmlns:a16="http://schemas.microsoft.com/office/drawing/2014/main" id="{698DDEF8-0DE5-42EB-B516-86ECDD662FD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97541"/>
            <a:ext cx="6858000" cy="11379758"/>
          </a:xfrm>
          <a:prstGeom prst="rect">
            <a:avLst/>
          </a:prstGeom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C352EB95-8910-4229-9B71-BA6961753F64}"/>
              </a:ext>
            </a:extLst>
          </p:cNvPr>
          <p:cNvGrpSpPr/>
          <p:nvPr/>
        </p:nvGrpSpPr>
        <p:grpSpPr>
          <a:xfrm>
            <a:off x="69379" y="677324"/>
            <a:ext cx="6680335" cy="11028372"/>
            <a:chOff x="-31817" y="300900"/>
            <a:chExt cx="6680335" cy="11028372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E1726B4-6C05-4634-A2C1-56150886F3BE}"/>
                </a:ext>
              </a:extLst>
            </p:cNvPr>
            <p:cNvSpPr txBox="1"/>
            <p:nvPr/>
          </p:nvSpPr>
          <p:spPr>
            <a:xfrm>
              <a:off x="655092" y="1221475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72-P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589A8BB-552D-4F4B-AA5B-4775673EF4A3}"/>
                </a:ext>
              </a:extLst>
            </p:cNvPr>
            <p:cNvSpPr txBox="1"/>
            <p:nvPr/>
          </p:nvSpPr>
          <p:spPr>
            <a:xfrm>
              <a:off x="655092" y="1694598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72-P1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AA5DEB4-CCD7-4DDB-AC8D-207B6A634BFA}"/>
                </a:ext>
              </a:extLst>
            </p:cNvPr>
            <p:cNvSpPr txBox="1"/>
            <p:nvPr/>
          </p:nvSpPr>
          <p:spPr>
            <a:xfrm>
              <a:off x="655092" y="2167721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72-P2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24765F2-9317-4A2C-8DB6-3EB8626B0715}"/>
                </a:ext>
              </a:extLst>
            </p:cNvPr>
            <p:cNvSpPr txBox="1"/>
            <p:nvPr/>
          </p:nvSpPr>
          <p:spPr>
            <a:xfrm>
              <a:off x="4001068" y="1552756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Palatino Linotype" panose="02040502050505030304" pitchFamily="18" charset="0"/>
                </a:rPr>
                <a:t>HT77-P1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2F2BBF4-06E4-4230-BAEC-46EEA9A9EC70}"/>
                </a:ext>
              </a:extLst>
            </p:cNvPr>
            <p:cNvSpPr txBox="1"/>
            <p:nvPr/>
          </p:nvSpPr>
          <p:spPr>
            <a:xfrm>
              <a:off x="4005885" y="1881317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Palatino Linotype" panose="02040502050505030304" pitchFamily="18" charset="0"/>
                </a:rPr>
                <a:t>HT77-P2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B321994-E6D4-41CA-8867-E1CE2BCE08BA}"/>
                </a:ext>
              </a:extLst>
            </p:cNvPr>
            <p:cNvSpPr txBox="1"/>
            <p:nvPr/>
          </p:nvSpPr>
          <p:spPr>
            <a:xfrm>
              <a:off x="4001068" y="2238458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Palatino Linotype" panose="02040502050505030304" pitchFamily="18" charset="0"/>
                </a:rPr>
                <a:t>HT77-P3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58252E9-71B8-42EE-B8B7-970462903C92}"/>
                </a:ext>
              </a:extLst>
            </p:cNvPr>
            <p:cNvSpPr txBox="1"/>
            <p:nvPr/>
          </p:nvSpPr>
          <p:spPr>
            <a:xfrm>
              <a:off x="831435" y="4019797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87-P0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70CD3A27-9EC2-4411-BA8A-95AC0E911661}"/>
                </a:ext>
              </a:extLst>
            </p:cNvPr>
            <p:cNvSpPr txBox="1"/>
            <p:nvPr/>
          </p:nvSpPr>
          <p:spPr>
            <a:xfrm>
              <a:off x="831435" y="4367307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87-P1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D582D7FC-4D17-4A69-8FBE-880A3E2B1F8B}"/>
                </a:ext>
              </a:extLst>
            </p:cNvPr>
            <p:cNvSpPr txBox="1"/>
            <p:nvPr/>
          </p:nvSpPr>
          <p:spPr>
            <a:xfrm>
              <a:off x="823104" y="4743828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87-P2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8EBED50-D4B7-49DD-B646-25C928A73A15}"/>
                </a:ext>
              </a:extLst>
            </p:cNvPr>
            <p:cNvSpPr txBox="1"/>
            <p:nvPr/>
          </p:nvSpPr>
          <p:spPr>
            <a:xfrm>
              <a:off x="840376" y="5136641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87-P3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22417B3-5BFE-40D7-B63C-7E010935FABB}"/>
                </a:ext>
              </a:extLst>
            </p:cNvPr>
            <p:cNvSpPr txBox="1"/>
            <p:nvPr/>
          </p:nvSpPr>
          <p:spPr>
            <a:xfrm>
              <a:off x="146627" y="5182230"/>
              <a:ext cx="56519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Palatino Linotype" panose="02040502050505030304" pitchFamily="18" charset="0"/>
                </a:rPr>
                <a:t>Set Size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D38DC60-FC82-40F1-8DD8-C97CE29DC3F1}"/>
                </a:ext>
              </a:extLst>
            </p:cNvPr>
            <p:cNvSpPr txBox="1"/>
            <p:nvPr/>
          </p:nvSpPr>
          <p:spPr>
            <a:xfrm>
              <a:off x="667412" y="5052611"/>
              <a:ext cx="1091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0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AE23E88-B873-4059-A115-98396905CD29}"/>
                </a:ext>
              </a:extLst>
            </p:cNvPr>
            <p:cNvSpPr txBox="1"/>
            <p:nvPr/>
          </p:nvSpPr>
          <p:spPr>
            <a:xfrm>
              <a:off x="271941" y="5057635"/>
              <a:ext cx="4004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100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30B59FA-8A67-4C32-BA6D-F3A81754EC22}"/>
                </a:ext>
              </a:extLst>
            </p:cNvPr>
            <p:cNvSpPr txBox="1"/>
            <p:nvPr/>
          </p:nvSpPr>
          <p:spPr>
            <a:xfrm>
              <a:off x="-31817" y="5057635"/>
              <a:ext cx="4004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2000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C84F1778-6DEF-450C-900E-12DB3D40369D}"/>
                </a:ext>
              </a:extLst>
            </p:cNvPr>
            <p:cNvSpPr txBox="1"/>
            <p:nvPr/>
          </p:nvSpPr>
          <p:spPr>
            <a:xfrm>
              <a:off x="3710134" y="5498126"/>
              <a:ext cx="56519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Palatino Linotype" panose="02040502050505030304" pitchFamily="18" charset="0"/>
                </a:rPr>
                <a:t>Set Size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A33D678-EFDC-4AF3-A416-ECFEA2086048}"/>
                </a:ext>
              </a:extLst>
            </p:cNvPr>
            <p:cNvSpPr txBox="1"/>
            <p:nvPr/>
          </p:nvSpPr>
          <p:spPr>
            <a:xfrm>
              <a:off x="4239256" y="5052611"/>
              <a:ext cx="1091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0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0811949-90AF-439E-A528-4A0F40F15315}"/>
                </a:ext>
              </a:extLst>
            </p:cNvPr>
            <p:cNvSpPr txBox="1"/>
            <p:nvPr/>
          </p:nvSpPr>
          <p:spPr>
            <a:xfrm>
              <a:off x="3843785" y="5057635"/>
              <a:ext cx="4004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100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ADAB9F4-C43A-4E27-B3E7-1A950499E04F}"/>
                </a:ext>
              </a:extLst>
            </p:cNvPr>
            <p:cNvSpPr txBox="1"/>
            <p:nvPr/>
          </p:nvSpPr>
          <p:spPr>
            <a:xfrm>
              <a:off x="189556" y="8600560"/>
              <a:ext cx="56519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Palatino Linotype" panose="02040502050505030304" pitchFamily="18" charset="0"/>
                </a:rPr>
                <a:t>Set Size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2D8BDAAA-E959-4F6D-8F73-9D0485BF5E52}"/>
                </a:ext>
              </a:extLst>
            </p:cNvPr>
            <p:cNvSpPr txBox="1"/>
            <p:nvPr/>
          </p:nvSpPr>
          <p:spPr>
            <a:xfrm>
              <a:off x="154748" y="2489077"/>
              <a:ext cx="56519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Palatino Linotype" panose="02040502050505030304" pitchFamily="18" charset="0"/>
                </a:rPr>
                <a:t>Set Size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3A00F04E-6410-486F-B200-2352386EA951}"/>
                </a:ext>
              </a:extLst>
            </p:cNvPr>
            <p:cNvSpPr txBox="1"/>
            <p:nvPr/>
          </p:nvSpPr>
          <p:spPr>
            <a:xfrm>
              <a:off x="654768" y="2400609"/>
              <a:ext cx="1091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0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1D63E5BA-9BCD-4809-982C-D07B54A4B85B}"/>
                </a:ext>
              </a:extLst>
            </p:cNvPr>
            <p:cNvSpPr txBox="1"/>
            <p:nvPr/>
          </p:nvSpPr>
          <p:spPr>
            <a:xfrm>
              <a:off x="192496" y="2390239"/>
              <a:ext cx="23010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2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8E368E78-8FA1-4F7E-A900-3961FA0E2DB2}"/>
                </a:ext>
              </a:extLst>
            </p:cNvPr>
            <p:cNvSpPr txBox="1"/>
            <p:nvPr/>
          </p:nvSpPr>
          <p:spPr>
            <a:xfrm>
              <a:off x="3948052" y="2540056"/>
              <a:ext cx="56519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Palatino Linotype" panose="02040502050505030304" pitchFamily="18" charset="0"/>
                </a:rPr>
                <a:t>Set Size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222757C3-12DB-442E-B90E-B1B05393CBA4}"/>
                </a:ext>
              </a:extLst>
            </p:cNvPr>
            <p:cNvSpPr txBox="1"/>
            <p:nvPr/>
          </p:nvSpPr>
          <p:spPr>
            <a:xfrm>
              <a:off x="4342841" y="3924051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96-P0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63877C2E-E455-4CD1-9296-B83E899DC507}"/>
                </a:ext>
              </a:extLst>
            </p:cNvPr>
            <p:cNvSpPr txBox="1"/>
            <p:nvPr/>
          </p:nvSpPr>
          <p:spPr>
            <a:xfrm>
              <a:off x="4342841" y="4300357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96-P1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91DAEF32-930D-49BD-874B-227EF69D81A5}"/>
                </a:ext>
              </a:extLst>
            </p:cNvPr>
            <p:cNvSpPr txBox="1"/>
            <p:nvPr/>
          </p:nvSpPr>
          <p:spPr>
            <a:xfrm>
              <a:off x="4327786" y="4671621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96-P2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53C04589-CA07-4C1F-B4CB-59DB619F2141}"/>
                </a:ext>
              </a:extLst>
            </p:cNvPr>
            <p:cNvSpPr txBox="1"/>
            <p:nvPr/>
          </p:nvSpPr>
          <p:spPr>
            <a:xfrm>
              <a:off x="4335922" y="5048186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96-P3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CE2DA755-BB54-48B9-9002-571D00C991EB}"/>
                </a:ext>
              </a:extLst>
            </p:cNvPr>
            <p:cNvSpPr txBox="1"/>
            <p:nvPr/>
          </p:nvSpPr>
          <p:spPr>
            <a:xfrm>
              <a:off x="840376" y="7093734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74-P0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481ED392-C48B-4CF1-8FF1-AD38ADE807ED}"/>
                </a:ext>
              </a:extLst>
            </p:cNvPr>
            <p:cNvSpPr txBox="1"/>
            <p:nvPr/>
          </p:nvSpPr>
          <p:spPr>
            <a:xfrm>
              <a:off x="831435" y="7622647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74-P1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3943CC50-B3BE-434B-A2D6-043E149D1EBA}"/>
                </a:ext>
              </a:extLst>
            </p:cNvPr>
            <p:cNvSpPr txBox="1"/>
            <p:nvPr/>
          </p:nvSpPr>
          <p:spPr>
            <a:xfrm>
              <a:off x="850365" y="8110525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74-P2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17DA634D-656A-4F13-8CF7-12DD0A4C3241}"/>
                </a:ext>
              </a:extLst>
            </p:cNvPr>
            <p:cNvSpPr txBox="1"/>
            <p:nvPr/>
          </p:nvSpPr>
          <p:spPr>
            <a:xfrm>
              <a:off x="4459848" y="7014227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98-P0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71DCA221-7F8F-472A-B996-99805FA2060F}"/>
                </a:ext>
              </a:extLst>
            </p:cNvPr>
            <p:cNvSpPr txBox="1"/>
            <p:nvPr/>
          </p:nvSpPr>
          <p:spPr>
            <a:xfrm>
              <a:off x="4459848" y="7366911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98-P1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FC185687-A5B2-4077-B12F-0F33502D706D}"/>
                </a:ext>
              </a:extLst>
            </p:cNvPr>
            <p:cNvSpPr txBox="1"/>
            <p:nvPr/>
          </p:nvSpPr>
          <p:spPr>
            <a:xfrm>
              <a:off x="4465511" y="7738152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98-P2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8DF3A785-035F-4613-A792-5BF812D15CBE}"/>
                </a:ext>
              </a:extLst>
            </p:cNvPr>
            <p:cNvSpPr txBox="1"/>
            <p:nvPr/>
          </p:nvSpPr>
          <p:spPr>
            <a:xfrm>
              <a:off x="4459848" y="8126675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98-P3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8A20017F-C2A9-41EE-9602-F6B92D3F7310}"/>
                </a:ext>
              </a:extLst>
            </p:cNvPr>
            <p:cNvSpPr txBox="1"/>
            <p:nvPr/>
          </p:nvSpPr>
          <p:spPr>
            <a:xfrm>
              <a:off x="823104" y="9961189"/>
              <a:ext cx="6606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50" b="1" dirty="0">
                  <a:latin typeface="Palatino Linotype" panose="02040502050505030304" pitchFamily="18" charset="0"/>
                </a:rPr>
                <a:t>HT120-P0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8C2E3B05-DEEC-4D1A-9B99-F195416F7B38}"/>
                </a:ext>
              </a:extLst>
            </p:cNvPr>
            <p:cNvSpPr txBox="1"/>
            <p:nvPr/>
          </p:nvSpPr>
          <p:spPr>
            <a:xfrm>
              <a:off x="823104" y="10352034"/>
              <a:ext cx="6606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50" b="1" dirty="0">
                  <a:latin typeface="Palatino Linotype" panose="02040502050505030304" pitchFamily="18" charset="0"/>
                </a:rPr>
                <a:t>HT120-P1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B9F86066-B6A4-47C2-BC1B-3C161A9D80AD}"/>
                </a:ext>
              </a:extLst>
            </p:cNvPr>
            <p:cNvSpPr txBox="1"/>
            <p:nvPr/>
          </p:nvSpPr>
          <p:spPr>
            <a:xfrm>
              <a:off x="823104" y="10722169"/>
              <a:ext cx="6606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50" b="1" dirty="0">
                  <a:latin typeface="Palatino Linotype" panose="02040502050505030304" pitchFamily="18" charset="0"/>
                </a:rPr>
                <a:t>HT120-P2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E94D93F0-AC62-49C9-8694-D50319120B42}"/>
                </a:ext>
              </a:extLst>
            </p:cNvPr>
            <p:cNvSpPr txBox="1"/>
            <p:nvPr/>
          </p:nvSpPr>
          <p:spPr>
            <a:xfrm>
              <a:off x="823104" y="11113828"/>
              <a:ext cx="6606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50" b="1" dirty="0">
                  <a:latin typeface="Palatino Linotype" panose="02040502050505030304" pitchFamily="18" charset="0"/>
                </a:rPr>
                <a:t>HT120-P3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D3B09752-14E1-41EB-9306-035CC389E260}"/>
                </a:ext>
              </a:extLst>
            </p:cNvPr>
            <p:cNvSpPr txBox="1"/>
            <p:nvPr/>
          </p:nvSpPr>
          <p:spPr>
            <a:xfrm>
              <a:off x="4643367" y="9930094"/>
              <a:ext cx="6606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50" b="1" dirty="0">
                  <a:latin typeface="Palatino Linotype" panose="02040502050505030304" pitchFamily="18" charset="0"/>
                </a:rPr>
                <a:t>HT139-P0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4E0280BD-8F41-4265-8BD1-18B04306FF59}"/>
                </a:ext>
              </a:extLst>
            </p:cNvPr>
            <p:cNvSpPr txBox="1"/>
            <p:nvPr/>
          </p:nvSpPr>
          <p:spPr>
            <a:xfrm>
              <a:off x="4627896" y="10283917"/>
              <a:ext cx="6606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50" b="1" dirty="0">
                  <a:latin typeface="Palatino Linotype" panose="02040502050505030304" pitchFamily="18" charset="0"/>
                </a:rPr>
                <a:t>HT139-P1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FEE13559-7222-4B63-B182-C7D81AC07B25}"/>
                </a:ext>
              </a:extLst>
            </p:cNvPr>
            <p:cNvSpPr txBox="1"/>
            <p:nvPr/>
          </p:nvSpPr>
          <p:spPr>
            <a:xfrm>
              <a:off x="4634064" y="10617967"/>
              <a:ext cx="6606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50" b="1" dirty="0">
                  <a:latin typeface="Palatino Linotype" panose="02040502050505030304" pitchFamily="18" charset="0"/>
                </a:rPr>
                <a:t>HT139-P2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008413BB-FF0C-438A-8C87-37DC924F60BF}"/>
                </a:ext>
              </a:extLst>
            </p:cNvPr>
            <p:cNvSpPr txBox="1"/>
            <p:nvPr/>
          </p:nvSpPr>
          <p:spPr>
            <a:xfrm>
              <a:off x="4634693" y="10976645"/>
              <a:ext cx="6606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50" b="1" dirty="0">
                  <a:latin typeface="Palatino Linotype" panose="02040502050505030304" pitchFamily="18" charset="0"/>
                </a:rPr>
                <a:t>HT139-P3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FD3AB55B-85CD-4B4C-9D9B-BEDA0A164F31}"/>
                </a:ext>
              </a:extLst>
            </p:cNvPr>
            <p:cNvSpPr txBox="1"/>
            <p:nvPr/>
          </p:nvSpPr>
          <p:spPr>
            <a:xfrm>
              <a:off x="1169110" y="3789551"/>
              <a:ext cx="20597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0</a:t>
              </a:r>
            </a:p>
          </p:txBody>
        </p:sp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52190894-D385-4321-99D9-78C6AAB90593}"/>
                </a:ext>
              </a:extLst>
            </p:cNvPr>
            <p:cNvGrpSpPr/>
            <p:nvPr/>
          </p:nvGrpSpPr>
          <p:grpSpPr>
            <a:xfrm>
              <a:off x="4657313" y="3014517"/>
              <a:ext cx="290094" cy="899401"/>
              <a:chOff x="2348882" y="7608748"/>
              <a:chExt cx="290094" cy="899401"/>
            </a:xfrm>
          </p:grpSpPr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29F8DEEA-0430-47A1-8E8D-173BA5A427A8}"/>
                  </a:ext>
                </a:extLst>
              </p:cNvPr>
              <p:cNvSpPr txBox="1"/>
              <p:nvPr/>
            </p:nvSpPr>
            <p:spPr>
              <a:xfrm>
                <a:off x="2361122" y="7956805"/>
                <a:ext cx="24824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latin typeface="Palatino Linotype" panose="02040502050505030304" pitchFamily="18" charset="0"/>
                  </a:rPr>
                  <a:t>1</a:t>
                </a:r>
              </a:p>
            </p:txBody>
          </p: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460A7A3C-A44E-49F6-BC9E-020DC28E4764}"/>
                  </a:ext>
                </a:extLst>
              </p:cNvPr>
              <p:cNvSpPr txBox="1"/>
              <p:nvPr/>
            </p:nvSpPr>
            <p:spPr>
              <a:xfrm>
                <a:off x="2361367" y="7608748"/>
                <a:ext cx="277609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latin typeface="Palatino Linotype" panose="02040502050505030304" pitchFamily="18" charset="0"/>
                  </a:rPr>
                  <a:t>2</a:t>
                </a:r>
              </a:p>
            </p:txBody>
          </p:sp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1298A758-2D57-4D94-BF8A-371806F792C2}"/>
                  </a:ext>
                </a:extLst>
              </p:cNvPr>
              <p:cNvSpPr txBox="1"/>
              <p:nvPr/>
            </p:nvSpPr>
            <p:spPr>
              <a:xfrm>
                <a:off x="2348882" y="8308094"/>
                <a:ext cx="20597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latin typeface="Palatino Linotype" panose="02040502050505030304" pitchFamily="18" charset="0"/>
                  </a:rPr>
                  <a:t>0</a:t>
                </a:r>
              </a:p>
            </p:txBody>
          </p:sp>
        </p:grpSp>
        <p:grpSp>
          <p:nvGrpSpPr>
            <p:cNvPr id="84" name="Group 83">
              <a:extLst>
                <a:ext uri="{FF2B5EF4-FFF2-40B4-BE49-F238E27FC236}">
                  <a16:creationId xmlns:a16="http://schemas.microsoft.com/office/drawing/2014/main" id="{C4CE9E00-F498-48EB-A7E1-085F1A9C53E9}"/>
                </a:ext>
              </a:extLst>
            </p:cNvPr>
            <p:cNvGrpSpPr/>
            <p:nvPr/>
          </p:nvGrpSpPr>
          <p:grpSpPr>
            <a:xfrm>
              <a:off x="701825" y="365740"/>
              <a:ext cx="494239" cy="845298"/>
              <a:chOff x="1984487" y="7492273"/>
              <a:chExt cx="494239" cy="845298"/>
            </a:xfrm>
          </p:grpSpPr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1D566F26-CF45-4D22-B7EA-E9563ED779E5}"/>
                  </a:ext>
                </a:extLst>
              </p:cNvPr>
              <p:cNvSpPr txBox="1"/>
              <p:nvPr/>
            </p:nvSpPr>
            <p:spPr>
              <a:xfrm rot="16200000">
                <a:off x="1739484" y="7737276"/>
                <a:ext cx="82856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Palatino Linotype" panose="02040502050505030304" pitchFamily="18" charset="0"/>
                  </a:rPr>
                  <a:t>Frameshift</a:t>
                </a:r>
              </a:p>
              <a:p>
                <a:pPr algn="ctr"/>
                <a:r>
                  <a:rPr lang="en-US" sz="800" b="1" dirty="0">
                    <a:latin typeface="Palatino Linotype" panose="02040502050505030304" pitchFamily="18" charset="0"/>
                  </a:rPr>
                  <a:t> Intersections</a:t>
                </a:r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F2F31571-908B-4918-82A5-120AC2E4623C}"/>
                  </a:ext>
                </a:extLst>
              </p:cNvPr>
              <p:cNvSpPr txBox="1"/>
              <p:nvPr/>
            </p:nvSpPr>
            <p:spPr>
              <a:xfrm>
                <a:off x="2243150" y="7954656"/>
                <a:ext cx="23557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latin typeface="Palatino Linotype" panose="02040502050505030304" pitchFamily="18" charset="0"/>
                  </a:rPr>
                  <a:t>1</a:t>
                </a:r>
              </a:p>
            </p:txBody>
          </p: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D28CC6FC-37AD-42DB-9C03-E3D60D224643}"/>
                  </a:ext>
                </a:extLst>
              </p:cNvPr>
              <p:cNvSpPr txBox="1"/>
              <p:nvPr/>
            </p:nvSpPr>
            <p:spPr>
              <a:xfrm>
                <a:off x="2248746" y="8137516"/>
                <a:ext cx="20597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latin typeface="Palatino Linotype" panose="02040502050505030304" pitchFamily="18" charset="0"/>
                  </a:rPr>
                  <a:t>0</a:t>
                </a:r>
              </a:p>
            </p:txBody>
          </p:sp>
        </p:grp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CF4F9424-B815-4B48-8B18-1D4176B2F799}"/>
                </a:ext>
              </a:extLst>
            </p:cNvPr>
            <p:cNvSpPr txBox="1"/>
            <p:nvPr/>
          </p:nvSpPr>
          <p:spPr>
            <a:xfrm>
              <a:off x="1429355" y="946798"/>
              <a:ext cx="33131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21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26FF4F17-38EB-4192-AA6C-31D3789253BD}"/>
                </a:ext>
              </a:extLst>
            </p:cNvPr>
            <p:cNvSpPr txBox="1"/>
            <p:nvPr/>
          </p:nvSpPr>
          <p:spPr>
            <a:xfrm>
              <a:off x="1995976" y="946798"/>
              <a:ext cx="33131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41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338BCBCF-4B33-4EC1-963C-11463EFA40B3}"/>
                </a:ext>
              </a:extLst>
            </p:cNvPr>
            <p:cNvSpPr txBox="1"/>
            <p:nvPr/>
          </p:nvSpPr>
          <p:spPr>
            <a:xfrm>
              <a:off x="1743612" y="353112"/>
              <a:ext cx="30201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3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81B07CDD-47E0-473F-AD7C-F4AD2C9FE8DF}"/>
                </a:ext>
              </a:extLst>
            </p:cNvPr>
            <p:cNvSpPr txBox="1"/>
            <p:nvPr/>
          </p:nvSpPr>
          <p:spPr>
            <a:xfrm>
              <a:off x="1525480" y="6547876"/>
              <a:ext cx="33131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1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D497124E-46DB-44F4-817F-5C4C68C5C943}"/>
                </a:ext>
              </a:extLst>
            </p:cNvPr>
            <p:cNvSpPr txBox="1"/>
            <p:nvPr/>
          </p:nvSpPr>
          <p:spPr>
            <a:xfrm>
              <a:off x="2108397" y="6556241"/>
              <a:ext cx="33131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1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FD1BEC16-902C-4820-AA4E-ED162D61997F}"/>
                </a:ext>
              </a:extLst>
            </p:cNvPr>
            <p:cNvSpPr txBox="1"/>
            <p:nvPr/>
          </p:nvSpPr>
          <p:spPr>
            <a:xfrm>
              <a:off x="2590657" y="6261545"/>
              <a:ext cx="30201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8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5BF970CF-4B8B-4E04-9B23-3EE8B2B64A02}"/>
                </a:ext>
              </a:extLst>
            </p:cNvPr>
            <p:cNvSpPr txBox="1"/>
            <p:nvPr/>
          </p:nvSpPr>
          <p:spPr>
            <a:xfrm>
              <a:off x="2675352" y="6061490"/>
              <a:ext cx="4918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3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21762218-DE10-4B65-AEB7-FB89B50034DE}"/>
                </a:ext>
              </a:extLst>
            </p:cNvPr>
            <p:cNvSpPr txBox="1"/>
            <p:nvPr/>
          </p:nvSpPr>
          <p:spPr>
            <a:xfrm>
              <a:off x="5677027" y="300900"/>
              <a:ext cx="37844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2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760B74B8-30B1-478D-8A83-4AC8107BF36F}"/>
                </a:ext>
              </a:extLst>
            </p:cNvPr>
            <p:cNvSpPr txBox="1"/>
            <p:nvPr/>
          </p:nvSpPr>
          <p:spPr>
            <a:xfrm>
              <a:off x="1514549" y="3473704"/>
              <a:ext cx="25289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1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CF640A7C-0D97-443C-BDAC-04AF43F46548}"/>
                </a:ext>
              </a:extLst>
            </p:cNvPr>
            <p:cNvSpPr txBox="1"/>
            <p:nvPr/>
          </p:nvSpPr>
          <p:spPr>
            <a:xfrm>
              <a:off x="2701057" y="3021159"/>
              <a:ext cx="4004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3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0AA4DC52-A950-419F-AA27-EE71D8330236}"/>
                </a:ext>
              </a:extLst>
            </p:cNvPr>
            <p:cNvSpPr txBox="1"/>
            <p:nvPr/>
          </p:nvSpPr>
          <p:spPr>
            <a:xfrm>
              <a:off x="6187072" y="3495606"/>
              <a:ext cx="32096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93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3BB78571-0AAD-4504-9579-088B1D41C48B}"/>
                </a:ext>
              </a:extLst>
            </p:cNvPr>
            <p:cNvSpPr txBox="1"/>
            <p:nvPr/>
          </p:nvSpPr>
          <p:spPr>
            <a:xfrm>
              <a:off x="6327555" y="3518708"/>
              <a:ext cx="32096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29</a:t>
              </a:r>
            </a:p>
          </p:txBody>
        </p:sp>
      </p:grpSp>
      <p:sp>
        <p:nvSpPr>
          <p:cNvPr id="142" name="TextBox 141">
            <a:extLst>
              <a:ext uri="{FF2B5EF4-FFF2-40B4-BE49-F238E27FC236}">
                <a16:creationId xmlns:a16="http://schemas.microsoft.com/office/drawing/2014/main" id="{1402536E-D07A-40BF-A56B-6AB25EDFFE83}"/>
              </a:ext>
            </a:extLst>
          </p:cNvPr>
          <p:cNvSpPr txBox="1"/>
          <p:nvPr/>
        </p:nvSpPr>
        <p:spPr>
          <a:xfrm>
            <a:off x="1058790" y="1010449"/>
            <a:ext cx="2355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861E5A86-6B57-49ED-A7B3-2C206DFE3551}"/>
              </a:ext>
            </a:extLst>
          </p:cNvPr>
          <p:cNvSpPr txBox="1"/>
          <p:nvPr/>
        </p:nvSpPr>
        <p:spPr>
          <a:xfrm>
            <a:off x="1055896" y="800029"/>
            <a:ext cx="2355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3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81DDA8B8-198F-4DE3-8A47-C31045DD2992}"/>
              </a:ext>
            </a:extLst>
          </p:cNvPr>
          <p:cNvSpPr txBox="1"/>
          <p:nvPr/>
        </p:nvSpPr>
        <p:spPr>
          <a:xfrm rot="16200000">
            <a:off x="4311541" y="917378"/>
            <a:ext cx="8285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Frameshift</a:t>
            </a:r>
          </a:p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 Intersections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FFB180F8-4530-40DE-B5D1-FADFF2B67653}"/>
              </a:ext>
            </a:extLst>
          </p:cNvPr>
          <p:cNvSpPr txBox="1"/>
          <p:nvPr/>
        </p:nvSpPr>
        <p:spPr>
          <a:xfrm>
            <a:off x="4913248" y="1052658"/>
            <a:ext cx="2355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76A3EB6F-6C7C-4D36-AED9-DD0BAD88D1CD}"/>
              </a:ext>
            </a:extLst>
          </p:cNvPr>
          <p:cNvSpPr txBox="1"/>
          <p:nvPr/>
        </p:nvSpPr>
        <p:spPr>
          <a:xfrm>
            <a:off x="4924001" y="1357961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BF8F92B3-467D-4DAB-A0DC-D3EA06D7CB47}"/>
              </a:ext>
            </a:extLst>
          </p:cNvPr>
          <p:cNvSpPr txBox="1"/>
          <p:nvPr/>
        </p:nvSpPr>
        <p:spPr>
          <a:xfrm>
            <a:off x="4918518" y="733693"/>
            <a:ext cx="2355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F0000DC2-3694-40B2-8A4A-CE1146BF1D3E}"/>
              </a:ext>
            </a:extLst>
          </p:cNvPr>
          <p:cNvSpPr txBox="1"/>
          <p:nvPr/>
        </p:nvSpPr>
        <p:spPr>
          <a:xfrm>
            <a:off x="4585018" y="2847620"/>
            <a:ext cx="1091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356BABC5-EEDC-4E35-AA4C-F0DEA77A719B}"/>
              </a:ext>
            </a:extLst>
          </p:cNvPr>
          <p:cNvSpPr txBox="1"/>
          <p:nvPr/>
        </p:nvSpPr>
        <p:spPr>
          <a:xfrm>
            <a:off x="3896114" y="2873092"/>
            <a:ext cx="1091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70BEF15C-BE52-4786-AE63-27878AE184B9}"/>
              </a:ext>
            </a:extLst>
          </p:cNvPr>
          <p:cNvSpPr txBox="1"/>
          <p:nvPr/>
        </p:nvSpPr>
        <p:spPr>
          <a:xfrm>
            <a:off x="4597362" y="1573580"/>
            <a:ext cx="5936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b="1" dirty="0">
                <a:latin typeface="Palatino Linotype" panose="02040502050505030304" pitchFamily="18" charset="0"/>
              </a:rPr>
              <a:t>HT72-P0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572AE23A-F6F7-49BE-A1A1-1742F3312315}"/>
              </a:ext>
            </a:extLst>
          </p:cNvPr>
          <p:cNvSpPr txBox="1"/>
          <p:nvPr/>
        </p:nvSpPr>
        <p:spPr>
          <a:xfrm>
            <a:off x="4597362" y="1878710"/>
            <a:ext cx="5936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b="1" dirty="0">
                <a:latin typeface="Palatino Linotype" panose="02040502050505030304" pitchFamily="18" charset="0"/>
              </a:rPr>
              <a:t>HT72-P1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D0AFBDE4-89A1-46AD-8D4D-94EEE4E0D639}"/>
              </a:ext>
            </a:extLst>
          </p:cNvPr>
          <p:cNvSpPr txBox="1"/>
          <p:nvPr/>
        </p:nvSpPr>
        <p:spPr>
          <a:xfrm>
            <a:off x="4597362" y="2230164"/>
            <a:ext cx="5936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b="1" dirty="0">
                <a:latin typeface="Palatino Linotype" panose="02040502050505030304" pitchFamily="18" charset="0"/>
              </a:rPr>
              <a:t>HT72-P2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F47231E5-02E6-483C-B32B-E63979150C89}"/>
              </a:ext>
            </a:extLst>
          </p:cNvPr>
          <p:cNvSpPr txBox="1"/>
          <p:nvPr/>
        </p:nvSpPr>
        <p:spPr>
          <a:xfrm>
            <a:off x="4606459" y="2560559"/>
            <a:ext cx="5936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b="1" dirty="0">
                <a:latin typeface="Palatino Linotype" panose="02040502050505030304" pitchFamily="18" charset="0"/>
              </a:rPr>
              <a:t>HT72-P3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A3CB5C6B-E229-414B-9F4C-55A4BFA8C9A1}"/>
              </a:ext>
            </a:extLst>
          </p:cNvPr>
          <p:cNvSpPr txBox="1"/>
          <p:nvPr/>
        </p:nvSpPr>
        <p:spPr>
          <a:xfrm>
            <a:off x="1259686" y="3934866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2BC23384-9EF0-4610-9294-AC7CA6556C77}"/>
              </a:ext>
            </a:extLst>
          </p:cNvPr>
          <p:cNvSpPr txBox="1"/>
          <p:nvPr/>
        </p:nvSpPr>
        <p:spPr>
          <a:xfrm>
            <a:off x="1260268" y="3712381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74AA8992-229B-4762-A92B-11A4602088DE}"/>
              </a:ext>
            </a:extLst>
          </p:cNvPr>
          <p:cNvSpPr txBox="1"/>
          <p:nvPr/>
        </p:nvSpPr>
        <p:spPr>
          <a:xfrm>
            <a:off x="1267545" y="3467348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3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658F91A7-A311-4DAE-90AB-21E27BDA3C24}"/>
              </a:ext>
            </a:extLst>
          </p:cNvPr>
          <p:cNvSpPr txBox="1"/>
          <p:nvPr/>
        </p:nvSpPr>
        <p:spPr>
          <a:xfrm>
            <a:off x="2209593" y="3857841"/>
            <a:ext cx="2528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37739859-1242-4352-A375-8AA058637567}"/>
              </a:ext>
            </a:extLst>
          </p:cNvPr>
          <p:cNvSpPr txBox="1"/>
          <p:nvPr/>
        </p:nvSpPr>
        <p:spPr>
          <a:xfrm rot="16200000">
            <a:off x="752874" y="3683323"/>
            <a:ext cx="8285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Frameshift</a:t>
            </a:r>
          </a:p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 Intersections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CE6C38D6-0A55-409E-90BD-026C7D5EC5CB}"/>
              </a:ext>
            </a:extLst>
          </p:cNvPr>
          <p:cNvSpPr txBox="1"/>
          <p:nvPr/>
        </p:nvSpPr>
        <p:spPr>
          <a:xfrm>
            <a:off x="5035769" y="3671975"/>
            <a:ext cx="2528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23CD29F4-CCD3-4195-A4F7-409BBEE5163A}"/>
              </a:ext>
            </a:extLst>
          </p:cNvPr>
          <p:cNvSpPr txBox="1"/>
          <p:nvPr/>
        </p:nvSpPr>
        <p:spPr>
          <a:xfrm>
            <a:off x="5497454" y="3671975"/>
            <a:ext cx="2528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0BE3F726-0850-43F2-9507-23F02E8986A1}"/>
              </a:ext>
            </a:extLst>
          </p:cNvPr>
          <p:cNvSpPr txBox="1"/>
          <p:nvPr/>
        </p:nvSpPr>
        <p:spPr>
          <a:xfrm>
            <a:off x="5919242" y="3669701"/>
            <a:ext cx="2528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12C44176-525F-48FF-9100-6540EC81E232}"/>
              </a:ext>
            </a:extLst>
          </p:cNvPr>
          <p:cNvSpPr txBox="1"/>
          <p:nvPr/>
        </p:nvSpPr>
        <p:spPr>
          <a:xfrm>
            <a:off x="6334494" y="3297996"/>
            <a:ext cx="2528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D413AD6B-3DBA-4E2A-A82B-4DC3E6C60E1A}"/>
              </a:ext>
            </a:extLst>
          </p:cNvPr>
          <p:cNvSpPr txBox="1"/>
          <p:nvPr/>
        </p:nvSpPr>
        <p:spPr>
          <a:xfrm rot="16200000">
            <a:off x="4281888" y="3607455"/>
            <a:ext cx="8285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Frameshift</a:t>
            </a:r>
          </a:p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 Intersections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C2B4D71D-34B4-449F-BEFD-E4B40D707BA7}"/>
              </a:ext>
            </a:extLst>
          </p:cNvPr>
          <p:cNvSpPr txBox="1"/>
          <p:nvPr/>
        </p:nvSpPr>
        <p:spPr>
          <a:xfrm>
            <a:off x="893700" y="5784406"/>
            <a:ext cx="1091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5F9365B6-14D9-4435-84DB-20D1A09ACEE1}"/>
              </a:ext>
            </a:extLst>
          </p:cNvPr>
          <p:cNvSpPr txBox="1"/>
          <p:nvPr/>
        </p:nvSpPr>
        <p:spPr>
          <a:xfrm>
            <a:off x="501499" y="5784406"/>
            <a:ext cx="1091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2603D66F-742E-4F63-AB7E-2B04A61B90AA}"/>
              </a:ext>
            </a:extLst>
          </p:cNvPr>
          <p:cNvSpPr txBox="1"/>
          <p:nvPr/>
        </p:nvSpPr>
        <p:spPr>
          <a:xfrm>
            <a:off x="112145" y="5784406"/>
            <a:ext cx="1091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4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CE94B645-39A5-4158-8EB3-1361BF7C861E}"/>
              </a:ext>
            </a:extLst>
          </p:cNvPr>
          <p:cNvSpPr txBox="1"/>
          <p:nvPr/>
        </p:nvSpPr>
        <p:spPr>
          <a:xfrm>
            <a:off x="290752" y="5908853"/>
            <a:ext cx="565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Palatino Linotype" panose="02040502050505030304" pitchFamily="18" charset="0"/>
              </a:rPr>
              <a:t>Set Size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10D40FFF-F567-4F2A-9408-C28811BCD485}"/>
              </a:ext>
            </a:extLst>
          </p:cNvPr>
          <p:cNvSpPr txBox="1"/>
          <p:nvPr/>
        </p:nvSpPr>
        <p:spPr>
          <a:xfrm>
            <a:off x="3581656" y="5716058"/>
            <a:ext cx="112707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4                2                0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B61EE7B8-4BC1-46B9-9EE3-AE47A165701F}"/>
              </a:ext>
            </a:extLst>
          </p:cNvPr>
          <p:cNvSpPr txBox="1"/>
          <p:nvPr/>
        </p:nvSpPr>
        <p:spPr>
          <a:xfrm>
            <a:off x="1267544" y="6537210"/>
            <a:ext cx="205971" cy="846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3</a:t>
            </a:r>
          </a:p>
          <a:p>
            <a:endParaRPr lang="en-US" sz="700" b="1" dirty="0">
              <a:latin typeface="Palatino Linotype" panose="02040502050505030304" pitchFamily="18" charset="0"/>
            </a:endParaRPr>
          </a:p>
          <a:p>
            <a:r>
              <a:rPr lang="en-US" sz="700" b="1" dirty="0">
                <a:latin typeface="Palatino Linotype" panose="02040502050505030304" pitchFamily="18" charset="0"/>
              </a:rPr>
              <a:t>2</a:t>
            </a:r>
          </a:p>
          <a:p>
            <a:endParaRPr lang="en-US" sz="700" b="1" dirty="0">
              <a:latin typeface="Palatino Linotype" panose="02040502050505030304" pitchFamily="18" charset="0"/>
            </a:endParaRPr>
          </a:p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  <a:p>
            <a:endParaRPr lang="en-US" sz="700" b="1" dirty="0">
              <a:latin typeface="Palatino Linotype" panose="02040502050505030304" pitchFamily="18" charset="0"/>
            </a:endParaRPr>
          </a:p>
          <a:p>
            <a:r>
              <a:rPr lang="en-US" sz="700" b="1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6F6771D4-4591-4DB6-8B53-1022B612F98E}"/>
              </a:ext>
            </a:extLst>
          </p:cNvPr>
          <p:cNvSpPr txBox="1"/>
          <p:nvPr/>
        </p:nvSpPr>
        <p:spPr>
          <a:xfrm rot="16200000">
            <a:off x="751648" y="6763388"/>
            <a:ext cx="8285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Frameshift</a:t>
            </a:r>
          </a:p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 Intersections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103D173E-1A8F-4E1D-9D41-9FED86478660}"/>
              </a:ext>
            </a:extLst>
          </p:cNvPr>
          <p:cNvSpPr txBox="1"/>
          <p:nvPr/>
        </p:nvSpPr>
        <p:spPr>
          <a:xfrm>
            <a:off x="71242" y="8840226"/>
            <a:ext cx="112707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4                2                0</a:t>
            </a:r>
          </a:p>
        </p:txBody>
      </p:sp>
      <p:sp>
        <p:nvSpPr>
          <p:cNvPr id="315" name="TextBox 314">
            <a:extLst>
              <a:ext uri="{FF2B5EF4-FFF2-40B4-BE49-F238E27FC236}">
                <a16:creationId xmlns:a16="http://schemas.microsoft.com/office/drawing/2014/main" id="{F1DA6EB4-FB76-4FB0-89B3-D16E01D11F38}"/>
              </a:ext>
            </a:extLst>
          </p:cNvPr>
          <p:cNvSpPr txBox="1"/>
          <p:nvPr/>
        </p:nvSpPr>
        <p:spPr>
          <a:xfrm>
            <a:off x="3712050" y="8765603"/>
            <a:ext cx="112707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4                2                0</a:t>
            </a:r>
          </a:p>
        </p:txBody>
      </p:sp>
      <p:sp>
        <p:nvSpPr>
          <p:cNvPr id="316" name="TextBox 315">
            <a:extLst>
              <a:ext uri="{FF2B5EF4-FFF2-40B4-BE49-F238E27FC236}">
                <a16:creationId xmlns:a16="http://schemas.microsoft.com/office/drawing/2014/main" id="{7052EF57-5774-4D51-AFD8-06CF1F57A127}"/>
              </a:ext>
            </a:extLst>
          </p:cNvPr>
          <p:cNvSpPr txBox="1"/>
          <p:nvPr/>
        </p:nvSpPr>
        <p:spPr>
          <a:xfrm>
            <a:off x="3967123" y="8917239"/>
            <a:ext cx="565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Palatino Linotype" panose="02040502050505030304" pitchFamily="18" charset="0"/>
              </a:rPr>
              <a:t>Set Size</a:t>
            </a:r>
          </a:p>
        </p:txBody>
      </p:sp>
      <p:sp>
        <p:nvSpPr>
          <p:cNvPr id="317" name="TextBox 316">
            <a:extLst>
              <a:ext uri="{FF2B5EF4-FFF2-40B4-BE49-F238E27FC236}">
                <a16:creationId xmlns:a16="http://schemas.microsoft.com/office/drawing/2014/main" id="{1894C2A2-81F3-4B43-9F52-33EE9BC4EE5E}"/>
              </a:ext>
            </a:extLst>
          </p:cNvPr>
          <p:cNvSpPr txBox="1"/>
          <p:nvPr/>
        </p:nvSpPr>
        <p:spPr>
          <a:xfrm rot="16200000">
            <a:off x="4344422" y="6688966"/>
            <a:ext cx="8285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Frameshift</a:t>
            </a:r>
          </a:p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 Intersections</a:t>
            </a:r>
          </a:p>
        </p:txBody>
      </p:sp>
      <p:sp>
        <p:nvSpPr>
          <p:cNvPr id="319" name="TextBox 318">
            <a:extLst>
              <a:ext uri="{FF2B5EF4-FFF2-40B4-BE49-F238E27FC236}">
                <a16:creationId xmlns:a16="http://schemas.microsoft.com/office/drawing/2014/main" id="{970D6D45-ABAD-402F-B981-4B46FC269F7E}"/>
              </a:ext>
            </a:extLst>
          </p:cNvPr>
          <p:cNvSpPr txBox="1"/>
          <p:nvPr/>
        </p:nvSpPr>
        <p:spPr>
          <a:xfrm>
            <a:off x="4894201" y="6433179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3</a:t>
            </a:r>
          </a:p>
        </p:txBody>
      </p:sp>
      <p:sp>
        <p:nvSpPr>
          <p:cNvPr id="320" name="TextBox 319">
            <a:extLst>
              <a:ext uri="{FF2B5EF4-FFF2-40B4-BE49-F238E27FC236}">
                <a16:creationId xmlns:a16="http://schemas.microsoft.com/office/drawing/2014/main" id="{7415991E-45EB-44CC-BB48-9A254FC1EC30}"/>
              </a:ext>
            </a:extLst>
          </p:cNvPr>
          <p:cNvSpPr txBox="1"/>
          <p:nvPr/>
        </p:nvSpPr>
        <p:spPr>
          <a:xfrm>
            <a:off x="4894932" y="6670602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</a:t>
            </a:r>
          </a:p>
        </p:txBody>
      </p:sp>
      <p:sp>
        <p:nvSpPr>
          <p:cNvPr id="321" name="TextBox 320">
            <a:extLst>
              <a:ext uri="{FF2B5EF4-FFF2-40B4-BE49-F238E27FC236}">
                <a16:creationId xmlns:a16="http://schemas.microsoft.com/office/drawing/2014/main" id="{0BC016E5-F49F-4003-9E4D-EC71693AD9BD}"/>
              </a:ext>
            </a:extLst>
          </p:cNvPr>
          <p:cNvSpPr txBox="1"/>
          <p:nvPr/>
        </p:nvSpPr>
        <p:spPr>
          <a:xfrm>
            <a:off x="4899500" y="6905699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322" name="TextBox 321">
            <a:extLst>
              <a:ext uri="{FF2B5EF4-FFF2-40B4-BE49-F238E27FC236}">
                <a16:creationId xmlns:a16="http://schemas.microsoft.com/office/drawing/2014/main" id="{ED9CB613-31DC-453C-B997-013245A275F0}"/>
              </a:ext>
            </a:extLst>
          </p:cNvPr>
          <p:cNvSpPr txBox="1"/>
          <p:nvPr/>
        </p:nvSpPr>
        <p:spPr>
          <a:xfrm>
            <a:off x="4907198" y="7135349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323" name="TextBox 322">
            <a:extLst>
              <a:ext uri="{FF2B5EF4-FFF2-40B4-BE49-F238E27FC236}">
                <a16:creationId xmlns:a16="http://schemas.microsoft.com/office/drawing/2014/main" id="{ACCB7F4F-430A-4A0C-99A5-EC9F38417221}"/>
              </a:ext>
            </a:extLst>
          </p:cNvPr>
          <p:cNvSpPr txBox="1"/>
          <p:nvPr/>
        </p:nvSpPr>
        <p:spPr>
          <a:xfrm>
            <a:off x="6282241" y="6363071"/>
            <a:ext cx="49184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3</a:t>
            </a:r>
          </a:p>
        </p:txBody>
      </p:sp>
      <p:sp>
        <p:nvSpPr>
          <p:cNvPr id="324" name="TextBox 323">
            <a:extLst>
              <a:ext uri="{FF2B5EF4-FFF2-40B4-BE49-F238E27FC236}">
                <a16:creationId xmlns:a16="http://schemas.microsoft.com/office/drawing/2014/main" id="{546ACFE3-1155-480E-8D14-FD30564C524B}"/>
              </a:ext>
            </a:extLst>
          </p:cNvPr>
          <p:cNvSpPr txBox="1"/>
          <p:nvPr/>
        </p:nvSpPr>
        <p:spPr>
          <a:xfrm>
            <a:off x="5396522" y="6838024"/>
            <a:ext cx="49184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325" name="TextBox 324">
            <a:extLst>
              <a:ext uri="{FF2B5EF4-FFF2-40B4-BE49-F238E27FC236}">
                <a16:creationId xmlns:a16="http://schemas.microsoft.com/office/drawing/2014/main" id="{0AF3DF73-35BE-4E4E-9CF5-3559E5FA8855}"/>
              </a:ext>
            </a:extLst>
          </p:cNvPr>
          <p:cNvSpPr txBox="1"/>
          <p:nvPr/>
        </p:nvSpPr>
        <p:spPr>
          <a:xfrm>
            <a:off x="4021751" y="11641267"/>
            <a:ext cx="112707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                             0</a:t>
            </a:r>
          </a:p>
        </p:txBody>
      </p:sp>
      <p:sp>
        <p:nvSpPr>
          <p:cNvPr id="326" name="TextBox 325">
            <a:extLst>
              <a:ext uri="{FF2B5EF4-FFF2-40B4-BE49-F238E27FC236}">
                <a16:creationId xmlns:a16="http://schemas.microsoft.com/office/drawing/2014/main" id="{B9F9A39B-C8CC-4E8A-9484-C4E37AFEE839}"/>
              </a:ext>
            </a:extLst>
          </p:cNvPr>
          <p:cNvSpPr txBox="1"/>
          <p:nvPr/>
        </p:nvSpPr>
        <p:spPr>
          <a:xfrm>
            <a:off x="291943" y="11881733"/>
            <a:ext cx="565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Palatino Linotype" panose="02040502050505030304" pitchFamily="18" charset="0"/>
              </a:rPr>
              <a:t>Set Size</a:t>
            </a:r>
          </a:p>
        </p:txBody>
      </p:sp>
      <p:sp>
        <p:nvSpPr>
          <p:cNvPr id="327" name="TextBox 326">
            <a:extLst>
              <a:ext uri="{FF2B5EF4-FFF2-40B4-BE49-F238E27FC236}">
                <a16:creationId xmlns:a16="http://schemas.microsoft.com/office/drawing/2014/main" id="{B80706BF-DA71-45F6-AE04-8F56945088CF}"/>
              </a:ext>
            </a:extLst>
          </p:cNvPr>
          <p:cNvSpPr txBox="1"/>
          <p:nvPr/>
        </p:nvSpPr>
        <p:spPr>
          <a:xfrm>
            <a:off x="4218024" y="11869008"/>
            <a:ext cx="565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Palatino Linotype" panose="02040502050505030304" pitchFamily="18" charset="0"/>
              </a:rPr>
              <a:t>Set Size</a:t>
            </a:r>
          </a:p>
        </p:txBody>
      </p:sp>
      <p:sp>
        <p:nvSpPr>
          <p:cNvPr id="328" name="TextBox 327">
            <a:extLst>
              <a:ext uri="{FF2B5EF4-FFF2-40B4-BE49-F238E27FC236}">
                <a16:creationId xmlns:a16="http://schemas.microsoft.com/office/drawing/2014/main" id="{67FBE5AD-DD3F-421A-A99F-55B65364BC82}"/>
              </a:ext>
            </a:extLst>
          </p:cNvPr>
          <p:cNvSpPr txBox="1"/>
          <p:nvPr/>
        </p:nvSpPr>
        <p:spPr>
          <a:xfrm>
            <a:off x="84714" y="11744594"/>
            <a:ext cx="112707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4                2                0</a:t>
            </a:r>
          </a:p>
        </p:txBody>
      </p:sp>
      <p:sp>
        <p:nvSpPr>
          <p:cNvPr id="329" name="TextBox 328">
            <a:extLst>
              <a:ext uri="{FF2B5EF4-FFF2-40B4-BE49-F238E27FC236}">
                <a16:creationId xmlns:a16="http://schemas.microsoft.com/office/drawing/2014/main" id="{D247BD29-FA5C-42A3-9FD7-DAB2E4BBE860}"/>
              </a:ext>
            </a:extLst>
          </p:cNvPr>
          <p:cNvSpPr txBox="1"/>
          <p:nvPr/>
        </p:nvSpPr>
        <p:spPr>
          <a:xfrm rot="16200000">
            <a:off x="779114" y="9680458"/>
            <a:ext cx="8285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Frameshift</a:t>
            </a:r>
          </a:p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 Intersections</a:t>
            </a:r>
          </a:p>
        </p:txBody>
      </p:sp>
      <p:sp>
        <p:nvSpPr>
          <p:cNvPr id="330" name="TextBox 329">
            <a:extLst>
              <a:ext uri="{FF2B5EF4-FFF2-40B4-BE49-F238E27FC236}">
                <a16:creationId xmlns:a16="http://schemas.microsoft.com/office/drawing/2014/main" id="{D0E4AFC9-1253-4E52-B5BE-461929DAC80B}"/>
              </a:ext>
            </a:extLst>
          </p:cNvPr>
          <p:cNvSpPr txBox="1"/>
          <p:nvPr/>
        </p:nvSpPr>
        <p:spPr>
          <a:xfrm>
            <a:off x="1329279" y="9450557"/>
            <a:ext cx="205971" cy="8463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</a:t>
            </a:r>
          </a:p>
          <a:p>
            <a:endParaRPr lang="en-US" sz="700" b="1" dirty="0">
              <a:latin typeface="Palatino Linotype" panose="02040502050505030304" pitchFamily="18" charset="0"/>
            </a:endParaRPr>
          </a:p>
          <a:p>
            <a:endParaRPr lang="en-US" sz="700" b="1" dirty="0">
              <a:latin typeface="Palatino Linotype" panose="02040502050505030304" pitchFamily="18" charset="0"/>
            </a:endParaRPr>
          </a:p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  <a:p>
            <a:endParaRPr lang="en-US" sz="700" b="1" dirty="0">
              <a:latin typeface="Palatino Linotype" panose="02040502050505030304" pitchFamily="18" charset="0"/>
            </a:endParaRPr>
          </a:p>
          <a:p>
            <a:endParaRPr lang="en-US" sz="700" b="1" dirty="0">
              <a:latin typeface="Palatino Linotype" panose="02040502050505030304" pitchFamily="18" charset="0"/>
            </a:endParaRPr>
          </a:p>
          <a:p>
            <a:r>
              <a:rPr lang="en-US" sz="700" b="1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331" name="TextBox 330">
            <a:extLst>
              <a:ext uri="{FF2B5EF4-FFF2-40B4-BE49-F238E27FC236}">
                <a16:creationId xmlns:a16="http://schemas.microsoft.com/office/drawing/2014/main" id="{D349768B-6EAE-4F13-8E33-E777CAC7C952}"/>
              </a:ext>
            </a:extLst>
          </p:cNvPr>
          <p:cNvSpPr txBox="1"/>
          <p:nvPr/>
        </p:nvSpPr>
        <p:spPr>
          <a:xfrm rot="16200000">
            <a:off x="4411656" y="9684397"/>
            <a:ext cx="8285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Frameshift</a:t>
            </a:r>
          </a:p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 Intersections</a:t>
            </a:r>
          </a:p>
        </p:txBody>
      </p:sp>
      <p:sp>
        <p:nvSpPr>
          <p:cNvPr id="333" name="TextBox 332">
            <a:extLst>
              <a:ext uri="{FF2B5EF4-FFF2-40B4-BE49-F238E27FC236}">
                <a16:creationId xmlns:a16="http://schemas.microsoft.com/office/drawing/2014/main" id="{1E1FA5D2-A692-48BA-B12E-6F6F1B2B0BC3}"/>
              </a:ext>
            </a:extLst>
          </p:cNvPr>
          <p:cNvSpPr txBox="1"/>
          <p:nvPr/>
        </p:nvSpPr>
        <p:spPr>
          <a:xfrm>
            <a:off x="5117466" y="10115279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334" name="TextBox 333">
            <a:extLst>
              <a:ext uri="{FF2B5EF4-FFF2-40B4-BE49-F238E27FC236}">
                <a16:creationId xmlns:a16="http://schemas.microsoft.com/office/drawing/2014/main" id="{79B59DF0-9E1E-4A5C-B819-8D7A9BE74329}"/>
              </a:ext>
            </a:extLst>
          </p:cNvPr>
          <p:cNvSpPr txBox="1"/>
          <p:nvPr/>
        </p:nvSpPr>
        <p:spPr>
          <a:xfrm>
            <a:off x="5047467" y="9744005"/>
            <a:ext cx="32392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0.5</a:t>
            </a:r>
          </a:p>
        </p:txBody>
      </p:sp>
      <p:sp>
        <p:nvSpPr>
          <p:cNvPr id="335" name="TextBox 334">
            <a:extLst>
              <a:ext uri="{FF2B5EF4-FFF2-40B4-BE49-F238E27FC236}">
                <a16:creationId xmlns:a16="http://schemas.microsoft.com/office/drawing/2014/main" id="{049A189A-A8BE-4A3F-8CE1-00E95DD6BA1D}"/>
              </a:ext>
            </a:extLst>
          </p:cNvPr>
          <p:cNvSpPr txBox="1"/>
          <p:nvPr/>
        </p:nvSpPr>
        <p:spPr>
          <a:xfrm>
            <a:off x="5120380" y="9387918"/>
            <a:ext cx="32392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336" name="TextBox 335">
            <a:extLst>
              <a:ext uri="{FF2B5EF4-FFF2-40B4-BE49-F238E27FC236}">
                <a16:creationId xmlns:a16="http://schemas.microsoft.com/office/drawing/2014/main" id="{9565C452-1617-48F0-A83A-F5DB4743971B}"/>
              </a:ext>
            </a:extLst>
          </p:cNvPr>
          <p:cNvSpPr txBox="1"/>
          <p:nvPr/>
        </p:nvSpPr>
        <p:spPr>
          <a:xfrm>
            <a:off x="1586092" y="9673695"/>
            <a:ext cx="3313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337" name="TextBox 336">
            <a:extLst>
              <a:ext uri="{FF2B5EF4-FFF2-40B4-BE49-F238E27FC236}">
                <a16:creationId xmlns:a16="http://schemas.microsoft.com/office/drawing/2014/main" id="{765034B6-F80A-444E-B008-B5578516EF08}"/>
              </a:ext>
            </a:extLst>
          </p:cNvPr>
          <p:cNvSpPr txBox="1"/>
          <p:nvPr/>
        </p:nvSpPr>
        <p:spPr>
          <a:xfrm>
            <a:off x="1904991" y="9681408"/>
            <a:ext cx="3313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338" name="TextBox 337">
            <a:extLst>
              <a:ext uri="{FF2B5EF4-FFF2-40B4-BE49-F238E27FC236}">
                <a16:creationId xmlns:a16="http://schemas.microsoft.com/office/drawing/2014/main" id="{638C387A-98D5-439C-9BCF-B72A809D4C82}"/>
              </a:ext>
            </a:extLst>
          </p:cNvPr>
          <p:cNvSpPr txBox="1"/>
          <p:nvPr/>
        </p:nvSpPr>
        <p:spPr>
          <a:xfrm>
            <a:off x="2248455" y="9673695"/>
            <a:ext cx="3313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339" name="TextBox 338">
            <a:extLst>
              <a:ext uri="{FF2B5EF4-FFF2-40B4-BE49-F238E27FC236}">
                <a16:creationId xmlns:a16="http://schemas.microsoft.com/office/drawing/2014/main" id="{044BE8C5-680D-4DD5-8867-AC6F0F197985}"/>
              </a:ext>
            </a:extLst>
          </p:cNvPr>
          <p:cNvSpPr txBox="1"/>
          <p:nvPr/>
        </p:nvSpPr>
        <p:spPr>
          <a:xfrm>
            <a:off x="2574067" y="9681408"/>
            <a:ext cx="3313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340" name="TextBox 339">
            <a:extLst>
              <a:ext uri="{FF2B5EF4-FFF2-40B4-BE49-F238E27FC236}">
                <a16:creationId xmlns:a16="http://schemas.microsoft.com/office/drawing/2014/main" id="{A97B825D-77CB-4A54-BA8B-DE1F3E29A8E0}"/>
              </a:ext>
            </a:extLst>
          </p:cNvPr>
          <p:cNvSpPr txBox="1"/>
          <p:nvPr/>
        </p:nvSpPr>
        <p:spPr>
          <a:xfrm>
            <a:off x="2937082" y="9357518"/>
            <a:ext cx="3313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</a:t>
            </a:r>
          </a:p>
        </p:txBody>
      </p:sp>
      <p:sp>
        <p:nvSpPr>
          <p:cNvPr id="341" name="TextBox 340">
            <a:extLst>
              <a:ext uri="{FF2B5EF4-FFF2-40B4-BE49-F238E27FC236}">
                <a16:creationId xmlns:a16="http://schemas.microsoft.com/office/drawing/2014/main" id="{41F99716-9C73-4E7D-A608-FA0958E8091B}"/>
              </a:ext>
            </a:extLst>
          </p:cNvPr>
          <p:cNvSpPr txBox="1"/>
          <p:nvPr/>
        </p:nvSpPr>
        <p:spPr>
          <a:xfrm>
            <a:off x="5587928" y="9328899"/>
            <a:ext cx="3313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342" name="TextBox 341">
            <a:extLst>
              <a:ext uri="{FF2B5EF4-FFF2-40B4-BE49-F238E27FC236}">
                <a16:creationId xmlns:a16="http://schemas.microsoft.com/office/drawing/2014/main" id="{8BADEFA8-B360-43FC-8C88-78C1FF727297}"/>
              </a:ext>
            </a:extLst>
          </p:cNvPr>
          <p:cNvSpPr txBox="1"/>
          <p:nvPr/>
        </p:nvSpPr>
        <p:spPr>
          <a:xfrm>
            <a:off x="6362508" y="9322580"/>
            <a:ext cx="3313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103C6B36-4F51-4448-AC3E-C02CA1E0D44D}"/>
              </a:ext>
            </a:extLst>
          </p:cNvPr>
          <p:cNvSpPr txBox="1"/>
          <p:nvPr/>
        </p:nvSpPr>
        <p:spPr>
          <a:xfrm>
            <a:off x="56176" y="-13173"/>
            <a:ext cx="11089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Palatino Linotype" panose="02040502050505030304" pitchFamily="18" charset="0"/>
              </a:rPr>
              <a:t>Fig. S11</a:t>
            </a:r>
          </a:p>
        </p:txBody>
      </p:sp>
    </p:spTree>
    <p:extLst>
      <p:ext uri="{BB962C8B-B14F-4D97-AF65-F5344CB8AC3E}">
        <p14:creationId xmlns:p14="http://schemas.microsoft.com/office/powerpoint/2010/main" val="229432219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iagram&#10;&#10;Description automatically generated">
            <a:extLst>
              <a:ext uri="{FF2B5EF4-FFF2-40B4-BE49-F238E27FC236}">
                <a16:creationId xmlns:a16="http://schemas.microsoft.com/office/drawing/2014/main" id="{6AF3349F-A160-46D8-88CB-3DBF811F59A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33853"/>
            <a:ext cx="6858000" cy="10539270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137E472D-8E1A-4624-9D4B-7CAD69F51735}"/>
              </a:ext>
            </a:extLst>
          </p:cNvPr>
          <p:cNvGrpSpPr/>
          <p:nvPr/>
        </p:nvGrpSpPr>
        <p:grpSpPr>
          <a:xfrm>
            <a:off x="93676" y="1133908"/>
            <a:ext cx="6783857" cy="10513488"/>
            <a:chOff x="61859" y="500955"/>
            <a:chExt cx="6783857" cy="10513488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86029D0-2E70-41F4-9DBA-983950BF34E4}"/>
                </a:ext>
              </a:extLst>
            </p:cNvPr>
            <p:cNvSpPr txBox="1"/>
            <p:nvPr/>
          </p:nvSpPr>
          <p:spPr>
            <a:xfrm>
              <a:off x="763967" y="1356806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72-P0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E136008-6E9E-40DF-AEBD-D07006A9C8FF}"/>
                </a:ext>
              </a:extLst>
            </p:cNvPr>
            <p:cNvSpPr txBox="1"/>
            <p:nvPr/>
          </p:nvSpPr>
          <p:spPr>
            <a:xfrm>
              <a:off x="763967" y="1829929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72-P1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19FC0FE-0054-4A68-A240-03C60C4C3ED8}"/>
                </a:ext>
              </a:extLst>
            </p:cNvPr>
            <p:cNvSpPr txBox="1"/>
            <p:nvPr/>
          </p:nvSpPr>
          <p:spPr>
            <a:xfrm>
              <a:off x="763967" y="2303052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72-P2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637CA1B-CAE4-4B07-B346-625056A1F002}"/>
                </a:ext>
              </a:extLst>
            </p:cNvPr>
            <p:cNvSpPr txBox="1"/>
            <p:nvPr/>
          </p:nvSpPr>
          <p:spPr>
            <a:xfrm>
              <a:off x="797535" y="3990559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87-P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750161E-29AB-48F2-8D71-19376519EB53}"/>
                </a:ext>
              </a:extLst>
            </p:cNvPr>
            <p:cNvSpPr txBox="1"/>
            <p:nvPr/>
          </p:nvSpPr>
          <p:spPr>
            <a:xfrm>
              <a:off x="797535" y="4338069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87-P1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475A54A-A46B-448B-8AC1-5F991D3B5C5D}"/>
                </a:ext>
              </a:extLst>
            </p:cNvPr>
            <p:cNvSpPr txBox="1"/>
            <p:nvPr/>
          </p:nvSpPr>
          <p:spPr>
            <a:xfrm>
              <a:off x="793063" y="4652171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87-P2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C819B716-7CB2-4B0F-8C41-C3809CC974EB}"/>
                </a:ext>
              </a:extLst>
            </p:cNvPr>
            <p:cNvSpPr txBox="1"/>
            <p:nvPr/>
          </p:nvSpPr>
          <p:spPr>
            <a:xfrm>
              <a:off x="793063" y="4975225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87-P3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886B7034-2DFF-4020-8706-69C028F909D7}"/>
                </a:ext>
              </a:extLst>
            </p:cNvPr>
            <p:cNvSpPr txBox="1"/>
            <p:nvPr/>
          </p:nvSpPr>
          <p:spPr>
            <a:xfrm>
              <a:off x="241707" y="5414568"/>
              <a:ext cx="56519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Palatino Linotype" panose="02040502050505030304" pitchFamily="18" charset="0"/>
                </a:rPr>
                <a:t>Set Size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672EE8D-AC86-4116-9603-A4E41398BB9E}"/>
                </a:ext>
              </a:extLst>
            </p:cNvPr>
            <p:cNvSpPr txBox="1"/>
            <p:nvPr/>
          </p:nvSpPr>
          <p:spPr>
            <a:xfrm>
              <a:off x="667412" y="5052611"/>
              <a:ext cx="1091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0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817F094-0AA0-4A98-9EE6-8CBB23B66E92}"/>
                </a:ext>
              </a:extLst>
            </p:cNvPr>
            <p:cNvSpPr txBox="1"/>
            <p:nvPr/>
          </p:nvSpPr>
          <p:spPr>
            <a:xfrm>
              <a:off x="271941" y="5057635"/>
              <a:ext cx="4004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1000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80F32EDA-EFD7-473B-9E12-6C9F472E9A14}"/>
                </a:ext>
              </a:extLst>
            </p:cNvPr>
            <p:cNvSpPr txBox="1"/>
            <p:nvPr/>
          </p:nvSpPr>
          <p:spPr>
            <a:xfrm>
              <a:off x="3710134" y="5498126"/>
              <a:ext cx="56519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Palatino Linotype" panose="02040502050505030304" pitchFamily="18" charset="0"/>
                </a:rPr>
                <a:t>Set Size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896BBF0-C002-4B3E-B3E5-0B8109A665AA}"/>
                </a:ext>
              </a:extLst>
            </p:cNvPr>
            <p:cNvSpPr txBox="1"/>
            <p:nvPr/>
          </p:nvSpPr>
          <p:spPr>
            <a:xfrm>
              <a:off x="4200615" y="5275309"/>
              <a:ext cx="1091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0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2197002-F3F5-45F5-815F-B5DC4DD6A07F}"/>
                </a:ext>
              </a:extLst>
            </p:cNvPr>
            <p:cNvSpPr txBox="1"/>
            <p:nvPr/>
          </p:nvSpPr>
          <p:spPr>
            <a:xfrm>
              <a:off x="3843785" y="5057635"/>
              <a:ext cx="4004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1000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14450B6-F4CB-429B-83B0-F896535781EF}"/>
                </a:ext>
              </a:extLst>
            </p:cNvPr>
            <p:cNvSpPr txBox="1"/>
            <p:nvPr/>
          </p:nvSpPr>
          <p:spPr>
            <a:xfrm>
              <a:off x="252944" y="10798999"/>
              <a:ext cx="56519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Palatino Linotype" panose="02040502050505030304" pitchFamily="18" charset="0"/>
                </a:rPr>
                <a:t>Set Size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423433E-B4B9-4E8C-B978-DBF66BBF6EF8}"/>
                </a:ext>
              </a:extLst>
            </p:cNvPr>
            <p:cNvSpPr txBox="1"/>
            <p:nvPr/>
          </p:nvSpPr>
          <p:spPr>
            <a:xfrm>
              <a:off x="168395" y="2730086"/>
              <a:ext cx="56519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Palatino Linotype" panose="02040502050505030304" pitchFamily="18" charset="0"/>
                </a:rPr>
                <a:t>Set Size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B5F671A-A729-4CA5-8970-F719F2F90F39}"/>
                </a:ext>
              </a:extLst>
            </p:cNvPr>
            <p:cNvSpPr txBox="1"/>
            <p:nvPr/>
          </p:nvSpPr>
          <p:spPr>
            <a:xfrm>
              <a:off x="751348" y="2573159"/>
              <a:ext cx="1091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0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A2A31C0-FE1F-42D9-B6C7-6B8222062E8B}"/>
                </a:ext>
              </a:extLst>
            </p:cNvPr>
            <p:cNvSpPr txBox="1"/>
            <p:nvPr/>
          </p:nvSpPr>
          <p:spPr>
            <a:xfrm>
              <a:off x="61859" y="2568266"/>
              <a:ext cx="27515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20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25AD2D2-63EE-466E-B40C-7F3A19DEAC0F}"/>
                </a:ext>
              </a:extLst>
            </p:cNvPr>
            <p:cNvSpPr txBox="1"/>
            <p:nvPr/>
          </p:nvSpPr>
          <p:spPr>
            <a:xfrm>
              <a:off x="3710134" y="2632991"/>
              <a:ext cx="56519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Palatino Linotype" panose="02040502050505030304" pitchFamily="18" charset="0"/>
                </a:rPr>
                <a:t>Set Size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37F444C-C2A7-4A16-B67C-704526141E6C}"/>
                </a:ext>
              </a:extLst>
            </p:cNvPr>
            <p:cNvSpPr txBox="1"/>
            <p:nvPr/>
          </p:nvSpPr>
          <p:spPr>
            <a:xfrm>
              <a:off x="4212905" y="3944419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96-P0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DBBD78D-33F4-4FDD-BD15-DD789432463F}"/>
                </a:ext>
              </a:extLst>
            </p:cNvPr>
            <p:cNvSpPr txBox="1"/>
            <p:nvPr/>
          </p:nvSpPr>
          <p:spPr>
            <a:xfrm>
              <a:off x="4212905" y="4320725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96-P1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0EFEFA3-C025-4A05-99CB-C6F89492451F}"/>
                </a:ext>
              </a:extLst>
            </p:cNvPr>
            <p:cNvSpPr txBox="1"/>
            <p:nvPr/>
          </p:nvSpPr>
          <p:spPr>
            <a:xfrm>
              <a:off x="4197850" y="4691989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96-P2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F81E089D-E4C7-4289-AB2D-5394C4E43709}"/>
                </a:ext>
              </a:extLst>
            </p:cNvPr>
            <p:cNvSpPr txBox="1"/>
            <p:nvPr/>
          </p:nvSpPr>
          <p:spPr>
            <a:xfrm>
              <a:off x="4205986" y="5068554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96-P3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1015E45B-A995-469B-BBCD-DB7EF8ACA783}"/>
                </a:ext>
              </a:extLst>
            </p:cNvPr>
            <p:cNvSpPr txBox="1"/>
            <p:nvPr/>
          </p:nvSpPr>
          <p:spPr>
            <a:xfrm>
              <a:off x="724634" y="6735211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74-P0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EBBBF69B-5B41-4E16-8AEF-70159C9D2E93}"/>
                </a:ext>
              </a:extLst>
            </p:cNvPr>
            <p:cNvSpPr txBox="1"/>
            <p:nvPr/>
          </p:nvSpPr>
          <p:spPr>
            <a:xfrm>
              <a:off x="733589" y="7144303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74-P1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BD063A10-F1FE-4631-A63C-AD0B655C2921}"/>
                </a:ext>
              </a:extLst>
            </p:cNvPr>
            <p:cNvSpPr txBox="1"/>
            <p:nvPr/>
          </p:nvSpPr>
          <p:spPr>
            <a:xfrm>
              <a:off x="725427" y="7553395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74-P2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652E8EFE-A3AD-41B8-A1EB-8133A1B335A5}"/>
                </a:ext>
              </a:extLst>
            </p:cNvPr>
            <p:cNvSpPr txBox="1"/>
            <p:nvPr/>
          </p:nvSpPr>
          <p:spPr>
            <a:xfrm>
              <a:off x="4234868" y="6569705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98-P0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519ECD19-C959-4FE0-AF56-511C26E3E3EA}"/>
                </a:ext>
              </a:extLst>
            </p:cNvPr>
            <p:cNvSpPr txBox="1"/>
            <p:nvPr/>
          </p:nvSpPr>
          <p:spPr>
            <a:xfrm>
              <a:off x="4234868" y="6922389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98-P1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2D5B1BA2-730A-4B97-85C4-6D89DB84A1F2}"/>
                </a:ext>
              </a:extLst>
            </p:cNvPr>
            <p:cNvSpPr txBox="1"/>
            <p:nvPr/>
          </p:nvSpPr>
          <p:spPr>
            <a:xfrm>
              <a:off x="4240531" y="7293630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98-P2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B1E0BEB8-5757-466E-A674-98CE22FEFBA7}"/>
                </a:ext>
              </a:extLst>
            </p:cNvPr>
            <p:cNvSpPr txBox="1"/>
            <p:nvPr/>
          </p:nvSpPr>
          <p:spPr>
            <a:xfrm>
              <a:off x="4234868" y="7682153"/>
              <a:ext cx="5936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50" b="1" dirty="0">
                  <a:latin typeface="Palatino Linotype" panose="02040502050505030304" pitchFamily="18" charset="0"/>
                </a:rPr>
                <a:t>HT98-P3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6BD4EA46-93A7-4072-BEE3-BB2EEAC2D547}"/>
                </a:ext>
              </a:extLst>
            </p:cNvPr>
            <p:cNvSpPr txBox="1"/>
            <p:nvPr/>
          </p:nvSpPr>
          <p:spPr>
            <a:xfrm>
              <a:off x="782817" y="9323873"/>
              <a:ext cx="6606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50" b="1" dirty="0">
                  <a:latin typeface="Palatino Linotype" panose="02040502050505030304" pitchFamily="18" charset="0"/>
                </a:rPr>
                <a:t>HT120-P0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EF62C600-78A1-4D27-945D-3832F48DD365}"/>
                </a:ext>
              </a:extLst>
            </p:cNvPr>
            <p:cNvSpPr txBox="1"/>
            <p:nvPr/>
          </p:nvSpPr>
          <p:spPr>
            <a:xfrm>
              <a:off x="766199" y="9693349"/>
              <a:ext cx="6606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50" b="1" dirty="0">
                  <a:latin typeface="Palatino Linotype" panose="02040502050505030304" pitchFamily="18" charset="0"/>
                </a:rPr>
                <a:t>HT120-P1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0844C9A6-0CB1-403C-921B-ACD666E41F1C}"/>
                </a:ext>
              </a:extLst>
            </p:cNvPr>
            <p:cNvSpPr txBox="1"/>
            <p:nvPr/>
          </p:nvSpPr>
          <p:spPr>
            <a:xfrm>
              <a:off x="763967" y="10041190"/>
              <a:ext cx="6606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50" b="1" dirty="0">
                  <a:latin typeface="Palatino Linotype" panose="02040502050505030304" pitchFamily="18" charset="0"/>
                </a:rPr>
                <a:t>HT120-P2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C7D6BC59-9D8F-429D-A900-EC88E5FDFE50}"/>
                </a:ext>
              </a:extLst>
            </p:cNvPr>
            <p:cNvSpPr txBox="1"/>
            <p:nvPr/>
          </p:nvSpPr>
          <p:spPr>
            <a:xfrm>
              <a:off x="772859" y="10372228"/>
              <a:ext cx="6606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50" b="1" dirty="0">
                  <a:latin typeface="Palatino Linotype" panose="02040502050505030304" pitchFamily="18" charset="0"/>
                </a:rPr>
                <a:t>HT120-P3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F9268B35-7225-4465-856F-73F07CB22C21}"/>
                </a:ext>
              </a:extLst>
            </p:cNvPr>
            <p:cNvSpPr txBox="1"/>
            <p:nvPr/>
          </p:nvSpPr>
          <p:spPr>
            <a:xfrm>
              <a:off x="4237124" y="9328010"/>
              <a:ext cx="6606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50" b="1" dirty="0">
                  <a:latin typeface="Palatino Linotype" panose="02040502050505030304" pitchFamily="18" charset="0"/>
                </a:rPr>
                <a:t>HT139-P0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24FE7080-19A7-44C8-A163-44062E60FA64}"/>
                </a:ext>
              </a:extLst>
            </p:cNvPr>
            <p:cNvSpPr txBox="1"/>
            <p:nvPr/>
          </p:nvSpPr>
          <p:spPr>
            <a:xfrm>
              <a:off x="4249991" y="9639278"/>
              <a:ext cx="6606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50" b="1" dirty="0">
                  <a:latin typeface="Palatino Linotype" panose="02040502050505030304" pitchFamily="18" charset="0"/>
                </a:rPr>
                <a:t>HT139-P1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ACF88604-6C41-4BAE-B6F6-CBBCE28BDDB0}"/>
                </a:ext>
              </a:extLst>
            </p:cNvPr>
            <p:cNvSpPr txBox="1"/>
            <p:nvPr/>
          </p:nvSpPr>
          <p:spPr>
            <a:xfrm>
              <a:off x="4256121" y="9991197"/>
              <a:ext cx="6606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50" b="1" dirty="0">
                  <a:latin typeface="Palatino Linotype" panose="02040502050505030304" pitchFamily="18" charset="0"/>
                </a:rPr>
                <a:t>HT139-P2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2C9B483C-C367-431F-84F1-A3FB39C1E320}"/>
                </a:ext>
              </a:extLst>
            </p:cNvPr>
            <p:cNvSpPr txBox="1"/>
            <p:nvPr/>
          </p:nvSpPr>
          <p:spPr>
            <a:xfrm>
              <a:off x="4236411" y="10332736"/>
              <a:ext cx="66065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50" b="1" dirty="0">
                  <a:latin typeface="Palatino Linotype" panose="02040502050505030304" pitchFamily="18" charset="0"/>
                </a:rPr>
                <a:t>HT139-P3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25361B8E-56A1-4B5F-8F2C-484C391D687F}"/>
                </a:ext>
              </a:extLst>
            </p:cNvPr>
            <p:cNvSpPr txBox="1"/>
            <p:nvPr/>
          </p:nvSpPr>
          <p:spPr>
            <a:xfrm>
              <a:off x="1101754" y="3796908"/>
              <a:ext cx="20597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0</a:t>
              </a:r>
            </a:p>
          </p:txBody>
        </p:sp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B0093E98-9071-4CD6-B244-A33B387D8F9E}"/>
                </a:ext>
              </a:extLst>
            </p:cNvPr>
            <p:cNvGrpSpPr/>
            <p:nvPr/>
          </p:nvGrpSpPr>
          <p:grpSpPr>
            <a:xfrm>
              <a:off x="4657313" y="3493204"/>
              <a:ext cx="304139" cy="420714"/>
              <a:chOff x="2348882" y="8087435"/>
              <a:chExt cx="304139" cy="420714"/>
            </a:xfrm>
          </p:grpSpPr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F67720AE-0BD3-470F-8AEA-FFA2676215D8}"/>
                  </a:ext>
                </a:extLst>
              </p:cNvPr>
              <p:cNvSpPr txBox="1"/>
              <p:nvPr/>
            </p:nvSpPr>
            <p:spPr>
              <a:xfrm>
                <a:off x="2404780" y="8087435"/>
                <a:ext cx="24824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latin typeface="Palatino Linotype" panose="02040502050505030304" pitchFamily="18" charset="0"/>
                  </a:rPr>
                  <a:t>2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E531AF5D-ECB0-476F-A1F6-BEA643C0A427}"/>
                  </a:ext>
                </a:extLst>
              </p:cNvPr>
              <p:cNvSpPr txBox="1"/>
              <p:nvPr/>
            </p:nvSpPr>
            <p:spPr>
              <a:xfrm>
                <a:off x="2348882" y="8308094"/>
                <a:ext cx="20597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latin typeface="Palatino Linotype" panose="02040502050505030304" pitchFamily="18" charset="0"/>
                  </a:rPr>
                  <a:t>0</a:t>
                </a:r>
              </a:p>
            </p:txBody>
          </p:sp>
        </p:grpSp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87B87C64-B389-4164-B90E-EA647F971B9D}"/>
                </a:ext>
              </a:extLst>
            </p:cNvPr>
            <p:cNvGrpSpPr/>
            <p:nvPr/>
          </p:nvGrpSpPr>
          <p:grpSpPr>
            <a:xfrm>
              <a:off x="751348" y="509276"/>
              <a:ext cx="603317" cy="868628"/>
              <a:chOff x="2034010" y="7635809"/>
              <a:chExt cx="603317" cy="868628"/>
            </a:xfrm>
          </p:grpSpPr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4A5B847A-7C89-41B0-A74D-02750E626436}"/>
                  </a:ext>
                </a:extLst>
              </p:cNvPr>
              <p:cNvSpPr txBox="1"/>
              <p:nvPr/>
            </p:nvSpPr>
            <p:spPr>
              <a:xfrm rot="16200000">
                <a:off x="1789007" y="7880812"/>
                <a:ext cx="82856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Palatino Linotype" panose="02040502050505030304" pitchFamily="18" charset="0"/>
                  </a:rPr>
                  <a:t>Missense</a:t>
                </a:r>
              </a:p>
              <a:p>
                <a:pPr algn="ctr"/>
                <a:r>
                  <a:rPr lang="en-US" sz="800" b="1" dirty="0">
                    <a:latin typeface="Palatino Linotype" panose="02040502050505030304" pitchFamily="18" charset="0"/>
                  </a:rPr>
                  <a:t> Intersections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9522FF92-D662-4F9B-998B-8DB4A9237092}"/>
                  </a:ext>
                </a:extLst>
              </p:cNvPr>
              <p:cNvSpPr txBox="1"/>
              <p:nvPr/>
            </p:nvSpPr>
            <p:spPr>
              <a:xfrm>
                <a:off x="2298773" y="7701217"/>
                <a:ext cx="33855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latin typeface="Palatino Linotype" panose="02040502050505030304" pitchFamily="18" charset="0"/>
                  </a:rPr>
                  <a:t>15</a:t>
                </a: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6CF1FE92-A09F-4233-8299-4AD6D4D9A6C7}"/>
                  </a:ext>
                </a:extLst>
              </p:cNvPr>
              <p:cNvSpPr txBox="1"/>
              <p:nvPr/>
            </p:nvSpPr>
            <p:spPr>
              <a:xfrm>
                <a:off x="2335258" y="8304382"/>
                <a:ext cx="20597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b="1" dirty="0">
                    <a:latin typeface="Palatino Linotype" panose="02040502050505030304" pitchFamily="18" charset="0"/>
                  </a:rPr>
                  <a:t>0</a:t>
                </a:r>
              </a:p>
            </p:txBody>
          </p:sp>
        </p:grp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ACFF2C36-F2CA-4B3F-BB17-4DD4ED9E4024}"/>
                </a:ext>
              </a:extLst>
            </p:cNvPr>
            <p:cNvSpPr txBox="1"/>
            <p:nvPr/>
          </p:nvSpPr>
          <p:spPr>
            <a:xfrm>
              <a:off x="1311478" y="1011546"/>
              <a:ext cx="33131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2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79D95276-7CDE-4D64-ABBE-D90DCDB57A83}"/>
                </a:ext>
              </a:extLst>
            </p:cNvPr>
            <p:cNvSpPr txBox="1"/>
            <p:nvPr/>
          </p:nvSpPr>
          <p:spPr>
            <a:xfrm>
              <a:off x="2082963" y="1044454"/>
              <a:ext cx="33131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2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FA7972B7-B6D7-4CB4-8161-58A86430308D}"/>
                </a:ext>
              </a:extLst>
            </p:cNvPr>
            <p:cNvSpPr txBox="1"/>
            <p:nvPr/>
          </p:nvSpPr>
          <p:spPr>
            <a:xfrm>
              <a:off x="2807391" y="500955"/>
              <a:ext cx="30201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15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205322CA-638C-487D-8947-AA0528D6CFB0}"/>
                </a:ext>
              </a:extLst>
            </p:cNvPr>
            <p:cNvSpPr txBox="1"/>
            <p:nvPr/>
          </p:nvSpPr>
          <p:spPr>
            <a:xfrm>
              <a:off x="2590657" y="6261545"/>
              <a:ext cx="30201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8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67806E14-5073-47AB-AD2C-BCBED004D340}"/>
                </a:ext>
              </a:extLst>
            </p:cNvPr>
            <p:cNvSpPr txBox="1"/>
            <p:nvPr/>
          </p:nvSpPr>
          <p:spPr>
            <a:xfrm>
              <a:off x="2675352" y="6061490"/>
              <a:ext cx="4918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3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0127EAF2-65F8-4F6C-B17A-9B86F8D60E22}"/>
                </a:ext>
              </a:extLst>
            </p:cNvPr>
            <p:cNvSpPr txBox="1"/>
            <p:nvPr/>
          </p:nvSpPr>
          <p:spPr>
            <a:xfrm>
              <a:off x="5950647" y="923555"/>
              <a:ext cx="37844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2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304158EA-7D6D-4758-BCEE-76A5E72B9BA2}"/>
                </a:ext>
              </a:extLst>
            </p:cNvPr>
            <p:cNvSpPr txBox="1"/>
            <p:nvPr/>
          </p:nvSpPr>
          <p:spPr>
            <a:xfrm>
              <a:off x="1268149" y="3337692"/>
              <a:ext cx="25289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5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5C4065A-37D1-4A28-AB41-3B214F039BBC}"/>
                </a:ext>
              </a:extLst>
            </p:cNvPr>
            <p:cNvSpPr txBox="1"/>
            <p:nvPr/>
          </p:nvSpPr>
          <p:spPr>
            <a:xfrm>
              <a:off x="3035078" y="3115783"/>
              <a:ext cx="40042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6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EDD587A7-9956-4763-B4FB-20DCB1FC8217}"/>
                </a:ext>
              </a:extLst>
            </p:cNvPr>
            <p:cNvSpPr txBox="1"/>
            <p:nvPr/>
          </p:nvSpPr>
          <p:spPr>
            <a:xfrm>
              <a:off x="6259096" y="3614860"/>
              <a:ext cx="32096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1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5CCC4A99-EE1F-4045-B6F5-D166BAF099B5}"/>
                </a:ext>
              </a:extLst>
            </p:cNvPr>
            <p:cNvSpPr txBox="1"/>
            <p:nvPr/>
          </p:nvSpPr>
          <p:spPr>
            <a:xfrm>
              <a:off x="6524753" y="3293149"/>
              <a:ext cx="32096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Palatino Linotype" panose="02040502050505030304" pitchFamily="18" charset="0"/>
                </a:rPr>
                <a:t>4</a:t>
              </a:r>
            </a:p>
          </p:txBody>
        </p:sp>
      </p:grpSp>
      <p:sp>
        <p:nvSpPr>
          <p:cNvPr id="68" name="TextBox 67">
            <a:extLst>
              <a:ext uri="{FF2B5EF4-FFF2-40B4-BE49-F238E27FC236}">
                <a16:creationId xmlns:a16="http://schemas.microsoft.com/office/drawing/2014/main" id="{8120ED6F-D876-42B2-B11D-F5DAF7042AC9}"/>
              </a:ext>
            </a:extLst>
          </p:cNvPr>
          <p:cNvSpPr txBox="1"/>
          <p:nvPr/>
        </p:nvSpPr>
        <p:spPr>
          <a:xfrm>
            <a:off x="1044099" y="1407913"/>
            <a:ext cx="3385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0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EF898F5E-BA4C-4C27-AF63-900A644699DF}"/>
              </a:ext>
            </a:extLst>
          </p:cNvPr>
          <p:cNvSpPr txBox="1"/>
          <p:nvPr/>
        </p:nvSpPr>
        <p:spPr>
          <a:xfrm>
            <a:off x="1090390" y="1608310"/>
            <a:ext cx="3385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5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3277699-06E8-4BF9-B863-C3B85B991C35}"/>
              </a:ext>
            </a:extLst>
          </p:cNvPr>
          <p:cNvSpPr txBox="1"/>
          <p:nvPr/>
        </p:nvSpPr>
        <p:spPr>
          <a:xfrm>
            <a:off x="2471528" y="1708337"/>
            <a:ext cx="3385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F991D820-DD30-4CE5-9112-230FB99D1F50}"/>
              </a:ext>
            </a:extLst>
          </p:cNvPr>
          <p:cNvSpPr txBox="1"/>
          <p:nvPr/>
        </p:nvSpPr>
        <p:spPr>
          <a:xfrm>
            <a:off x="1722954" y="1708336"/>
            <a:ext cx="3313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5D06D5A4-4A83-466E-A1F5-F9933C85A344}"/>
              </a:ext>
            </a:extLst>
          </p:cNvPr>
          <p:cNvSpPr txBox="1"/>
          <p:nvPr/>
        </p:nvSpPr>
        <p:spPr>
          <a:xfrm>
            <a:off x="4249773" y="3169097"/>
            <a:ext cx="1091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76A1BB30-B58B-4265-AF24-C1A6DE080F3E}"/>
              </a:ext>
            </a:extLst>
          </p:cNvPr>
          <p:cNvSpPr txBox="1"/>
          <p:nvPr/>
        </p:nvSpPr>
        <p:spPr>
          <a:xfrm>
            <a:off x="3513731" y="3172034"/>
            <a:ext cx="2751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8BC3E229-718A-46A8-900C-262510499BFC}"/>
              </a:ext>
            </a:extLst>
          </p:cNvPr>
          <p:cNvSpPr txBox="1"/>
          <p:nvPr/>
        </p:nvSpPr>
        <p:spPr>
          <a:xfrm>
            <a:off x="4271073" y="1910829"/>
            <a:ext cx="5936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b="1" dirty="0">
                <a:latin typeface="Palatino Linotype" panose="02040502050505030304" pitchFamily="18" charset="0"/>
              </a:rPr>
              <a:t>HT77-P0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EEFE3305-BA0A-4891-B449-46CE31AF9E27}"/>
              </a:ext>
            </a:extLst>
          </p:cNvPr>
          <p:cNvSpPr txBox="1"/>
          <p:nvPr/>
        </p:nvSpPr>
        <p:spPr>
          <a:xfrm>
            <a:off x="4271073" y="2234664"/>
            <a:ext cx="593678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b="1" dirty="0">
                <a:latin typeface="Palatino Linotype" panose="02040502050505030304" pitchFamily="18" charset="0"/>
              </a:rPr>
              <a:t>HT77-P1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EA23105E-228C-4962-8427-ADC156C4FE85}"/>
              </a:ext>
            </a:extLst>
          </p:cNvPr>
          <p:cNvSpPr txBox="1"/>
          <p:nvPr/>
        </p:nvSpPr>
        <p:spPr>
          <a:xfrm>
            <a:off x="4287009" y="2570486"/>
            <a:ext cx="593678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b="1" dirty="0">
                <a:latin typeface="Palatino Linotype" panose="02040502050505030304" pitchFamily="18" charset="0"/>
              </a:rPr>
              <a:t>HT77-P2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E9FEE871-B8A7-4CB0-A926-61BC403A866E}"/>
              </a:ext>
            </a:extLst>
          </p:cNvPr>
          <p:cNvSpPr txBox="1"/>
          <p:nvPr/>
        </p:nvSpPr>
        <p:spPr>
          <a:xfrm>
            <a:off x="4272685" y="2934032"/>
            <a:ext cx="593678" cy="2077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50" b="1" dirty="0">
                <a:latin typeface="Palatino Linotype" panose="02040502050505030304" pitchFamily="18" charset="0"/>
              </a:rPr>
              <a:t>HT77-P3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F5B925FB-2E15-49FA-80B1-F8DDF2566C06}"/>
              </a:ext>
            </a:extLst>
          </p:cNvPr>
          <p:cNvSpPr txBox="1"/>
          <p:nvPr/>
        </p:nvSpPr>
        <p:spPr>
          <a:xfrm>
            <a:off x="4542331" y="1107609"/>
            <a:ext cx="3385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5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0846D031-A366-4A2C-8B37-B24CEA3636FC}"/>
              </a:ext>
            </a:extLst>
          </p:cNvPr>
          <p:cNvSpPr txBox="1"/>
          <p:nvPr/>
        </p:nvSpPr>
        <p:spPr>
          <a:xfrm>
            <a:off x="4547863" y="1311044"/>
            <a:ext cx="3385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C52550D2-6AFC-42E3-A69B-73C94120ED23}"/>
              </a:ext>
            </a:extLst>
          </p:cNvPr>
          <p:cNvSpPr txBox="1"/>
          <p:nvPr/>
        </p:nvSpPr>
        <p:spPr>
          <a:xfrm>
            <a:off x="4590325" y="1504915"/>
            <a:ext cx="3385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5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03E4F000-B5BB-4008-A3FE-5D7C175E0555}"/>
              </a:ext>
            </a:extLst>
          </p:cNvPr>
          <p:cNvSpPr txBox="1"/>
          <p:nvPr/>
        </p:nvSpPr>
        <p:spPr>
          <a:xfrm>
            <a:off x="4599267" y="1691962"/>
            <a:ext cx="3385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4EB7D82C-3177-41A2-81F3-E552E1AB00A9}"/>
              </a:ext>
            </a:extLst>
          </p:cNvPr>
          <p:cNvSpPr txBox="1"/>
          <p:nvPr/>
        </p:nvSpPr>
        <p:spPr>
          <a:xfrm rot="16200000">
            <a:off x="4051881" y="1300396"/>
            <a:ext cx="8285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Missense</a:t>
            </a:r>
          </a:p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 Intersections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5A4F6381-EE75-4A71-A1E8-FD6783CC7083}"/>
              </a:ext>
            </a:extLst>
          </p:cNvPr>
          <p:cNvSpPr txBox="1"/>
          <p:nvPr/>
        </p:nvSpPr>
        <p:spPr>
          <a:xfrm>
            <a:off x="4813567" y="1594519"/>
            <a:ext cx="3313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768C6F0F-9097-4D08-B04E-1B476A1F1097}"/>
              </a:ext>
            </a:extLst>
          </p:cNvPr>
          <p:cNvSpPr txBox="1"/>
          <p:nvPr/>
        </p:nvSpPr>
        <p:spPr>
          <a:xfrm>
            <a:off x="5107008" y="1602955"/>
            <a:ext cx="3313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306E2C3F-2857-4E2D-BEFF-66C304F58DE3}"/>
              </a:ext>
            </a:extLst>
          </p:cNvPr>
          <p:cNvSpPr txBox="1"/>
          <p:nvPr/>
        </p:nvSpPr>
        <p:spPr>
          <a:xfrm>
            <a:off x="5405965" y="1604213"/>
            <a:ext cx="3313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E5521BB2-3EF1-434F-934B-018FB1B23BFC}"/>
              </a:ext>
            </a:extLst>
          </p:cNvPr>
          <p:cNvSpPr txBox="1"/>
          <p:nvPr/>
        </p:nvSpPr>
        <p:spPr>
          <a:xfrm>
            <a:off x="5678022" y="1610747"/>
            <a:ext cx="3313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50F89488-57F5-42D5-8210-0557C5C21C0C}"/>
              </a:ext>
            </a:extLst>
          </p:cNvPr>
          <p:cNvSpPr txBox="1"/>
          <p:nvPr/>
        </p:nvSpPr>
        <p:spPr>
          <a:xfrm>
            <a:off x="6254521" y="1601954"/>
            <a:ext cx="37844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32A7FEE1-652E-4079-841E-33FB4686A083}"/>
              </a:ext>
            </a:extLst>
          </p:cNvPr>
          <p:cNvSpPr txBox="1"/>
          <p:nvPr/>
        </p:nvSpPr>
        <p:spPr>
          <a:xfrm>
            <a:off x="6563885" y="1004142"/>
            <a:ext cx="37844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6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F1B0E594-41AC-4671-907E-57F8EE20904F}"/>
              </a:ext>
            </a:extLst>
          </p:cNvPr>
          <p:cNvSpPr txBox="1"/>
          <p:nvPr/>
        </p:nvSpPr>
        <p:spPr>
          <a:xfrm>
            <a:off x="1525582" y="4235027"/>
            <a:ext cx="2528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5E85FDF9-6D91-4168-8058-06DEBC850436}"/>
              </a:ext>
            </a:extLst>
          </p:cNvPr>
          <p:cNvSpPr txBox="1"/>
          <p:nvPr/>
        </p:nvSpPr>
        <p:spPr>
          <a:xfrm>
            <a:off x="1759697" y="4277093"/>
            <a:ext cx="2528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A97DA748-13D6-471D-85B7-D7A9DD881BEF}"/>
              </a:ext>
            </a:extLst>
          </p:cNvPr>
          <p:cNvSpPr txBox="1"/>
          <p:nvPr/>
        </p:nvSpPr>
        <p:spPr>
          <a:xfrm>
            <a:off x="1977002" y="4151661"/>
            <a:ext cx="2528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3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5477A234-4EFB-4540-8379-9777B23068FF}"/>
              </a:ext>
            </a:extLst>
          </p:cNvPr>
          <p:cNvSpPr txBox="1"/>
          <p:nvPr/>
        </p:nvSpPr>
        <p:spPr>
          <a:xfrm>
            <a:off x="2192280" y="4138957"/>
            <a:ext cx="2528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3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F600AD69-B242-4D61-B8CE-47096314962B}"/>
              </a:ext>
            </a:extLst>
          </p:cNvPr>
          <p:cNvSpPr txBox="1"/>
          <p:nvPr/>
        </p:nvSpPr>
        <p:spPr>
          <a:xfrm>
            <a:off x="2407227" y="4230713"/>
            <a:ext cx="2528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F35B43AC-ACD8-4102-BC27-8FF5E74F2669}"/>
              </a:ext>
            </a:extLst>
          </p:cNvPr>
          <p:cNvSpPr txBox="1"/>
          <p:nvPr/>
        </p:nvSpPr>
        <p:spPr>
          <a:xfrm>
            <a:off x="2643111" y="4304991"/>
            <a:ext cx="2528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0156E402-4B0E-450B-82C8-CD6F4B90C01C}"/>
              </a:ext>
            </a:extLst>
          </p:cNvPr>
          <p:cNvSpPr txBox="1"/>
          <p:nvPr/>
        </p:nvSpPr>
        <p:spPr>
          <a:xfrm>
            <a:off x="2852297" y="4222449"/>
            <a:ext cx="2528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EA0A319A-1C14-40E6-812F-59012A8D0EDE}"/>
              </a:ext>
            </a:extLst>
          </p:cNvPr>
          <p:cNvSpPr txBox="1"/>
          <p:nvPr/>
        </p:nvSpPr>
        <p:spPr>
          <a:xfrm>
            <a:off x="1133571" y="4281775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0A22B3CE-4697-4C70-BCCC-02E0D51532FB}"/>
              </a:ext>
            </a:extLst>
          </p:cNvPr>
          <p:cNvSpPr txBox="1"/>
          <p:nvPr/>
        </p:nvSpPr>
        <p:spPr>
          <a:xfrm>
            <a:off x="1130420" y="4138012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4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3D510B7B-8845-4318-AE84-84B62296AE2F}"/>
              </a:ext>
            </a:extLst>
          </p:cNvPr>
          <p:cNvSpPr txBox="1"/>
          <p:nvPr/>
        </p:nvSpPr>
        <p:spPr>
          <a:xfrm>
            <a:off x="1134649" y="3984132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6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CD7E961D-75F2-4327-9FCC-5A539A954B71}"/>
              </a:ext>
            </a:extLst>
          </p:cNvPr>
          <p:cNvSpPr txBox="1"/>
          <p:nvPr/>
        </p:nvSpPr>
        <p:spPr>
          <a:xfrm>
            <a:off x="1130419" y="3820083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8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F06D4CD4-EC60-451A-B41D-1943849A5217}"/>
              </a:ext>
            </a:extLst>
          </p:cNvPr>
          <p:cNvSpPr txBox="1"/>
          <p:nvPr/>
        </p:nvSpPr>
        <p:spPr>
          <a:xfrm rot="16200000">
            <a:off x="593946" y="4042672"/>
            <a:ext cx="8285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Missense</a:t>
            </a:r>
          </a:p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 Intersections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F2055F7D-B860-437B-B37A-0DFD3CD8803E}"/>
              </a:ext>
            </a:extLst>
          </p:cNvPr>
          <p:cNvSpPr txBox="1"/>
          <p:nvPr/>
        </p:nvSpPr>
        <p:spPr>
          <a:xfrm>
            <a:off x="28606" y="5878661"/>
            <a:ext cx="2751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0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DDAA3B94-9AC4-402A-9ED1-9879FA6B958C}"/>
              </a:ext>
            </a:extLst>
          </p:cNvPr>
          <p:cNvSpPr txBox="1"/>
          <p:nvPr/>
        </p:nvSpPr>
        <p:spPr>
          <a:xfrm>
            <a:off x="373218" y="5877042"/>
            <a:ext cx="2751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0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6B55D250-6A2B-43C5-904A-4021715432C8}"/>
              </a:ext>
            </a:extLst>
          </p:cNvPr>
          <p:cNvSpPr txBox="1"/>
          <p:nvPr/>
        </p:nvSpPr>
        <p:spPr>
          <a:xfrm>
            <a:off x="767379" y="5876078"/>
            <a:ext cx="2751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E0544FF3-A739-453B-BFC5-2EBBB8BDA52F}"/>
              </a:ext>
            </a:extLst>
          </p:cNvPr>
          <p:cNvSpPr txBox="1"/>
          <p:nvPr/>
        </p:nvSpPr>
        <p:spPr>
          <a:xfrm rot="16200000">
            <a:off x="4043735" y="4030296"/>
            <a:ext cx="8285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Missense</a:t>
            </a:r>
          </a:p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 Intersections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80B7DCC4-F868-4308-B30A-E5D0F5AA1BA2}"/>
              </a:ext>
            </a:extLst>
          </p:cNvPr>
          <p:cNvSpPr txBox="1"/>
          <p:nvPr/>
        </p:nvSpPr>
        <p:spPr>
          <a:xfrm>
            <a:off x="4576082" y="4416682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EC1FB8CD-F401-481C-9797-E07581E02D68}"/>
              </a:ext>
            </a:extLst>
          </p:cNvPr>
          <p:cNvSpPr txBox="1"/>
          <p:nvPr/>
        </p:nvSpPr>
        <p:spPr>
          <a:xfrm>
            <a:off x="4579347" y="4212010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9E7DBDCE-E844-44CC-959F-D22702EB146F}"/>
              </a:ext>
            </a:extLst>
          </p:cNvPr>
          <p:cNvSpPr txBox="1"/>
          <p:nvPr/>
        </p:nvSpPr>
        <p:spPr>
          <a:xfrm>
            <a:off x="4574680" y="3990300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4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E65E2918-3324-4632-9E68-6AC876392C94}"/>
              </a:ext>
            </a:extLst>
          </p:cNvPr>
          <p:cNvSpPr txBox="1"/>
          <p:nvPr/>
        </p:nvSpPr>
        <p:spPr>
          <a:xfrm>
            <a:off x="4563524" y="3776893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6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D797E40F-FCE7-4051-988D-F0EB57BA2D87}"/>
              </a:ext>
            </a:extLst>
          </p:cNvPr>
          <p:cNvSpPr txBox="1"/>
          <p:nvPr/>
        </p:nvSpPr>
        <p:spPr>
          <a:xfrm>
            <a:off x="5020760" y="4251688"/>
            <a:ext cx="24824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96BC6362-CE60-4E8E-AEAF-131CCBDFE0F9}"/>
              </a:ext>
            </a:extLst>
          </p:cNvPr>
          <p:cNvSpPr txBox="1"/>
          <p:nvPr/>
        </p:nvSpPr>
        <p:spPr>
          <a:xfrm>
            <a:off x="5270580" y="4147786"/>
            <a:ext cx="24824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A4A6E017-4301-4C38-8F70-4F66FD53652D}"/>
              </a:ext>
            </a:extLst>
          </p:cNvPr>
          <p:cNvSpPr txBox="1"/>
          <p:nvPr/>
        </p:nvSpPr>
        <p:spPr>
          <a:xfrm>
            <a:off x="5535183" y="4247813"/>
            <a:ext cx="24824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E07259BF-7B87-42E7-8075-733AE82C358F}"/>
              </a:ext>
            </a:extLst>
          </p:cNvPr>
          <p:cNvSpPr txBox="1"/>
          <p:nvPr/>
        </p:nvSpPr>
        <p:spPr>
          <a:xfrm>
            <a:off x="5770811" y="3697641"/>
            <a:ext cx="24824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6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510BB33F-DB62-4A24-B9A1-5CF13FB97415}"/>
              </a:ext>
            </a:extLst>
          </p:cNvPr>
          <p:cNvSpPr txBox="1"/>
          <p:nvPr/>
        </p:nvSpPr>
        <p:spPr>
          <a:xfrm>
            <a:off x="6028083" y="4130685"/>
            <a:ext cx="24824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8FF3CF96-06D0-4005-973E-C327B625F218}"/>
              </a:ext>
            </a:extLst>
          </p:cNvPr>
          <p:cNvSpPr txBox="1"/>
          <p:nvPr/>
        </p:nvSpPr>
        <p:spPr>
          <a:xfrm>
            <a:off x="3749285" y="5904716"/>
            <a:ext cx="3237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0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51B74588-AE37-4178-881B-D4307046DE4A}"/>
              </a:ext>
            </a:extLst>
          </p:cNvPr>
          <p:cNvSpPr txBox="1"/>
          <p:nvPr/>
        </p:nvSpPr>
        <p:spPr>
          <a:xfrm>
            <a:off x="1359084" y="6701261"/>
            <a:ext cx="2528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5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35726260-C44D-4B6C-82FD-BDC46F8B5E88}"/>
              </a:ext>
            </a:extLst>
          </p:cNvPr>
          <p:cNvSpPr txBox="1"/>
          <p:nvPr/>
        </p:nvSpPr>
        <p:spPr>
          <a:xfrm>
            <a:off x="1801377" y="6782199"/>
            <a:ext cx="2528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4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BDC49EEF-AAAE-4713-8CE2-1DFA5E5C46C5}"/>
              </a:ext>
            </a:extLst>
          </p:cNvPr>
          <p:cNvSpPr txBox="1"/>
          <p:nvPr/>
        </p:nvSpPr>
        <p:spPr>
          <a:xfrm>
            <a:off x="2255429" y="6852664"/>
            <a:ext cx="2528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3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7A520682-DBD5-41C3-9F37-7F53DFBBD171}"/>
              </a:ext>
            </a:extLst>
          </p:cNvPr>
          <p:cNvSpPr txBox="1"/>
          <p:nvPr/>
        </p:nvSpPr>
        <p:spPr>
          <a:xfrm>
            <a:off x="2725851" y="6494275"/>
            <a:ext cx="2528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8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52AD2CD1-6F46-4FD5-A96A-987B4F09603A}"/>
              </a:ext>
            </a:extLst>
          </p:cNvPr>
          <p:cNvSpPr txBox="1"/>
          <p:nvPr/>
        </p:nvSpPr>
        <p:spPr>
          <a:xfrm>
            <a:off x="275243" y="8608977"/>
            <a:ext cx="565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Palatino Linotype" panose="02040502050505030304" pitchFamily="18" charset="0"/>
              </a:rPr>
              <a:t>Set Size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D494F982-1E19-4EC2-AA88-F85459275EC3}"/>
              </a:ext>
            </a:extLst>
          </p:cNvPr>
          <p:cNvSpPr txBox="1"/>
          <p:nvPr/>
        </p:nvSpPr>
        <p:spPr>
          <a:xfrm>
            <a:off x="728359" y="8477165"/>
            <a:ext cx="2751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5301F411-549F-416C-B87D-89CF07FB772E}"/>
              </a:ext>
            </a:extLst>
          </p:cNvPr>
          <p:cNvSpPr txBox="1"/>
          <p:nvPr/>
        </p:nvSpPr>
        <p:spPr>
          <a:xfrm>
            <a:off x="333820" y="8477164"/>
            <a:ext cx="2751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0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AD6771D8-6265-43F1-9E31-DCA0A6F85111}"/>
              </a:ext>
            </a:extLst>
          </p:cNvPr>
          <p:cNvSpPr txBox="1"/>
          <p:nvPr/>
        </p:nvSpPr>
        <p:spPr>
          <a:xfrm>
            <a:off x="3466799" y="8508949"/>
            <a:ext cx="2751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0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E7D6A60D-AC5A-4169-9909-CB374F8148A7}"/>
              </a:ext>
            </a:extLst>
          </p:cNvPr>
          <p:cNvSpPr txBox="1"/>
          <p:nvPr/>
        </p:nvSpPr>
        <p:spPr>
          <a:xfrm>
            <a:off x="4186779" y="8516644"/>
            <a:ext cx="2751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9C595B14-F3F0-47FB-94ED-B819BA105EC7}"/>
              </a:ext>
            </a:extLst>
          </p:cNvPr>
          <p:cNvSpPr txBox="1"/>
          <p:nvPr/>
        </p:nvSpPr>
        <p:spPr>
          <a:xfrm>
            <a:off x="3739156" y="8611170"/>
            <a:ext cx="565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Palatino Linotype" panose="02040502050505030304" pitchFamily="18" charset="0"/>
              </a:rPr>
              <a:t>Set Size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C599036C-6DAC-4B9E-8277-AEDDF4AB94D6}"/>
              </a:ext>
            </a:extLst>
          </p:cNvPr>
          <p:cNvSpPr txBox="1"/>
          <p:nvPr/>
        </p:nvSpPr>
        <p:spPr>
          <a:xfrm>
            <a:off x="1060231" y="6555823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8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6BF43A70-25A5-49E5-832E-FB103945F60B}"/>
              </a:ext>
            </a:extLst>
          </p:cNvPr>
          <p:cNvSpPr txBox="1"/>
          <p:nvPr/>
        </p:nvSpPr>
        <p:spPr>
          <a:xfrm>
            <a:off x="1058683" y="6712698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6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65A9A10C-9644-43D2-9196-C1B60D3BBB2F}"/>
              </a:ext>
            </a:extLst>
          </p:cNvPr>
          <p:cNvSpPr txBox="1"/>
          <p:nvPr/>
        </p:nvSpPr>
        <p:spPr>
          <a:xfrm>
            <a:off x="1060238" y="6856208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4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5B637509-A7B2-40EF-96FE-53FB542809BA}"/>
              </a:ext>
            </a:extLst>
          </p:cNvPr>
          <p:cNvSpPr txBox="1"/>
          <p:nvPr/>
        </p:nvSpPr>
        <p:spPr>
          <a:xfrm>
            <a:off x="1058683" y="7010899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212FA96C-6E34-4168-8FEF-46C2E2935183}"/>
              </a:ext>
            </a:extLst>
          </p:cNvPr>
          <p:cNvSpPr txBox="1"/>
          <p:nvPr/>
        </p:nvSpPr>
        <p:spPr>
          <a:xfrm>
            <a:off x="1050346" y="7151339"/>
            <a:ext cx="2059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AB5AB49E-1344-4F8B-AFB3-A3069D84704F}"/>
              </a:ext>
            </a:extLst>
          </p:cNvPr>
          <p:cNvSpPr txBox="1"/>
          <p:nvPr/>
        </p:nvSpPr>
        <p:spPr>
          <a:xfrm rot="16200000">
            <a:off x="534121" y="6762032"/>
            <a:ext cx="8285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Missense</a:t>
            </a:r>
          </a:p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 Intersections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90164DDD-6AC2-4A21-AB67-7D96F7554C78}"/>
              </a:ext>
            </a:extLst>
          </p:cNvPr>
          <p:cNvSpPr txBox="1"/>
          <p:nvPr/>
        </p:nvSpPr>
        <p:spPr>
          <a:xfrm>
            <a:off x="4534587" y="6454829"/>
            <a:ext cx="3428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5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744246EA-2EBC-4CAD-A69B-F83E46F05EA3}"/>
              </a:ext>
            </a:extLst>
          </p:cNvPr>
          <p:cNvSpPr txBox="1"/>
          <p:nvPr/>
        </p:nvSpPr>
        <p:spPr>
          <a:xfrm>
            <a:off x="4547762" y="6626822"/>
            <a:ext cx="3428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0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D3FE225C-81B5-4AE2-A86A-4EC2D34465CE}"/>
              </a:ext>
            </a:extLst>
          </p:cNvPr>
          <p:cNvSpPr txBox="1"/>
          <p:nvPr/>
        </p:nvSpPr>
        <p:spPr>
          <a:xfrm>
            <a:off x="4589942" y="6828985"/>
            <a:ext cx="3428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5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BBD44E78-D79C-432F-99C6-7DDC39F04E24}"/>
              </a:ext>
            </a:extLst>
          </p:cNvPr>
          <p:cNvSpPr txBox="1"/>
          <p:nvPr/>
        </p:nvSpPr>
        <p:spPr>
          <a:xfrm>
            <a:off x="4588160" y="7031896"/>
            <a:ext cx="3428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1260494C-86F7-477C-A787-79A94F927E2D}"/>
              </a:ext>
            </a:extLst>
          </p:cNvPr>
          <p:cNvSpPr txBox="1"/>
          <p:nvPr/>
        </p:nvSpPr>
        <p:spPr>
          <a:xfrm rot="16200000">
            <a:off x="4043735" y="6648394"/>
            <a:ext cx="8285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Missense</a:t>
            </a:r>
          </a:p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 Intersections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B32D45DF-F9D6-4825-B887-94CEE8357218}"/>
              </a:ext>
            </a:extLst>
          </p:cNvPr>
          <p:cNvSpPr txBox="1"/>
          <p:nvPr/>
        </p:nvSpPr>
        <p:spPr>
          <a:xfrm>
            <a:off x="4915183" y="6920681"/>
            <a:ext cx="2528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0EF1DA2F-6C52-478A-8F7C-89C94CF8F0B1}"/>
              </a:ext>
            </a:extLst>
          </p:cNvPr>
          <p:cNvSpPr txBox="1"/>
          <p:nvPr/>
        </p:nvSpPr>
        <p:spPr>
          <a:xfrm>
            <a:off x="5429712" y="6924909"/>
            <a:ext cx="2528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F44EA45F-7AC4-41BD-AFE8-28BBD0CBCE08}"/>
              </a:ext>
            </a:extLst>
          </p:cNvPr>
          <p:cNvSpPr txBox="1"/>
          <p:nvPr/>
        </p:nvSpPr>
        <p:spPr>
          <a:xfrm>
            <a:off x="5918796" y="6929012"/>
            <a:ext cx="25289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7D294D43-7C60-46EB-AFB8-59E2B36F420E}"/>
              </a:ext>
            </a:extLst>
          </p:cNvPr>
          <p:cNvSpPr txBox="1"/>
          <p:nvPr/>
        </p:nvSpPr>
        <p:spPr>
          <a:xfrm>
            <a:off x="6440108" y="6337483"/>
            <a:ext cx="42447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6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A11492C1-A74C-41CC-8DA2-2974C99EE189}"/>
              </a:ext>
            </a:extLst>
          </p:cNvPr>
          <p:cNvSpPr txBox="1"/>
          <p:nvPr/>
        </p:nvSpPr>
        <p:spPr>
          <a:xfrm>
            <a:off x="770626" y="11266457"/>
            <a:ext cx="2751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8FF45D36-1CB9-41D6-8E4B-0D2B780554F9}"/>
              </a:ext>
            </a:extLst>
          </p:cNvPr>
          <p:cNvSpPr txBox="1"/>
          <p:nvPr/>
        </p:nvSpPr>
        <p:spPr>
          <a:xfrm>
            <a:off x="4252471" y="11247640"/>
            <a:ext cx="2751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F9CCE727-50DF-431C-871D-153B47086BC8}"/>
              </a:ext>
            </a:extLst>
          </p:cNvPr>
          <p:cNvSpPr txBox="1"/>
          <p:nvPr/>
        </p:nvSpPr>
        <p:spPr>
          <a:xfrm>
            <a:off x="3660351" y="11247640"/>
            <a:ext cx="2751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0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EF6695E0-6195-44E3-9216-D3F213A55AA2}"/>
              </a:ext>
            </a:extLst>
          </p:cNvPr>
          <p:cNvSpPr txBox="1"/>
          <p:nvPr/>
        </p:nvSpPr>
        <p:spPr>
          <a:xfrm>
            <a:off x="3935503" y="11247640"/>
            <a:ext cx="2751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0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34C34059-0651-4030-87B7-FD6A9A80841D}"/>
              </a:ext>
            </a:extLst>
          </p:cNvPr>
          <p:cNvSpPr txBox="1"/>
          <p:nvPr/>
        </p:nvSpPr>
        <p:spPr>
          <a:xfrm>
            <a:off x="3759161" y="11388163"/>
            <a:ext cx="5651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Palatino Linotype" panose="02040502050505030304" pitchFamily="18" charset="0"/>
              </a:rPr>
              <a:t>Set Size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2A06A562-FD9B-4E0B-B56F-EF0E7C713F04}"/>
              </a:ext>
            </a:extLst>
          </p:cNvPr>
          <p:cNvSpPr txBox="1"/>
          <p:nvPr/>
        </p:nvSpPr>
        <p:spPr>
          <a:xfrm>
            <a:off x="28606" y="11266456"/>
            <a:ext cx="2751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30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8260B8CB-B21F-4AD2-843D-71A2B21F06B5}"/>
              </a:ext>
            </a:extLst>
          </p:cNvPr>
          <p:cNvSpPr txBox="1"/>
          <p:nvPr/>
        </p:nvSpPr>
        <p:spPr>
          <a:xfrm>
            <a:off x="280969" y="11266457"/>
            <a:ext cx="2751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0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D0DECCB2-20B6-4D0D-AA29-2BC3C945DB50}"/>
              </a:ext>
            </a:extLst>
          </p:cNvPr>
          <p:cNvSpPr txBox="1"/>
          <p:nvPr/>
        </p:nvSpPr>
        <p:spPr>
          <a:xfrm>
            <a:off x="502956" y="11266457"/>
            <a:ext cx="27515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0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C96CB19F-29DC-47EF-A479-7417CD555059}"/>
              </a:ext>
            </a:extLst>
          </p:cNvPr>
          <p:cNvSpPr txBox="1"/>
          <p:nvPr/>
        </p:nvSpPr>
        <p:spPr>
          <a:xfrm>
            <a:off x="1117678" y="9148167"/>
            <a:ext cx="3385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5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9BDFB977-D58D-435F-8561-5EAA9E25D06E}"/>
              </a:ext>
            </a:extLst>
          </p:cNvPr>
          <p:cNvSpPr txBox="1"/>
          <p:nvPr/>
        </p:nvSpPr>
        <p:spPr>
          <a:xfrm>
            <a:off x="1123210" y="9351602"/>
            <a:ext cx="3385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0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5AC9FB2D-0EE9-417D-8E10-CB7157BD6AD9}"/>
              </a:ext>
            </a:extLst>
          </p:cNvPr>
          <p:cNvSpPr txBox="1"/>
          <p:nvPr/>
        </p:nvSpPr>
        <p:spPr>
          <a:xfrm>
            <a:off x="1164372" y="9574978"/>
            <a:ext cx="3385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5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29FF0DCE-72FF-44D0-801A-C63C77143FC9}"/>
              </a:ext>
            </a:extLst>
          </p:cNvPr>
          <p:cNvSpPr txBox="1"/>
          <p:nvPr/>
        </p:nvSpPr>
        <p:spPr>
          <a:xfrm>
            <a:off x="1180852" y="9790600"/>
            <a:ext cx="3385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0EE53DD5-CDC5-41B0-8012-6447D9FFC97E}"/>
              </a:ext>
            </a:extLst>
          </p:cNvPr>
          <p:cNvSpPr txBox="1"/>
          <p:nvPr/>
        </p:nvSpPr>
        <p:spPr>
          <a:xfrm>
            <a:off x="4602983" y="9160741"/>
            <a:ext cx="3385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0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122363B3-8D25-437B-A532-1787C7CABA90}"/>
              </a:ext>
            </a:extLst>
          </p:cNvPr>
          <p:cNvSpPr txBox="1"/>
          <p:nvPr/>
        </p:nvSpPr>
        <p:spPr>
          <a:xfrm>
            <a:off x="4612133" y="9476075"/>
            <a:ext cx="3385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0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1088DE76-E1F3-4897-B0BC-F435A0CF6761}"/>
              </a:ext>
            </a:extLst>
          </p:cNvPr>
          <p:cNvSpPr txBox="1"/>
          <p:nvPr/>
        </p:nvSpPr>
        <p:spPr>
          <a:xfrm>
            <a:off x="4644290" y="9756771"/>
            <a:ext cx="33855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0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5139A11A-E99C-4AF9-BCB4-D088D43C65D6}"/>
              </a:ext>
            </a:extLst>
          </p:cNvPr>
          <p:cNvSpPr txBox="1"/>
          <p:nvPr/>
        </p:nvSpPr>
        <p:spPr>
          <a:xfrm>
            <a:off x="1348839" y="9048990"/>
            <a:ext cx="3257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4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9FADF5B0-8936-4C84-80E3-027863563248}"/>
              </a:ext>
            </a:extLst>
          </p:cNvPr>
          <p:cNvSpPr txBox="1"/>
          <p:nvPr/>
        </p:nvSpPr>
        <p:spPr>
          <a:xfrm rot="16200000">
            <a:off x="597295" y="9346063"/>
            <a:ext cx="8285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Missense</a:t>
            </a:r>
          </a:p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 Intersections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565D6B3C-95CA-4019-A0C8-244023D3DD67}"/>
              </a:ext>
            </a:extLst>
          </p:cNvPr>
          <p:cNvSpPr txBox="1"/>
          <p:nvPr/>
        </p:nvSpPr>
        <p:spPr>
          <a:xfrm rot="16200000">
            <a:off x="4094108" y="9352821"/>
            <a:ext cx="8285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Missense</a:t>
            </a:r>
          </a:p>
          <a:p>
            <a:pPr algn="ctr"/>
            <a:r>
              <a:rPr lang="en-US" sz="800" b="1" dirty="0">
                <a:latin typeface="Palatino Linotype" panose="02040502050505030304" pitchFamily="18" charset="0"/>
              </a:rPr>
              <a:t> Intersections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E9ED2356-A6B9-4368-960A-1DD4B5EAF14C}"/>
              </a:ext>
            </a:extLst>
          </p:cNvPr>
          <p:cNvSpPr txBox="1"/>
          <p:nvPr/>
        </p:nvSpPr>
        <p:spPr>
          <a:xfrm>
            <a:off x="1519406" y="9376047"/>
            <a:ext cx="3257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8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3039935D-7C7A-4965-937C-ED5EFDF6D8A3}"/>
              </a:ext>
            </a:extLst>
          </p:cNvPr>
          <p:cNvSpPr txBox="1"/>
          <p:nvPr/>
        </p:nvSpPr>
        <p:spPr>
          <a:xfrm>
            <a:off x="1754378" y="9498453"/>
            <a:ext cx="3257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5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17002152-6144-40E1-AC6C-8D6A5C9C2466}"/>
              </a:ext>
            </a:extLst>
          </p:cNvPr>
          <p:cNvSpPr txBox="1"/>
          <p:nvPr/>
        </p:nvSpPr>
        <p:spPr>
          <a:xfrm>
            <a:off x="1940562" y="9667604"/>
            <a:ext cx="3257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402D2A32-EED4-4DE4-B2DD-92B3AE3C970E}"/>
              </a:ext>
            </a:extLst>
          </p:cNvPr>
          <p:cNvSpPr txBox="1"/>
          <p:nvPr/>
        </p:nvSpPr>
        <p:spPr>
          <a:xfrm>
            <a:off x="2158776" y="9493626"/>
            <a:ext cx="3257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5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EC88F34A-DF27-4608-B38C-3F6BC895136D}"/>
              </a:ext>
            </a:extLst>
          </p:cNvPr>
          <p:cNvSpPr txBox="1"/>
          <p:nvPr/>
        </p:nvSpPr>
        <p:spPr>
          <a:xfrm>
            <a:off x="2354899" y="9656743"/>
            <a:ext cx="3257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5C284C8F-53DF-438E-8829-01C8DE7C1832}"/>
              </a:ext>
            </a:extLst>
          </p:cNvPr>
          <p:cNvSpPr txBox="1"/>
          <p:nvPr/>
        </p:nvSpPr>
        <p:spPr>
          <a:xfrm>
            <a:off x="2545149" y="9671778"/>
            <a:ext cx="3257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A5F28E23-89D8-4AEF-97EA-83D839963D55}"/>
              </a:ext>
            </a:extLst>
          </p:cNvPr>
          <p:cNvSpPr txBox="1"/>
          <p:nvPr/>
        </p:nvSpPr>
        <p:spPr>
          <a:xfrm>
            <a:off x="2741125" y="9640150"/>
            <a:ext cx="3257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58726DBF-B017-4D92-8EB1-57298BFEDC69}"/>
              </a:ext>
            </a:extLst>
          </p:cNvPr>
          <p:cNvSpPr txBox="1"/>
          <p:nvPr/>
        </p:nvSpPr>
        <p:spPr>
          <a:xfrm>
            <a:off x="2953093" y="9672164"/>
            <a:ext cx="3257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CAF8D0B5-BBCB-4AC1-A27C-29C209AC2762}"/>
              </a:ext>
            </a:extLst>
          </p:cNvPr>
          <p:cNvSpPr txBox="1"/>
          <p:nvPr/>
        </p:nvSpPr>
        <p:spPr>
          <a:xfrm>
            <a:off x="3147912" y="9222067"/>
            <a:ext cx="3257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1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B0E27BA0-B70E-4AD5-8559-868B873B4129}"/>
              </a:ext>
            </a:extLst>
          </p:cNvPr>
          <p:cNvSpPr txBox="1"/>
          <p:nvPr/>
        </p:nvSpPr>
        <p:spPr>
          <a:xfrm>
            <a:off x="4993269" y="9607964"/>
            <a:ext cx="3257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3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69646CEB-98C3-44C9-87D8-11C9E440F4F6}"/>
              </a:ext>
            </a:extLst>
          </p:cNvPr>
          <p:cNvSpPr txBox="1"/>
          <p:nvPr/>
        </p:nvSpPr>
        <p:spPr>
          <a:xfrm>
            <a:off x="5485607" y="9640150"/>
            <a:ext cx="3257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DD0D8987-B7C9-41C7-8AEB-B5E9061A6A23}"/>
              </a:ext>
            </a:extLst>
          </p:cNvPr>
          <p:cNvSpPr txBox="1"/>
          <p:nvPr/>
        </p:nvSpPr>
        <p:spPr>
          <a:xfrm>
            <a:off x="5943365" y="9670989"/>
            <a:ext cx="3257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1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27F16EF5-2128-4352-8B1C-83966DA273B6}"/>
              </a:ext>
            </a:extLst>
          </p:cNvPr>
          <p:cNvSpPr txBox="1"/>
          <p:nvPr/>
        </p:nvSpPr>
        <p:spPr>
          <a:xfrm>
            <a:off x="6424674" y="9060713"/>
            <a:ext cx="3257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Palatino Linotype" panose="02040502050505030304" pitchFamily="18" charset="0"/>
              </a:rPr>
              <a:t>21</a:t>
            </a: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C59D5CB0-C1D3-43A9-8E57-24181D481D00}"/>
              </a:ext>
            </a:extLst>
          </p:cNvPr>
          <p:cNvSpPr txBox="1"/>
          <p:nvPr/>
        </p:nvSpPr>
        <p:spPr>
          <a:xfrm>
            <a:off x="56176" y="-13173"/>
            <a:ext cx="11089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Palatino Linotype" panose="02040502050505030304" pitchFamily="18" charset="0"/>
              </a:rPr>
              <a:t>Fig. S12</a:t>
            </a:r>
          </a:p>
        </p:txBody>
      </p:sp>
    </p:spTree>
    <p:extLst>
      <p:ext uri="{BB962C8B-B14F-4D97-AF65-F5344CB8AC3E}">
        <p14:creationId xmlns:p14="http://schemas.microsoft.com/office/powerpoint/2010/main" val="32826677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5E28F63-CB06-42E3-9BEB-363D9269E7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2178" y="3690830"/>
            <a:ext cx="3173441" cy="2267198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81A3863D-08B7-49AD-8F1D-3E28BA9D7EFE}"/>
              </a:ext>
            </a:extLst>
          </p:cNvPr>
          <p:cNvSpPr txBox="1"/>
          <p:nvPr/>
        </p:nvSpPr>
        <p:spPr>
          <a:xfrm rot="16200000">
            <a:off x="-374273" y="1693731"/>
            <a:ext cx="102555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HT72 -P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FC643A8-7D65-4C40-9E3F-13B40CEE7FBE}"/>
              </a:ext>
            </a:extLst>
          </p:cNvPr>
          <p:cNvSpPr txBox="1"/>
          <p:nvPr/>
        </p:nvSpPr>
        <p:spPr>
          <a:xfrm rot="16200000">
            <a:off x="3099588" y="1693730"/>
            <a:ext cx="102555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HT77- P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0146CA9-C693-4C4B-9148-572996E233F4}"/>
              </a:ext>
            </a:extLst>
          </p:cNvPr>
          <p:cNvSpPr txBox="1"/>
          <p:nvPr/>
        </p:nvSpPr>
        <p:spPr>
          <a:xfrm>
            <a:off x="1485601" y="3197942"/>
            <a:ext cx="84509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HT72 -P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2623DEB-8B49-40D3-B587-E406736534E7}"/>
              </a:ext>
            </a:extLst>
          </p:cNvPr>
          <p:cNvSpPr txBox="1"/>
          <p:nvPr/>
        </p:nvSpPr>
        <p:spPr>
          <a:xfrm>
            <a:off x="-27474" y="657864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6B6D41B-042C-4C19-A351-740CBCDB52CC}"/>
              </a:ext>
            </a:extLst>
          </p:cNvPr>
          <p:cNvSpPr txBox="1"/>
          <p:nvPr/>
        </p:nvSpPr>
        <p:spPr>
          <a:xfrm>
            <a:off x="3355689" y="657864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771515C-3633-43C6-91DE-8421123A1282}"/>
              </a:ext>
            </a:extLst>
          </p:cNvPr>
          <p:cNvSpPr txBox="1"/>
          <p:nvPr/>
        </p:nvSpPr>
        <p:spPr>
          <a:xfrm>
            <a:off x="-10038" y="3461283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4371617-21BC-4A5B-B150-C9922E1346BF}"/>
              </a:ext>
            </a:extLst>
          </p:cNvPr>
          <p:cNvSpPr txBox="1"/>
          <p:nvPr/>
        </p:nvSpPr>
        <p:spPr>
          <a:xfrm>
            <a:off x="-6834" y="6186418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3DC003C-7DE6-4907-9DCF-9408A4EC0633}"/>
              </a:ext>
            </a:extLst>
          </p:cNvPr>
          <p:cNvSpPr txBox="1"/>
          <p:nvPr/>
        </p:nvSpPr>
        <p:spPr>
          <a:xfrm>
            <a:off x="3347112" y="3461283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D8C46F5-225F-4239-B95B-97DF871169EC}"/>
              </a:ext>
            </a:extLst>
          </p:cNvPr>
          <p:cNvSpPr txBox="1"/>
          <p:nvPr/>
        </p:nvSpPr>
        <p:spPr>
          <a:xfrm>
            <a:off x="4949853" y="3197942"/>
            <a:ext cx="84509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HT72 -P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8E41AB4-6D97-496E-BDA8-52FE89663A70}"/>
              </a:ext>
            </a:extLst>
          </p:cNvPr>
          <p:cNvSpPr txBox="1"/>
          <p:nvPr/>
        </p:nvSpPr>
        <p:spPr>
          <a:xfrm>
            <a:off x="1485601" y="5917084"/>
            <a:ext cx="84509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HT87-P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C6A09EF-0FE6-4BC7-ABC9-A29233DFB0A3}"/>
              </a:ext>
            </a:extLst>
          </p:cNvPr>
          <p:cNvSpPr txBox="1"/>
          <p:nvPr/>
        </p:nvSpPr>
        <p:spPr>
          <a:xfrm>
            <a:off x="1485601" y="8776956"/>
            <a:ext cx="95038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HT74 -P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3CEA753-B8C4-459B-BC00-30F15AE18178}"/>
              </a:ext>
            </a:extLst>
          </p:cNvPr>
          <p:cNvSpPr txBox="1"/>
          <p:nvPr/>
        </p:nvSpPr>
        <p:spPr>
          <a:xfrm>
            <a:off x="4949853" y="5933427"/>
            <a:ext cx="84509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HT96- P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67DE683-B748-4FAC-BFF9-17BBF69154E6}"/>
              </a:ext>
            </a:extLst>
          </p:cNvPr>
          <p:cNvSpPr txBox="1"/>
          <p:nvPr/>
        </p:nvSpPr>
        <p:spPr>
          <a:xfrm rot="16200000">
            <a:off x="-374274" y="4492078"/>
            <a:ext cx="102555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HT87- P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EBFD389-0122-48BB-9C66-50C8F5CAC3BD}"/>
              </a:ext>
            </a:extLst>
          </p:cNvPr>
          <p:cNvSpPr txBox="1"/>
          <p:nvPr/>
        </p:nvSpPr>
        <p:spPr>
          <a:xfrm rot="16200000">
            <a:off x="3108266" y="4487929"/>
            <a:ext cx="102555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HT96 -P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7FBD117-304D-4F8A-8420-9838DCF2C4D0}"/>
              </a:ext>
            </a:extLst>
          </p:cNvPr>
          <p:cNvSpPr txBox="1"/>
          <p:nvPr/>
        </p:nvSpPr>
        <p:spPr>
          <a:xfrm rot="16200000">
            <a:off x="-366899" y="7237377"/>
            <a:ext cx="102555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HT74- P2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D375610-93F8-481D-92B7-C45D146FB2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9060" y="996504"/>
            <a:ext cx="3098052" cy="2213337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516E4E83-254A-45AD-943A-0A1FD1C3CE8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54796" y="1012613"/>
            <a:ext cx="3075503" cy="2197228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4C52F525-5D87-431E-B14E-42308712128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5412" y="3764683"/>
            <a:ext cx="3035633" cy="216874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21A246D-1329-4E31-9E39-2F57CE281C4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3455" y="6463114"/>
            <a:ext cx="3232528" cy="2309411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B63AB16B-B030-4C56-AB21-1D0E867C0E8E}"/>
              </a:ext>
            </a:extLst>
          </p:cNvPr>
          <p:cNvSpPr txBox="1"/>
          <p:nvPr/>
        </p:nvSpPr>
        <p:spPr>
          <a:xfrm>
            <a:off x="56176" y="-13173"/>
            <a:ext cx="11089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Palatino Linotype" panose="02040502050505030304" pitchFamily="18" charset="0"/>
              </a:rPr>
              <a:t>Fig. S13</a:t>
            </a:r>
          </a:p>
        </p:txBody>
      </p:sp>
    </p:spTree>
    <p:extLst>
      <p:ext uri="{BB962C8B-B14F-4D97-AF65-F5344CB8AC3E}">
        <p14:creationId xmlns:p14="http://schemas.microsoft.com/office/powerpoint/2010/main" val="201810199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AFC6729-29E0-4A26-87DB-BFDE6D47F03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043" t="16216" r="43916" b="15625"/>
          <a:stretch/>
        </p:blipFill>
        <p:spPr>
          <a:xfrm>
            <a:off x="74428" y="967562"/>
            <a:ext cx="3519377" cy="726203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69E1394-5E4B-476A-9210-3E88474155C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3042" t="16203" r="13835" b="60774"/>
          <a:stretch/>
        </p:blipFill>
        <p:spPr>
          <a:xfrm>
            <a:off x="3593805" y="4311301"/>
            <a:ext cx="2211572" cy="2935993"/>
          </a:xfrm>
          <a:prstGeom prst="rect">
            <a:avLst/>
          </a:prstGeom>
        </p:spPr>
      </p:pic>
      <p:grpSp>
        <p:nvGrpSpPr>
          <p:cNvPr id="7" name="Group 6">
            <a:extLst>
              <a:ext uri="{FF2B5EF4-FFF2-40B4-BE49-F238E27FC236}">
                <a16:creationId xmlns:a16="http://schemas.microsoft.com/office/drawing/2014/main" id="{875B5992-3E00-4AED-A904-FF8424A4B2DD}"/>
              </a:ext>
            </a:extLst>
          </p:cNvPr>
          <p:cNvGrpSpPr/>
          <p:nvPr/>
        </p:nvGrpSpPr>
        <p:grpSpPr>
          <a:xfrm>
            <a:off x="3593805" y="1122805"/>
            <a:ext cx="1369146" cy="2192908"/>
            <a:chOff x="4629150" y="1551625"/>
            <a:chExt cx="1369146" cy="2192908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84AC960D-EBE1-4DF0-8392-BDAA5E531EB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65059" t="1824" r="32937" b="78776"/>
            <a:stretch/>
          </p:blipFill>
          <p:spPr>
            <a:xfrm>
              <a:off x="4629150" y="1559086"/>
              <a:ext cx="204643" cy="2177987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A28E559-0FA2-42B6-BD99-545E9DC27849}"/>
                </a:ext>
              </a:extLst>
            </p:cNvPr>
            <p:cNvSpPr txBox="1"/>
            <p:nvPr/>
          </p:nvSpPr>
          <p:spPr>
            <a:xfrm>
              <a:off x="4731471" y="1551625"/>
              <a:ext cx="1266825" cy="21929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dirty="0">
                  <a:cs typeface="Arial" panose="020B0604020202020204" pitchFamily="34" charset="0"/>
                </a:rPr>
                <a:t>150,000</a:t>
              </a:r>
            </a:p>
            <a:p>
              <a:endParaRPr lang="en-US" sz="1050" dirty="0">
                <a:cs typeface="Arial" panose="020B0604020202020204" pitchFamily="34" charset="0"/>
              </a:endParaRPr>
            </a:p>
            <a:p>
              <a:endParaRPr lang="en-US" sz="1050" dirty="0">
                <a:cs typeface="Arial" panose="020B0604020202020204" pitchFamily="34" charset="0"/>
              </a:endParaRPr>
            </a:p>
            <a:p>
              <a:endParaRPr lang="en-US" sz="1050" dirty="0">
                <a:cs typeface="Arial" panose="020B0604020202020204" pitchFamily="34" charset="0"/>
              </a:endParaRPr>
            </a:p>
            <a:p>
              <a:r>
                <a:rPr lang="en-US" sz="1050" dirty="0">
                  <a:cs typeface="Arial" panose="020B0604020202020204" pitchFamily="34" charset="0"/>
                </a:rPr>
                <a:t>100,000</a:t>
              </a:r>
            </a:p>
            <a:p>
              <a:endParaRPr lang="en-US" sz="1050" dirty="0">
                <a:cs typeface="Arial" panose="020B0604020202020204" pitchFamily="34" charset="0"/>
              </a:endParaRPr>
            </a:p>
            <a:p>
              <a:endParaRPr lang="en-US" sz="1050" dirty="0">
                <a:cs typeface="Arial" panose="020B0604020202020204" pitchFamily="34" charset="0"/>
              </a:endParaRPr>
            </a:p>
            <a:p>
              <a:endParaRPr lang="en-US" sz="1050" dirty="0">
                <a:cs typeface="Arial" panose="020B0604020202020204" pitchFamily="34" charset="0"/>
              </a:endParaRPr>
            </a:p>
            <a:p>
              <a:r>
                <a:rPr lang="en-US" sz="1050" dirty="0">
                  <a:cs typeface="Arial" panose="020B0604020202020204" pitchFamily="34" charset="0"/>
                </a:rPr>
                <a:t>50,000</a:t>
              </a:r>
            </a:p>
            <a:p>
              <a:endParaRPr lang="en-US" sz="1050" dirty="0">
                <a:cs typeface="Arial" panose="020B0604020202020204" pitchFamily="34" charset="0"/>
              </a:endParaRPr>
            </a:p>
            <a:p>
              <a:endParaRPr lang="en-US" sz="1050" dirty="0">
                <a:cs typeface="Arial" panose="020B0604020202020204" pitchFamily="34" charset="0"/>
              </a:endParaRPr>
            </a:p>
            <a:p>
              <a:endParaRPr lang="en-US" sz="1050" dirty="0">
                <a:cs typeface="Arial" panose="020B0604020202020204" pitchFamily="34" charset="0"/>
              </a:endParaRPr>
            </a:p>
            <a:p>
              <a:r>
                <a:rPr lang="en-US" sz="1050" dirty="0">
                  <a:cs typeface="Arial" panose="020B0604020202020204" pitchFamily="34" charset="0"/>
                </a:rPr>
                <a:t>0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97332E9C-0263-454D-BACB-FF0FD77EF587}"/>
              </a:ext>
            </a:extLst>
          </p:cNvPr>
          <p:cNvSpPr txBox="1"/>
          <p:nvPr/>
        </p:nvSpPr>
        <p:spPr>
          <a:xfrm>
            <a:off x="3429000" y="836757"/>
            <a:ext cx="11642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/>
              <a:t>Intensity Value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8EA496D-81F4-4986-985D-D2D634634E53}"/>
              </a:ext>
            </a:extLst>
          </p:cNvPr>
          <p:cNvSpPr txBox="1"/>
          <p:nvPr/>
        </p:nvSpPr>
        <p:spPr>
          <a:xfrm>
            <a:off x="56176" y="-13173"/>
            <a:ext cx="11089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Palatino Linotype" panose="02040502050505030304" pitchFamily="18" charset="0"/>
              </a:rPr>
              <a:t>Fig. S14</a:t>
            </a:r>
          </a:p>
        </p:txBody>
      </p:sp>
    </p:spTree>
    <p:extLst>
      <p:ext uri="{BB962C8B-B14F-4D97-AF65-F5344CB8AC3E}">
        <p14:creationId xmlns:p14="http://schemas.microsoft.com/office/powerpoint/2010/main" val="233531823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2" name="Chart 31">
            <a:extLst>
              <a:ext uri="{FF2B5EF4-FFF2-40B4-BE49-F238E27FC236}">
                <a16:creationId xmlns:a16="http://schemas.microsoft.com/office/drawing/2014/main" id="{8A05AF86-45C4-4700-8C03-58C7B3B1BD2B}"/>
              </a:ext>
            </a:extLst>
          </p:cNvPr>
          <p:cNvGraphicFramePr>
            <a:graphicFrameLocks/>
          </p:cNvGraphicFramePr>
          <p:nvPr/>
        </p:nvGraphicFramePr>
        <p:xfrm>
          <a:off x="167774" y="736151"/>
          <a:ext cx="6482514" cy="29861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3" name="TextBox 32">
            <a:extLst>
              <a:ext uri="{FF2B5EF4-FFF2-40B4-BE49-F238E27FC236}">
                <a16:creationId xmlns:a16="http://schemas.microsoft.com/office/drawing/2014/main" id="{4D738DDD-6119-4B11-8EDE-100436CFE256}"/>
              </a:ext>
            </a:extLst>
          </p:cNvPr>
          <p:cNvSpPr txBox="1"/>
          <p:nvPr/>
        </p:nvSpPr>
        <p:spPr>
          <a:xfrm rot="16200000">
            <a:off x="-614356" y="2048658"/>
            <a:ext cx="20365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ody Weights (g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DF54DD5-4DEC-44D3-8D14-9B79045D519C}"/>
              </a:ext>
            </a:extLst>
          </p:cNvPr>
          <p:cNvSpPr txBox="1"/>
          <p:nvPr/>
        </p:nvSpPr>
        <p:spPr>
          <a:xfrm>
            <a:off x="1163964" y="854836"/>
            <a:ext cx="53148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ody Weights of HT77 PDX Treated </a:t>
            </a:r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With Palbociclib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9F015D09-966B-4D3E-83C4-3CA2B0DB2EE9}"/>
              </a:ext>
            </a:extLst>
          </p:cNvPr>
          <p:cNvSpPr/>
          <p:nvPr/>
        </p:nvSpPr>
        <p:spPr>
          <a:xfrm>
            <a:off x="77971" y="3521585"/>
            <a:ext cx="1106266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i="1" dirty="0"/>
              <a:t>Study Days</a:t>
            </a:r>
            <a:endParaRPr lang="en-US" sz="1600" b="1" i="1" baseline="30000" dirty="0"/>
          </a:p>
        </p:txBody>
      </p: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8486E320-15A7-4F78-97C4-2AB124AE1965}"/>
              </a:ext>
            </a:extLst>
          </p:cNvPr>
          <p:cNvCxnSpPr/>
          <p:nvPr/>
        </p:nvCxnSpPr>
        <p:spPr>
          <a:xfrm>
            <a:off x="355013" y="3808066"/>
            <a:ext cx="64008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8F1FB0C5-A245-43CD-8275-52FFBCBE2846}"/>
              </a:ext>
            </a:extLst>
          </p:cNvPr>
          <p:cNvSpPr txBox="1"/>
          <p:nvPr/>
        </p:nvSpPr>
        <p:spPr>
          <a:xfrm>
            <a:off x="0" y="3844949"/>
            <a:ext cx="41402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i="1" dirty="0">
                <a:solidFill>
                  <a:schemeClr val="accent4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sing Days (1-21)</a:t>
            </a: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B69A88FF-E376-49AF-8718-34C990B89573}"/>
              </a:ext>
            </a:extLst>
          </p:cNvPr>
          <p:cNvCxnSpPr>
            <a:cxnSpLocks/>
          </p:cNvCxnSpPr>
          <p:nvPr/>
        </p:nvCxnSpPr>
        <p:spPr>
          <a:xfrm>
            <a:off x="1284398" y="3801976"/>
            <a:ext cx="1645920" cy="0"/>
          </a:xfrm>
          <a:prstGeom prst="line">
            <a:avLst/>
          </a:prstGeom>
          <a:ln w="0">
            <a:solidFill>
              <a:schemeClr val="accent4">
                <a:lumMod val="50000"/>
              </a:schemeClr>
            </a:solidFill>
            <a:headEnd type="oval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89916CB1-8449-4310-96AF-5885A4F5D751}"/>
              </a:ext>
            </a:extLst>
          </p:cNvPr>
          <p:cNvSpPr txBox="1"/>
          <p:nvPr/>
        </p:nvSpPr>
        <p:spPr>
          <a:xfrm>
            <a:off x="2892313" y="2745487"/>
            <a:ext cx="249675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00" b="1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B1+, CDKN2A null, CCND3 (8 copies), p53 null</a:t>
            </a:r>
          </a:p>
        </p:txBody>
      </p:sp>
      <p:pic>
        <p:nvPicPr>
          <p:cNvPr id="60" name="Picture 59">
            <a:extLst>
              <a:ext uri="{FF2B5EF4-FFF2-40B4-BE49-F238E27FC236}">
                <a16:creationId xmlns:a16="http://schemas.microsoft.com/office/drawing/2014/main" id="{9915F8FE-E302-415D-B809-E55BF810BE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84398" y="2563331"/>
            <a:ext cx="1277356" cy="746624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EA728EEE-FB60-46A1-BDA7-0B39D13352EF}"/>
              </a:ext>
            </a:extLst>
          </p:cNvPr>
          <p:cNvSpPr txBox="1"/>
          <p:nvPr/>
        </p:nvSpPr>
        <p:spPr>
          <a:xfrm>
            <a:off x="98339" y="644707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931B16E9-A45B-4E5B-BBFB-CBC7DD3F8C91}"/>
              </a:ext>
            </a:extLst>
          </p:cNvPr>
          <p:cNvSpPr txBox="1"/>
          <p:nvPr/>
        </p:nvSpPr>
        <p:spPr>
          <a:xfrm>
            <a:off x="98339" y="4558668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72" name="Chart 71">
            <a:extLst>
              <a:ext uri="{FF2B5EF4-FFF2-40B4-BE49-F238E27FC236}">
                <a16:creationId xmlns:a16="http://schemas.microsoft.com/office/drawing/2014/main" id="{C2D6938F-AD55-4415-B879-8E163C29C1A6}"/>
              </a:ext>
            </a:extLst>
          </p:cNvPr>
          <p:cNvGraphicFramePr>
            <a:graphicFrameLocks/>
          </p:cNvGraphicFramePr>
          <p:nvPr/>
        </p:nvGraphicFramePr>
        <p:xfrm>
          <a:off x="262520" y="5000200"/>
          <a:ext cx="6267545" cy="24791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3" name="TextBox 72">
            <a:extLst>
              <a:ext uri="{FF2B5EF4-FFF2-40B4-BE49-F238E27FC236}">
                <a16:creationId xmlns:a16="http://schemas.microsoft.com/office/drawing/2014/main" id="{A974F697-1017-4C85-9E59-EC6FF7D5BD47}"/>
              </a:ext>
            </a:extLst>
          </p:cNvPr>
          <p:cNvSpPr txBox="1"/>
          <p:nvPr/>
        </p:nvSpPr>
        <p:spPr>
          <a:xfrm>
            <a:off x="277781" y="7435122"/>
            <a:ext cx="414025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00" b="1" i="1" dirty="0">
                <a:solidFill>
                  <a:schemeClr val="accent4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sing Days (1-38)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09F21DE9-5635-4448-A952-8D39848661AD}"/>
              </a:ext>
            </a:extLst>
          </p:cNvPr>
          <p:cNvCxnSpPr>
            <a:cxnSpLocks/>
          </p:cNvCxnSpPr>
          <p:nvPr/>
        </p:nvCxnSpPr>
        <p:spPr>
          <a:xfrm>
            <a:off x="1130181" y="7435122"/>
            <a:ext cx="2468880" cy="0"/>
          </a:xfrm>
          <a:prstGeom prst="line">
            <a:avLst/>
          </a:prstGeom>
          <a:ln w="0">
            <a:solidFill>
              <a:schemeClr val="accent4">
                <a:lumMod val="50000"/>
              </a:schemeClr>
            </a:solidFill>
            <a:headEnd type="oval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F8613915-A7F8-4D82-A9E9-442BB44185DC}"/>
              </a:ext>
            </a:extLst>
          </p:cNvPr>
          <p:cNvSpPr txBox="1"/>
          <p:nvPr/>
        </p:nvSpPr>
        <p:spPr>
          <a:xfrm>
            <a:off x="3545086" y="6185608"/>
            <a:ext cx="22075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YC CNV Amplification </a:t>
            </a:r>
          </a:p>
          <a:p>
            <a:pPr algn="ctr"/>
            <a:r>
              <a:rPr lang="en-US" sz="1400" b="1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5-7 copies) </a:t>
            </a:r>
          </a:p>
        </p:txBody>
      </p:sp>
      <p:pic>
        <p:nvPicPr>
          <p:cNvPr id="76" name="Picture 75">
            <a:extLst>
              <a:ext uri="{FF2B5EF4-FFF2-40B4-BE49-F238E27FC236}">
                <a16:creationId xmlns:a16="http://schemas.microsoft.com/office/drawing/2014/main" id="{BBFA086E-E5E6-4B73-AB4C-FBD1AFDD4F1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82763" y="6198784"/>
            <a:ext cx="1709662" cy="724521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sp>
        <p:nvSpPr>
          <p:cNvPr id="77" name="Rectangle 76">
            <a:extLst>
              <a:ext uri="{FF2B5EF4-FFF2-40B4-BE49-F238E27FC236}">
                <a16:creationId xmlns:a16="http://schemas.microsoft.com/office/drawing/2014/main" id="{85AFAC0E-A0F9-447B-AC4F-BA4CD2F386FF}"/>
              </a:ext>
            </a:extLst>
          </p:cNvPr>
          <p:cNvSpPr/>
          <p:nvPr/>
        </p:nvSpPr>
        <p:spPr>
          <a:xfrm>
            <a:off x="98339" y="7196858"/>
            <a:ext cx="1106266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600" b="1" i="1" dirty="0"/>
              <a:t>Study Days</a:t>
            </a:r>
            <a:endParaRPr lang="en-US" sz="1600" b="1" i="1" baseline="30000" dirty="0"/>
          </a:p>
        </p:txBody>
      </p:sp>
      <p:cxnSp>
        <p:nvCxnSpPr>
          <p:cNvPr id="78" name="Straight Arrow Connector 77">
            <a:extLst>
              <a:ext uri="{FF2B5EF4-FFF2-40B4-BE49-F238E27FC236}">
                <a16:creationId xmlns:a16="http://schemas.microsoft.com/office/drawing/2014/main" id="{F94E9C6C-BCED-46F4-9546-3E86C226EDB5}"/>
              </a:ext>
            </a:extLst>
          </p:cNvPr>
          <p:cNvCxnSpPr/>
          <p:nvPr/>
        </p:nvCxnSpPr>
        <p:spPr>
          <a:xfrm>
            <a:off x="375381" y="7483339"/>
            <a:ext cx="64008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EE978D99-1AB7-4F89-B493-E1AB36CEF45D}"/>
              </a:ext>
            </a:extLst>
          </p:cNvPr>
          <p:cNvSpPr txBox="1"/>
          <p:nvPr/>
        </p:nvSpPr>
        <p:spPr>
          <a:xfrm rot="16200000">
            <a:off x="-533970" y="5814729"/>
            <a:ext cx="20365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ody Weights (g)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9EB9C562-D7A8-44CD-9EB4-425085EC7F1B}"/>
              </a:ext>
            </a:extLst>
          </p:cNvPr>
          <p:cNvSpPr txBox="1"/>
          <p:nvPr/>
        </p:nvSpPr>
        <p:spPr>
          <a:xfrm>
            <a:off x="1282763" y="4685217"/>
            <a:ext cx="53148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ody Weights of HT96 PDX Treated With OTX015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FEB81E7-AAB4-4E5A-9BE0-EB2083A2E6E4}"/>
              </a:ext>
            </a:extLst>
          </p:cNvPr>
          <p:cNvSpPr txBox="1"/>
          <p:nvPr/>
        </p:nvSpPr>
        <p:spPr>
          <a:xfrm>
            <a:off x="56176" y="-13173"/>
            <a:ext cx="11089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Palatino Linotype" panose="02040502050505030304" pitchFamily="18" charset="0"/>
              </a:rPr>
              <a:t>Fig. S15</a:t>
            </a:r>
          </a:p>
        </p:txBody>
      </p:sp>
    </p:spTree>
    <p:extLst>
      <p:ext uri="{BB962C8B-B14F-4D97-AF65-F5344CB8AC3E}">
        <p14:creationId xmlns:p14="http://schemas.microsoft.com/office/powerpoint/2010/main" val="20064966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4F61A56-201F-4836-8F1F-9199BB41AD6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332" r="5778"/>
          <a:stretch/>
        </p:blipFill>
        <p:spPr>
          <a:xfrm>
            <a:off x="868701" y="1556084"/>
            <a:ext cx="4970625" cy="399085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92FFBC1-1301-4F86-8E98-49BA5CA36D74}"/>
              </a:ext>
            </a:extLst>
          </p:cNvPr>
          <p:cNvSpPr txBox="1"/>
          <p:nvPr/>
        </p:nvSpPr>
        <p:spPr>
          <a:xfrm>
            <a:off x="0" y="0"/>
            <a:ext cx="11089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Palatino Linotype" panose="02040502050505030304" pitchFamily="18" charset="0"/>
              </a:rPr>
              <a:t>Fig. S2</a:t>
            </a:r>
          </a:p>
        </p:txBody>
      </p:sp>
    </p:spTree>
    <p:extLst>
      <p:ext uri="{BB962C8B-B14F-4D97-AF65-F5344CB8AC3E}">
        <p14:creationId xmlns:p14="http://schemas.microsoft.com/office/powerpoint/2010/main" val="14371843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C1C53E1B-4B91-4C02-BC7F-68A36AB80F66}"/>
              </a:ext>
            </a:extLst>
          </p:cNvPr>
          <p:cNvSpPr txBox="1"/>
          <p:nvPr/>
        </p:nvSpPr>
        <p:spPr>
          <a:xfrm>
            <a:off x="3131771" y="0"/>
            <a:ext cx="1265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Palatino Linotype" panose="02040502050505030304" pitchFamily="18" charset="0"/>
              </a:rPr>
              <a:t>HT7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8E64117-969D-4711-8692-CB3FBFD93C57}"/>
              </a:ext>
            </a:extLst>
          </p:cNvPr>
          <p:cNvSpPr txBox="1"/>
          <p:nvPr/>
        </p:nvSpPr>
        <p:spPr>
          <a:xfrm rot="16200000">
            <a:off x="750774" y="3639956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1 Copy Ratio (log2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70AD8C3-D427-4692-9646-BBC4A9C736C5}"/>
              </a:ext>
            </a:extLst>
          </p:cNvPr>
          <p:cNvSpPr txBox="1"/>
          <p:nvPr/>
        </p:nvSpPr>
        <p:spPr>
          <a:xfrm rot="16200000">
            <a:off x="750774" y="1103284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0 Copy Ratio (log2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4792E31-06BB-4E2C-B312-CC7AF3A41204}"/>
              </a:ext>
            </a:extLst>
          </p:cNvPr>
          <p:cNvSpPr txBox="1"/>
          <p:nvPr/>
        </p:nvSpPr>
        <p:spPr>
          <a:xfrm rot="16200000">
            <a:off x="750774" y="5903474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2 Copy Ratio (log2)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C9BFFE58-664F-4BA0-8B07-C0365CD76A2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185" t="6498"/>
          <a:stretch/>
        </p:blipFill>
        <p:spPr>
          <a:xfrm>
            <a:off x="1920241" y="317161"/>
            <a:ext cx="3017520" cy="2339208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54482AE0-0867-4C6A-86A5-C5CACDB6ADB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966" t="6497"/>
          <a:stretch/>
        </p:blipFill>
        <p:spPr>
          <a:xfrm>
            <a:off x="1920240" y="2656369"/>
            <a:ext cx="3017520" cy="2333801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C833E522-C720-42CC-B230-0E25A4E7E90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746" t="6218"/>
          <a:stretch/>
        </p:blipFill>
        <p:spPr>
          <a:xfrm>
            <a:off x="1920239" y="4955029"/>
            <a:ext cx="3017520" cy="2335378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370AEB20-30F8-48BE-A0C6-3BA5F3DAE2F5}"/>
              </a:ext>
            </a:extLst>
          </p:cNvPr>
          <p:cNvSpPr txBox="1"/>
          <p:nvPr/>
        </p:nvSpPr>
        <p:spPr>
          <a:xfrm>
            <a:off x="1663565" y="0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EBD0115-6556-4032-9009-F12B94DB0737}"/>
              </a:ext>
            </a:extLst>
          </p:cNvPr>
          <p:cNvSpPr txBox="1"/>
          <p:nvPr/>
        </p:nvSpPr>
        <p:spPr>
          <a:xfrm>
            <a:off x="1663565" y="2489137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3E9F03E-D3A7-455A-94F1-32F254E63CD7}"/>
              </a:ext>
            </a:extLst>
          </p:cNvPr>
          <p:cNvSpPr txBox="1"/>
          <p:nvPr/>
        </p:nvSpPr>
        <p:spPr>
          <a:xfrm>
            <a:off x="1652510" y="4852165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99C45F5-0A93-4FF9-AC80-3C94136F4C92}"/>
              </a:ext>
            </a:extLst>
          </p:cNvPr>
          <p:cNvSpPr txBox="1"/>
          <p:nvPr/>
        </p:nvSpPr>
        <p:spPr>
          <a:xfrm>
            <a:off x="0" y="0"/>
            <a:ext cx="11089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Palatino Linotype" panose="02040502050505030304" pitchFamily="18" charset="0"/>
              </a:rPr>
              <a:t>Fig. S3</a:t>
            </a:r>
          </a:p>
        </p:txBody>
      </p:sp>
    </p:spTree>
    <p:extLst>
      <p:ext uri="{BB962C8B-B14F-4D97-AF65-F5344CB8AC3E}">
        <p14:creationId xmlns:p14="http://schemas.microsoft.com/office/powerpoint/2010/main" val="6730534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C1C53E1B-4B91-4C02-BC7F-68A36AB80F66}"/>
              </a:ext>
            </a:extLst>
          </p:cNvPr>
          <p:cNvSpPr txBox="1"/>
          <p:nvPr/>
        </p:nvSpPr>
        <p:spPr>
          <a:xfrm>
            <a:off x="3131771" y="0"/>
            <a:ext cx="1265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Palatino Linotype" panose="02040502050505030304" pitchFamily="18" charset="0"/>
              </a:rPr>
              <a:t>HT77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BA35AE0-E04C-48FF-AF78-A8942945FDC8}"/>
              </a:ext>
            </a:extLst>
          </p:cNvPr>
          <p:cNvSpPr txBox="1"/>
          <p:nvPr/>
        </p:nvSpPr>
        <p:spPr>
          <a:xfrm rot="16200000">
            <a:off x="764421" y="3655480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1 Copy Ratio (log2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1AF791E-B897-4430-82F4-50B2E4FD0A69}"/>
              </a:ext>
            </a:extLst>
          </p:cNvPr>
          <p:cNvSpPr txBox="1"/>
          <p:nvPr/>
        </p:nvSpPr>
        <p:spPr>
          <a:xfrm rot="16200000">
            <a:off x="748014" y="1238623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HT72-P0 Copy Ratio (log2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2A198CC-F9E6-4513-9C42-5D77597F881D}"/>
              </a:ext>
            </a:extLst>
          </p:cNvPr>
          <p:cNvSpPr txBox="1"/>
          <p:nvPr/>
        </p:nvSpPr>
        <p:spPr>
          <a:xfrm rot="16200000">
            <a:off x="764421" y="6003960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2 Copy Ratio (log2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42C7044-443B-465B-9060-E216985B89B0}"/>
              </a:ext>
            </a:extLst>
          </p:cNvPr>
          <p:cNvSpPr txBox="1"/>
          <p:nvPr/>
        </p:nvSpPr>
        <p:spPr>
          <a:xfrm rot="16200000">
            <a:off x="764421" y="8499466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3 Copy Ratio (log2)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3F9C34F-C896-4794-A290-ABE89FF6218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526" t="6497"/>
          <a:stretch/>
        </p:blipFill>
        <p:spPr>
          <a:xfrm>
            <a:off x="1933888" y="7576638"/>
            <a:ext cx="3017520" cy="232306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C90421F-CEB9-4F11-8205-76E020DB7F9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834" t="6360"/>
          <a:stretch/>
        </p:blipFill>
        <p:spPr>
          <a:xfrm>
            <a:off x="1933888" y="5116023"/>
            <a:ext cx="3017520" cy="2334015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B12CF1E9-94C2-402C-AC2C-90C9C866ACA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586" t="6043"/>
          <a:stretch/>
        </p:blipFill>
        <p:spPr>
          <a:xfrm>
            <a:off x="1933887" y="2728148"/>
            <a:ext cx="3017520" cy="2335801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642131C7-7E6E-45B1-AB75-7951FA85238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185" t="6498"/>
          <a:stretch/>
        </p:blipFill>
        <p:spPr>
          <a:xfrm>
            <a:off x="1920240" y="322905"/>
            <a:ext cx="3017520" cy="2339208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CBA3E8BE-185F-473D-88A8-8DE2A6015DD2}"/>
              </a:ext>
            </a:extLst>
          </p:cNvPr>
          <p:cNvSpPr txBox="1"/>
          <p:nvPr/>
        </p:nvSpPr>
        <p:spPr>
          <a:xfrm>
            <a:off x="1663565" y="0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C9DE7A5-C8E5-4E58-928E-6126C0801F06}"/>
              </a:ext>
            </a:extLst>
          </p:cNvPr>
          <p:cNvSpPr txBox="1"/>
          <p:nvPr/>
        </p:nvSpPr>
        <p:spPr>
          <a:xfrm>
            <a:off x="1652510" y="2547786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AC6BD97-CBDD-4B38-966B-F683085790FA}"/>
              </a:ext>
            </a:extLst>
          </p:cNvPr>
          <p:cNvSpPr txBox="1"/>
          <p:nvPr/>
        </p:nvSpPr>
        <p:spPr>
          <a:xfrm>
            <a:off x="1652510" y="4937349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6913FC9-EEF9-4A9E-90F5-6A46D0B9D27D}"/>
              </a:ext>
            </a:extLst>
          </p:cNvPr>
          <p:cNvSpPr txBox="1"/>
          <p:nvPr/>
        </p:nvSpPr>
        <p:spPr>
          <a:xfrm>
            <a:off x="1677213" y="7405277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452CD3A-8A40-4EDF-8E3A-43D74C60FB3C}"/>
              </a:ext>
            </a:extLst>
          </p:cNvPr>
          <p:cNvSpPr txBox="1"/>
          <p:nvPr/>
        </p:nvSpPr>
        <p:spPr>
          <a:xfrm>
            <a:off x="0" y="0"/>
            <a:ext cx="11089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Palatino Linotype" panose="02040502050505030304" pitchFamily="18" charset="0"/>
              </a:rPr>
              <a:t>Fig. S4</a:t>
            </a:r>
          </a:p>
        </p:txBody>
      </p:sp>
    </p:spTree>
    <p:extLst>
      <p:ext uri="{BB962C8B-B14F-4D97-AF65-F5344CB8AC3E}">
        <p14:creationId xmlns:p14="http://schemas.microsoft.com/office/powerpoint/2010/main" val="12416109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C1C53E1B-4B91-4C02-BC7F-68A36AB80F66}"/>
              </a:ext>
            </a:extLst>
          </p:cNvPr>
          <p:cNvSpPr txBox="1"/>
          <p:nvPr/>
        </p:nvSpPr>
        <p:spPr>
          <a:xfrm>
            <a:off x="3131771" y="0"/>
            <a:ext cx="1265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Palatino Linotype" panose="02040502050505030304" pitchFamily="18" charset="0"/>
              </a:rPr>
              <a:t>HT87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BA35AE0-E04C-48FF-AF78-A8942945FDC8}"/>
              </a:ext>
            </a:extLst>
          </p:cNvPr>
          <p:cNvSpPr txBox="1"/>
          <p:nvPr/>
        </p:nvSpPr>
        <p:spPr>
          <a:xfrm rot="16200000">
            <a:off x="814513" y="3577608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1 Copy Ratio (log2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1AF791E-B897-4430-82F4-50B2E4FD0A69}"/>
              </a:ext>
            </a:extLst>
          </p:cNvPr>
          <p:cNvSpPr txBox="1"/>
          <p:nvPr/>
        </p:nvSpPr>
        <p:spPr>
          <a:xfrm rot="16200000">
            <a:off x="790978" y="1021129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0 Copy Ratio (log2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2A198CC-F9E6-4513-9C42-5D77597F881D}"/>
              </a:ext>
            </a:extLst>
          </p:cNvPr>
          <p:cNvSpPr txBox="1"/>
          <p:nvPr/>
        </p:nvSpPr>
        <p:spPr>
          <a:xfrm rot="16200000">
            <a:off x="791430" y="5961095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2 Copy Ratio (log2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42C7044-443B-465B-9060-E216985B89B0}"/>
              </a:ext>
            </a:extLst>
          </p:cNvPr>
          <p:cNvSpPr txBox="1"/>
          <p:nvPr/>
        </p:nvSpPr>
        <p:spPr>
          <a:xfrm rot="16200000">
            <a:off x="810156" y="8463473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3 Copy Ratio (log2)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FC9D91A-BDEF-4D6F-85B5-C2951261EFC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834" t="6360"/>
          <a:stretch/>
        </p:blipFill>
        <p:spPr>
          <a:xfrm>
            <a:off x="1920240" y="307777"/>
            <a:ext cx="3017520" cy="233401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AEAC549-E06D-4330-AA4B-664F9C21EB7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336" t="6360"/>
          <a:stretch/>
        </p:blipFill>
        <p:spPr>
          <a:xfrm>
            <a:off x="1983980" y="5027262"/>
            <a:ext cx="3017520" cy="232185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07542CF-1C3B-41D6-97B4-E8A3D3ED69A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306" t="6497"/>
          <a:stretch/>
        </p:blipFill>
        <p:spPr>
          <a:xfrm>
            <a:off x="1923819" y="2689269"/>
            <a:ext cx="3017520" cy="231772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3347389-EDE4-4337-9F7E-346BECD8234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526" t="5939"/>
          <a:stretch/>
        </p:blipFill>
        <p:spPr>
          <a:xfrm>
            <a:off x="1983980" y="7463877"/>
            <a:ext cx="3017520" cy="2336947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3B74A92C-8836-4066-957E-9A93BB446778}"/>
              </a:ext>
            </a:extLst>
          </p:cNvPr>
          <p:cNvSpPr txBox="1"/>
          <p:nvPr/>
        </p:nvSpPr>
        <p:spPr>
          <a:xfrm>
            <a:off x="1663565" y="0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243583C-38EE-4D42-8E0D-5747BF04DF79}"/>
              </a:ext>
            </a:extLst>
          </p:cNvPr>
          <p:cNvSpPr txBox="1"/>
          <p:nvPr/>
        </p:nvSpPr>
        <p:spPr>
          <a:xfrm>
            <a:off x="1652510" y="2547786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EE2C9CF-5E23-4AE4-A5B6-0A68E6B246BC}"/>
              </a:ext>
            </a:extLst>
          </p:cNvPr>
          <p:cNvSpPr txBox="1"/>
          <p:nvPr/>
        </p:nvSpPr>
        <p:spPr>
          <a:xfrm>
            <a:off x="1652510" y="4937349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6697FBB-D5AD-4CD4-8B96-A14B8830FCA6}"/>
              </a:ext>
            </a:extLst>
          </p:cNvPr>
          <p:cNvSpPr txBox="1"/>
          <p:nvPr/>
        </p:nvSpPr>
        <p:spPr>
          <a:xfrm>
            <a:off x="1677213" y="7405277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F6EF3DE-AC3E-40AC-A88E-21072CC17A28}"/>
              </a:ext>
            </a:extLst>
          </p:cNvPr>
          <p:cNvSpPr txBox="1"/>
          <p:nvPr/>
        </p:nvSpPr>
        <p:spPr>
          <a:xfrm>
            <a:off x="0" y="0"/>
            <a:ext cx="11089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Palatino Linotype" panose="02040502050505030304" pitchFamily="18" charset="0"/>
              </a:rPr>
              <a:t>Fig. S5</a:t>
            </a:r>
          </a:p>
        </p:txBody>
      </p:sp>
    </p:spTree>
    <p:extLst>
      <p:ext uri="{BB962C8B-B14F-4D97-AF65-F5344CB8AC3E}">
        <p14:creationId xmlns:p14="http://schemas.microsoft.com/office/powerpoint/2010/main" val="42396019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C1C53E1B-4B91-4C02-BC7F-68A36AB80F66}"/>
              </a:ext>
            </a:extLst>
          </p:cNvPr>
          <p:cNvSpPr txBox="1"/>
          <p:nvPr/>
        </p:nvSpPr>
        <p:spPr>
          <a:xfrm>
            <a:off x="3131771" y="0"/>
            <a:ext cx="1265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Palatino Linotype" panose="02040502050505030304" pitchFamily="18" charset="0"/>
              </a:rPr>
              <a:t>HT96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BA35AE0-E04C-48FF-AF78-A8942945FDC8}"/>
              </a:ext>
            </a:extLst>
          </p:cNvPr>
          <p:cNvSpPr txBox="1"/>
          <p:nvPr/>
        </p:nvSpPr>
        <p:spPr>
          <a:xfrm rot="16200000">
            <a:off x="761662" y="3574406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1 Copy Ratio (log2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1AF791E-B897-4430-82F4-50B2E4FD0A69}"/>
              </a:ext>
            </a:extLst>
          </p:cNvPr>
          <p:cNvSpPr txBox="1"/>
          <p:nvPr/>
        </p:nvSpPr>
        <p:spPr>
          <a:xfrm rot="16200000">
            <a:off x="761662" y="1022304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0 Copy Ratio (log2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2A198CC-F9E6-4513-9C42-5D77597F881D}"/>
              </a:ext>
            </a:extLst>
          </p:cNvPr>
          <p:cNvSpPr txBox="1"/>
          <p:nvPr/>
        </p:nvSpPr>
        <p:spPr>
          <a:xfrm rot="16200000">
            <a:off x="769324" y="5975104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2 Copy Ratio (log2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42C7044-443B-465B-9060-E216985B89B0}"/>
              </a:ext>
            </a:extLst>
          </p:cNvPr>
          <p:cNvSpPr txBox="1"/>
          <p:nvPr/>
        </p:nvSpPr>
        <p:spPr>
          <a:xfrm rot="16200000">
            <a:off x="740726" y="8255213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3 Copy Ratio (log2)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4D4E196B-41C3-4F03-8E08-4C4CEFF26B1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966" t="6218"/>
          <a:stretch/>
        </p:blipFill>
        <p:spPr>
          <a:xfrm>
            <a:off x="1920240" y="307777"/>
            <a:ext cx="3017520" cy="2340776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B6C33C7F-FE20-4E21-843E-A0FAFB0798A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526" t="6218"/>
          <a:stretch/>
        </p:blipFill>
        <p:spPr>
          <a:xfrm>
            <a:off x="1920240" y="2659023"/>
            <a:ext cx="3017520" cy="233000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43093DC1-D87D-4887-AD8D-4F8AA15545A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966" t="6497"/>
          <a:stretch/>
        </p:blipFill>
        <p:spPr>
          <a:xfrm>
            <a:off x="1920240" y="5010435"/>
            <a:ext cx="3017520" cy="233380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E4AEDE29-4F8C-4B46-A6D5-4BB3321493E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185" t="6218"/>
          <a:stretch/>
        </p:blipFill>
        <p:spPr>
          <a:xfrm>
            <a:off x="1920240" y="7365644"/>
            <a:ext cx="3017520" cy="2346199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4CB5E6CA-98AD-47A8-82AE-8550E260ED62}"/>
              </a:ext>
            </a:extLst>
          </p:cNvPr>
          <p:cNvSpPr txBox="1"/>
          <p:nvPr/>
        </p:nvSpPr>
        <p:spPr>
          <a:xfrm>
            <a:off x="1663565" y="0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C859934-2C90-4CA0-AD84-DD58BFBCE3B7}"/>
              </a:ext>
            </a:extLst>
          </p:cNvPr>
          <p:cNvSpPr txBox="1"/>
          <p:nvPr/>
        </p:nvSpPr>
        <p:spPr>
          <a:xfrm>
            <a:off x="1652510" y="2547786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E5B2135-66F6-4134-9C30-B5FBACAA51D3}"/>
              </a:ext>
            </a:extLst>
          </p:cNvPr>
          <p:cNvSpPr txBox="1"/>
          <p:nvPr/>
        </p:nvSpPr>
        <p:spPr>
          <a:xfrm>
            <a:off x="1651454" y="4937998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350B45D-E87F-411E-8AEC-A825A9D1FB21}"/>
              </a:ext>
            </a:extLst>
          </p:cNvPr>
          <p:cNvSpPr txBox="1"/>
          <p:nvPr/>
        </p:nvSpPr>
        <p:spPr>
          <a:xfrm>
            <a:off x="1651454" y="7167654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F115103-2CFF-48D7-BF22-9021FB099E06}"/>
              </a:ext>
            </a:extLst>
          </p:cNvPr>
          <p:cNvSpPr txBox="1"/>
          <p:nvPr/>
        </p:nvSpPr>
        <p:spPr>
          <a:xfrm>
            <a:off x="0" y="0"/>
            <a:ext cx="11089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Palatino Linotype" panose="02040502050505030304" pitchFamily="18" charset="0"/>
              </a:rPr>
              <a:t>Fig. S6</a:t>
            </a:r>
          </a:p>
        </p:txBody>
      </p:sp>
    </p:spTree>
    <p:extLst>
      <p:ext uri="{BB962C8B-B14F-4D97-AF65-F5344CB8AC3E}">
        <p14:creationId xmlns:p14="http://schemas.microsoft.com/office/powerpoint/2010/main" val="20439100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C1C53E1B-4B91-4C02-BC7F-68A36AB80F66}"/>
              </a:ext>
            </a:extLst>
          </p:cNvPr>
          <p:cNvSpPr txBox="1"/>
          <p:nvPr/>
        </p:nvSpPr>
        <p:spPr>
          <a:xfrm>
            <a:off x="3131771" y="0"/>
            <a:ext cx="1265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Palatino Linotype" panose="02040502050505030304" pitchFamily="18" charset="0"/>
              </a:rPr>
              <a:t>HT7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8E64117-969D-4711-8692-CB3FBFD93C57}"/>
              </a:ext>
            </a:extLst>
          </p:cNvPr>
          <p:cNvSpPr txBox="1"/>
          <p:nvPr/>
        </p:nvSpPr>
        <p:spPr>
          <a:xfrm rot="16200000">
            <a:off x="767967" y="3598093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1 Copy Ratio (log2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70AD8C3-D427-4692-9646-BBC4A9C736C5}"/>
              </a:ext>
            </a:extLst>
          </p:cNvPr>
          <p:cNvSpPr txBox="1"/>
          <p:nvPr/>
        </p:nvSpPr>
        <p:spPr>
          <a:xfrm rot="16200000">
            <a:off x="750773" y="1079718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0 Copy Ratio (log2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4792E31-06BB-4E2C-B312-CC7AF3A41204}"/>
              </a:ext>
            </a:extLst>
          </p:cNvPr>
          <p:cNvSpPr txBox="1"/>
          <p:nvPr/>
        </p:nvSpPr>
        <p:spPr>
          <a:xfrm rot="16200000">
            <a:off x="767968" y="6182593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2 Copy Ratio (log2)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BED68D41-B45F-4FF0-9171-4D864F1B0F6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878" t="6355"/>
          <a:stretch/>
        </p:blipFill>
        <p:spPr>
          <a:xfrm>
            <a:off x="1920240" y="307777"/>
            <a:ext cx="3017520" cy="233519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4C2DA339-DADF-43BC-A208-EB0CABEBC0D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746" t="6497"/>
          <a:stretch/>
        </p:blipFill>
        <p:spPr>
          <a:xfrm>
            <a:off x="1920240" y="2706221"/>
            <a:ext cx="3017520" cy="2328419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3236B196-A98A-4AAF-A23C-1C94FF457B5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746" t="6497"/>
          <a:stretch/>
        </p:blipFill>
        <p:spPr>
          <a:xfrm>
            <a:off x="1920240" y="5164309"/>
            <a:ext cx="3017520" cy="2328419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3F244835-1E08-4903-8FCA-F33F2C349346}"/>
              </a:ext>
            </a:extLst>
          </p:cNvPr>
          <p:cNvSpPr txBox="1"/>
          <p:nvPr/>
        </p:nvSpPr>
        <p:spPr>
          <a:xfrm>
            <a:off x="1663565" y="0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076C7DA-23F7-47A7-8398-C5CFB3FF765D}"/>
              </a:ext>
            </a:extLst>
          </p:cNvPr>
          <p:cNvSpPr txBox="1"/>
          <p:nvPr/>
        </p:nvSpPr>
        <p:spPr>
          <a:xfrm>
            <a:off x="1652510" y="2547786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682B88D-BC46-408A-9BA2-5260D4E74436}"/>
              </a:ext>
            </a:extLst>
          </p:cNvPr>
          <p:cNvSpPr txBox="1"/>
          <p:nvPr/>
        </p:nvSpPr>
        <p:spPr>
          <a:xfrm>
            <a:off x="1652510" y="4964254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DB326F3-39DC-4C6C-B226-0ADC199139EC}"/>
              </a:ext>
            </a:extLst>
          </p:cNvPr>
          <p:cNvSpPr txBox="1"/>
          <p:nvPr/>
        </p:nvSpPr>
        <p:spPr>
          <a:xfrm>
            <a:off x="0" y="0"/>
            <a:ext cx="11089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Palatino Linotype" panose="02040502050505030304" pitchFamily="18" charset="0"/>
              </a:rPr>
              <a:t>Fig. S7</a:t>
            </a:r>
          </a:p>
        </p:txBody>
      </p:sp>
    </p:spTree>
    <p:extLst>
      <p:ext uri="{BB962C8B-B14F-4D97-AF65-F5344CB8AC3E}">
        <p14:creationId xmlns:p14="http://schemas.microsoft.com/office/powerpoint/2010/main" val="11400307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C1C53E1B-4B91-4C02-BC7F-68A36AB80F66}"/>
              </a:ext>
            </a:extLst>
          </p:cNvPr>
          <p:cNvSpPr txBox="1"/>
          <p:nvPr/>
        </p:nvSpPr>
        <p:spPr>
          <a:xfrm>
            <a:off x="3131771" y="0"/>
            <a:ext cx="1265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Palatino Linotype" panose="02040502050505030304" pitchFamily="18" charset="0"/>
              </a:rPr>
              <a:t>HT98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E0E68AF-FBA4-478D-B30F-A1768C3B0EF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586" t="6202"/>
          <a:stretch/>
        </p:blipFill>
        <p:spPr>
          <a:xfrm>
            <a:off x="1920240" y="276517"/>
            <a:ext cx="3017520" cy="233186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3E56B68-2F2F-4E01-9C6E-38CCF93D127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966" t="6218"/>
          <a:stretch/>
        </p:blipFill>
        <p:spPr>
          <a:xfrm>
            <a:off x="1920239" y="5046424"/>
            <a:ext cx="3017520" cy="234077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C4BAFD2-56F1-45F9-8490-1EFF1EA1E14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966" t="6218"/>
          <a:stretch/>
        </p:blipFill>
        <p:spPr>
          <a:xfrm>
            <a:off x="1920239" y="2638145"/>
            <a:ext cx="3017520" cy="2340776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C0DEE015-179B-441C-BEFF-CB2A2F1C8D7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306" t="5939"/>
          <a:stretch/>
        </p:blipFill>
        <p:spPr>
          <a:xfrm>
            <a:off x="1920239" y="7376128"/>
            <a:ext cx="3017520" cy="2331583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BBA35AE0-E04C-48FF-AF78-A8942945FDC8}"/>
              </a:ext>
            </a:extLst>
          </p:cNvPr>
          <p:cNvSpPr txBox="1"/>
          <p:nvPr/>
        </p:nvSpPr>
        <p:spPr>
          <a:xfrm rot="16200000">
            <a:off x="750774" y="3499017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1 Copy Ratio (log2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1AF791E-B897-4430-82F4-50B2E4FD0A69}"/>
              </a:ext>
            </a:extLst>
          </p:cNvPr>
          <p:cNvSpPr txBox="1"/>
          <p:nvPr/>
        </p:nvSpPr>
        <p:spPr>
          <a:xfrm rot="16200000">
            <a:off x="750773" y="1070928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0 Copy Ratio (log2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2A198CC-F9E6-4513-9C42-5D77597F881D}"/>
              </a:ext>
            </a:extLst>
          </p:cNvPr>
          <p:cNvSpPr txBox="1"/>
          <p:nvPr/>
        </p:nvSpPr>
        <p:spPr>
          <a:xfrm rot="16200000">
            <a:off x="750774" y="5941401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2 Copy Ratio (log2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42C7044-443B-465B-9060-E216985B89B0}"/>
              </a:ext>
            </a:extLst>
          </p:cNvPr>
          <p:cNvSpPr txBox="1"/>
          <p:nvPr/>
        </p:nvSpPr>
        <p:spPr>
          <a:xfrm rot="16200000">
            <a:off x="761662" y="8451664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3 Copy Ratio (log2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5D169A6-5C30-4C03-B59B-2C71F6A22A00}"/>
              </a:ext>
            </a:extLst>
          </p:cNvPr>
          <p:cNvSpPr txBox="1"/>
          <p:nvPr/>
        </p:nvSpPr>
        <p:spPr>
          <a:xfrm>
            <a:off x="1663565" y="0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56A9589-8BEC-4166-AFC1-18BB3B28C692}"/>
              </a:ext>
            </a:extLst>
          </p:cNvPr>
          <p:cNvSpPr txBox="1"/>
          <p:nvPr/>
        </p:nvSpPr>
        <p:spPr>
          <a:xfrm>
            <a:off x="1650488" y="2475826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2B81F8D-7542-4EA7-A841-D8C529F678C8}"/>
              </a:ext>
            </a:extLst>
          </p:cNvPr>
          <p:cNvSpPr txBox="1"/>
          <p:nvPr/>
        </p:nvSpPr>
        <p:spPr>
          <a:xfrm>
            <a:off x="1650488" y="4868214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94FF764-0C48-491A-8BFC-6F7BF5AA3DC0}"/>
              </a:ext>
            </a:extLst>
          </p:cNvPr>
          <p:cNvSpPr txBox="1"/>
          <p:nvPr/>
        </p:nvSpPr>
        <p:spPr>
          <a:xfrm>
            <a:off x="1677213" y="7256836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57AE1C1-4E3B-4A5F-A66D-218CA935DD19}"/>
              </a:ext>
            </a:extLst>
          </p:cNvPr>
          <p:cNvSpPr txBox="1"/>
          <p:nvPr/>
        </p:nvSpPr>
        <p:spPr>
          <a:xfrm>
            <a:off x="0" y="0"/>
            <a:ext cx="11089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Palatino Linotype" panose="02040502050505030304" pitchFamily="18" charset="0"/>
              </a:rPr>
              <a:t>Fig. S8</a:t>
            </a:r>
          </a:p>
        </p:txBody>
      </p:sp>
    </p:spTree>
    <p:extLst>
      <p:ext uri="{BB962C8B-B14F-4D97-AF65-F5344CB8AC3E}">
        <p14:creationId xmlns:p14="http://schemas.microsoft.com/office/powerpoint/2010/main" val="11587176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C1C53E1B-4B91-4C02-BC7F-68A36AB80F66}"/>
              </a:ext>
            </a:extLst>
          </p:cNvPr>
          <p:cNvSpPr txBox="1"/>
          <p:nvPr/>
        </p:nvSpPr>
        <p:spPr>
          <a:xfrm>
            <a:off x="3131771" y="0"/>
            <a:ext cx="12652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Palatino Linotype" panose="02040502050505030304" pitchFamily="18" charset="0"/>
              </a:rPr>
              <a:t>HT120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E94B40CA-87D3-4C66-989A-CFE007251E3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834" t="6676"/>
          <a:stretch/>
        </p:blipFill>
        <p:spPr>
          <a:xfrm>
            <a:off x="1958340" y="288727"/>
            <a:ext cx="3017520" cy="2326114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26E78B8C-A647-472B-9381-371A98DF5F4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834" t="6360"/>
          <a:stretch/>
        </p:blipFill>
        <p:spPr>
          <a:xfrm>
            <a:off x="1958340" y="2614841"/>
            <a:ext cx="3017520" cy="2334015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4807B9CA-3238-4A18-89C6-3DD3ADFE704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997" t="6634"/>
          <a:stretch/>
        </p:blipFill>
        <p:spPr>
          <a:xfrm>
            <a:off x="1958340" y="4988012"/>
            <a:ext cx="3017520" cy="2331154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06D0EBC5-CA12-4C81-8693-DD15F9FA2C3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834" t="5726"/>
          <a:stretch/>
        </p:blipFill>
        <p:spPr>
          <a:xfrm>
            <a:off x="1958340" y="7453289"/>
            <a:ext cx="3017520" cy="2349818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CB1C5078-DDDF-4E61-BA68-6113BF3F9FE7}"/>
              </a:ext>
            </a:extLst>
          </p:cNvPr>
          <p:cNvSpPr txBox="1"/>
          <p:nvPr/>
        </p:nvSpPr>
        <p:spPr>
          <a:xfrm rot="16200000">
            <a:off x="788875" y="3440525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1 Copy Ratio (log2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9D79D94-7049-4687-BAB9-F3E0284CA3F8}"/>
              </a:ext>
            </a:extLst>
          </p:cNvPr>
          <p:cNvSpPr txBox="1"/>
          <p:nvPr/>
        </p:nvSpPr>
        <p:spPr>
          <a:xfrm rot="16200000">
            <a:off x="788874" y="1012436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0 Copy Ratio (log2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BB377C8-DEA8-4F46-B4DF-1B18541889A5}"/>
              </a:ext>
            </a:extLst>
          </p:cNvPr>
          <p:cNvSpPr txBox="1"/>
          <p:nvPr/>
        </p:nvSpPr>
        <p:spPr>
          <a:xfrm rot="16200000">
            <a:off x="788875" y="5882909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2 Copy Ratio (log2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A5BABB8-A18D-437A-90A7-2B4E95BE768B}"/>
              </a:ext>
            </a:extLst>
          </p:cNvPr>
          <p:cNvSpPr txBox="1"/>
          <p:nvPr/>
        </p:nvSpPr>
        <p:spPr>
          <a:xfrm rot="16200000">
            <a:off x="788874" y="8368840"/>
            <a:ext cx="2108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Palatino Linotype" panose="02040502050505030304" pitchFamily="18" charset="0"/>
              </a:rPr>
              <a:t>P3 Copy Ratio (log2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9785337-04DB-4AF7-9120-4B2BC2135088}"/>
              </a:ext>
            </a:extLst>
          </p:cNvPr>
          <p:cNvSpPr txBox="1"/>
          <p:nvPr/>
        </p:nvSpPr>
        <p:spPr>
          <a:xfrm>
            <a:off x="1663565" y="0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3540029-74D1-43A8-BF48-E7B17A850EA1}"/>
              </a:ext>
            </a:extLst>
          </p:cNvPr>
          <p:cNvSpPr txBox="1"/>
          <p:nvPr/>
        </p:nvSpPr>
        <p:spPr>
          <a:xfrm>
            <a:off x="1677213" y="2453942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3B55776-FF02-426D-966F-2AA3F69B699F}"/>
              </a:ext>
            </a:extLst>
          </p:cNvPr>
          <p:cNvSpPr txBox="1"/>
          <p:nvPr/>
        </p:nvSpPr>
        <p:spPr>
          <a:xfrm>
            <a:off x="1636959" y="4853889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ED45530-E9EA-4545-AD59-2AD91CD41366}"/>
              </a:ext>
            </a:extLst>
          </p:cNvPr>
          <p:cNvSpPr txBox="1"/>
          <p:nvPr/>
        </p:nvSpPr>
        <p:spPr>
          <a:xfrm>
            <a:off x="1677213" y="7263622"/>
            <a:ext cx="5133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Palatino Linotype" panose="02040502050505030304" pitchFamily="18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BBFEB0E-BBA2-4B18-A8B3-B6305EC55E7C}"/>
              </a:ext>
            </a:extLst>
          </p:cNvPr>
          <p:cNvSpPr txBox="1"/>
          <p:nvPr/>
        </p:nvSpPr>
        <p:spPr>
          <a:xfrm>
            <a:off x="0" y="0"/>
            <a:ext cx="11089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latin typeface="Palatino Linotype" panose="02040502050505030304" pitchFamily="18" charset="0"/>
              </a:rPr>
              <a:t>Fig. S9</a:t>
            </a:r>
          </a:p>
        </p:txBody>
      </p:sp>
    </p:spTree>
    <p:extLst>
      <p:ext uri="{BB962C8B-B14F-4D97-AF65-F5344CB8AC3E}">
        <p14:creationId xmlns:p14="http://schemas.microsoft.com/office/powerpoint/2010/main" val="14560634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</TotalTime>
  <Words>695</Words>
  <Application>Microsoft Office PowerPoint</Application>
  <PresentationFormat>Widescreen</PresentationFormat>
  <Paragraphs>426</Paragraphs>
  <Slides>1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20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Indiana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dya, Pankita Hemant</dc:creator>
  <cp:lastModifiedBy>Pandya, Pankita Hemant</cp:lastModifiedBy>
  <cp:revision>13</cp:revision>
  <dcterms:created xsi:type="dcterms:W3CDTF">2022-09-19T16:49:07Z</dcterms:created>
  <dcterms:modified xsi:type="dcterms:W3CDTF">2022-12-29T20:14:37Z</dcterms:modified>
</cp:coreProperties>
</file>